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90" y="-6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05324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527132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25510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858954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64033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16780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015590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9864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5001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93817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51728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ACC10-8FB8-413E-AF74-078481BBC614}" type="datetimeFigureOut">
              <a:rPr lang="en-SG" smtClean="0"/>
              <a:t>26/5/2014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3425A-33DE-4497-83C0-A6E971FAEF37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07416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43608" y="186398"/>
            <a:ext cx="6789628" cy="5114810"/>
            <a:chOff x="336399" y="823244"/>
            <a:chExt cx="6044929" cy="3984788"/>
          </a:xfrm>
        </p:grpSpPr>
        <p:sp>
          <p:nvSpPr>
            <p:cNvPr id="5" name="Rectangle 233"/>
            <p:cNvSpPr>
              <a:spLocks noChangeArrowheads="1"/>
            </p:cNvSpPr>
            <p:nvPr/>
          </p:nvSpPr>
          <p:spPr bwMode="auto">
            <a:xfrm>
              <a:off x="2200371" y="944367"/>
              <a:ext cx="83035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effectLst/>
                </a:rPr>
                <a:t>MsTPS1 + HMGR</a:t>
              </a:r>
            </a:p>
          </p:txBody>
        </p:sp>
        <p:sp>
          <p:nvSpPr>
            <p:cNvPr id="6" name="Rectangle 239"/>
            <p:cNvSpPr>
              <a:spLocks noChangeArrowheads="1"/>
            </p:cNvSpPr>
            <p:nvPr/>
          </p:nvSpPr>
          <p:spPr bwMode="auto">
            <a:xfrm>
              <a:off x="2190296" y="1103886"/>
              <a:ext cx="3125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effectLst/>
                </a:rPr>
                <a:t>HMGR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473781" y="1126649"/>
              <a:ext cx="3113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1000" b="1" dirty="0" smtClean="0">
                  <a:latin typeface="Arial" panose="020B0604020202020204" pitchFamily="34" charset="0"/>
                  <a:ea typeface="굴림"/>
                  <a:cs typeface="Arial" panose="020B0604020202020204" pitchFamily="34" charset="0"/>
                </a:rPr>
                <a:t>①</a:t>
              </a:r>
              <a:endParaRPr lang="en-SG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35298" y="1989632"/>
              <a:ext cx="3113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1000" b="1" dirty="0" smtClean="0">
                  <a:latin typeface="Arial" panose="020B0604020202020204" pitchFamily="34" charset="0"/>
                  <a:ea typeface="굴림"/>
                  <a:cs typeface="Arial" panose="020B0604020202020204" pitchFamily="34" charset="0"/>
                </a:rPr>
                <a:t>②</a:t>
              </a:r>
              <a:endParaRPr lang="en-SG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>
              <a:off x="1999280" y="2224771"/>
              <a:ext cx="0" cy="216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" name="Group 9"/>
            <p:cNvGrpSpPr>
              <a:grpSpLocks noChangeAspect="1"/>
            </p:cNvGrpSpPr>
            <p:nvPr/>
          </p:nvGrpSpPr>
          <p:grpSpPr>
            <a:xfrm>
              <a:off x="507634" y="958300"/>
              <a:ext cx="2625239" cy="1800000"/>
              <a:chOff x="532531" y="1086660"/>
              <a:chExt cx="3384143" cy="2320344"/>
            </a:xfrm>
          </p:grpSpPr>
          <p:grpSp>
            <p:nvGrpSpPr>
              <p:cNvPr id="181" name="Group 180"/>
              <p:cNvGrpSpPr/>
              <p:nvPr/>
            </p:nvGrpSpPr>
            <p:grpSpPr>
              <a:xfrm>
                <a:off x="532531" y="1086660"/>
                <a:ext cx="3384143" cy="2320344"/>
                <a:chOff x="575697" y="1086650"/>
                <a:chExt cx="4060972" cy="2784409"/>
              </a:xfrm>
            </p:grpSpPr>
            <p:sp>
              <p:nvSpPr>
                <p:cNvPr id="184" name="Line 327"/>
                <p:cNvSpPr>
                  <a:spLocks noChangeShapeType="1"/>
                </p:cNvSpPr>
                <p:nvPr/>
              </p:nvSpPr>
              <p:spPr bwMode="auto">
                <a:xfrm>
                  <a:off x="695791" y="3675879"/>
                  <a:ext cx="3940878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85" name="Line 328"/>
                <p:cNvSpPr>
                  <a:spLocks noChangeShapeType="1"/>
                </p:cNvSpPr>
                <p:nvPr/>
              </p:nvSpPr>
              <p:spPr bwMode="auto">
                <a:xfrm flipV="1">
                  <a:off x="759857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86" name="Line 329"/>
                <p:cNvSpPr>
                  <a:spLocks noChangeShapeType="1"/>
                </p:cNvSpPr>
                <p:nvPr/>
              </p:nvSpPr>
              <p:spPr bwMode="auto">
                <a:xfrm flipV="1">
                  <a:off x="833300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87" name="Line 330"/>
                <p:cNvSpPr>
                  <a:spLocks noChangeShapeType="1"/>
                </p:cNvSpPr>
                <p:nvPr/>
              </p:nvSpPr>
              <p:spPr bwMode="auto">
                <a:xfrm flipV="1">
                  <a:off x="906741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88" name="Line 331"/>
                <p:cNvSpPr>
                  <a:spLocks noChangeShapeType="1"/>
                </p:cNvSpPr>
                <p:nvPr/>
              </p:nvSpPr>
              <p:spPr bwMode="auto">
                <a:xfrm flipV="1">
                  <a:off x="978621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89" name="Line 332"/>
                <p:cNvSpPr>
                  <a:spLocks noChangeShapeType="1"/>
                </p:cNvSpPr>
                <p:nvPr/>
              </p:nvSpPr>
              <p:spPr bwMode="auto">
                <a:xfrm flipV="1">
                  <a:off x="1052064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0" name="Line 333"/>
                <p:cNvSpPr>
                  <a:spLocks noChangeShapeType="1"/>
                </p:cNvSpPr>
                <p:nvPr/>
              </p:nvSpPr>
              <p:spPr bwMode="auto">
                <a:xfrm flipV="1">
                  <a:off x="1125505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1" name="Line 334"/>
                <p:cNvSpPr>
                  <a:spLocks noChangeShapeType="1"/>
                </p:cNvSpPr>
                <p:nvPr/>
              </p:nvSpPr>
              <p:spPr bwMode="auto">
                <a:xfrm flipV="1">
                  <a:off x="119894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2" name="Line 335"/>
                <p:cNvSpPr>
                  <a:spLocks noChangeShapeType="1"/>
                </p:cNvSpPr>
                <p:nvPr/>
              </p:nvSpPr>
              <p:spPr bwMode="auto">
                <a:xfrm flipV="1">
                  <a:off x="1272390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3" name="Line 336"/>
                <p:cNvSpPr>
                  <a:spLocks noChangeShapeType="1"/>
                </p:cNvSpPr>
                <p:nvPr/>
              </p:nvSpPr>
              <p:spPr bwMode="auto">
                <a:xfrm flipV="1">
                  <a:off x="1344269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4" name="Line 337"/>
                <p:cNvSpPr>
                  <a:spLocks noChangeShapeType="1"/>
                </p:cNvSpPr>
                <p:nvPr/>
              </p:nvSpPr>
              <p:spPr bwMode="auto">
                <a:xfrm flipV="1">
                  <a:off x="1417712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5" name="Line 338"/>
                <p:cNvSpPr>
                  <a:spLocks noChangeShapeType="1"/>
                </p:cNvSpPr>
                <p:nvPr/>
              </p:nvSpPr>
              <p:spPr bwMode="auto">
                <a:xfrm flipV="1">
                  <a:off x="1491154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6" name="Line 339"/>
                <p:cNvSpPr>
                  <a:spLocks noChangeShapeType="1"/>
                </p:cNvSpPr>
                <p:nvPr/>
              </p:nvSpPr>
              <p:spPr bwMode="auto">
                <a:xfrm flipV="1">
                  <a:off x="1564597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7" name="Line 340"/>
                <p:cNvSpPr>
                  <a:spLocks noChangeShapeType="1"/>
                </p:cNvSpPr>
                <p:nvPr/>
              </p:nvSpPr>
              <p:spPr bwMode="auto">
                <a:xfrm flipV="1">
                  <a:off x="163803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8" name="Line 341"/>
                <p:cNvSpPr>
                  <a:spLocks noChangeShapeType="1"/>
                </p:cNvSpPr>
                <p:nvPr/>
              </p:nvSpPr>
              <p:spPr bwMode="auto">
                <a:xfrm flipV="1">
                  <a:off x="170991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199" name="Line 342"/>
                <p:cNvSpPr>
                  <a:spLocks noChangeShapeType="1"/>
                </p:cNvSpPr>
                <p:nvPr/>
              </p:nvSpPr>
              <p:spPr bwMode="auto">
                <a:xfrm flipV="1">
                  <a:off x="1783361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0" name="Line 343"/>
                <p:cNvSpPr>
                  <a:spLocks noChangeShapeType="1"/>
                </p:cNvSpPr>
                <p:nvPr/>
              </p:nvSpPr>
              <p:spPr bwMode="auto">
                <a:xfrm flipV="1">
                  <a:off x="1856802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1" name="Line 344"/>
                <p:cNvSpPr>
                  <a:spLocks noChangeShapeType="1"/>
                </p:cNvSpPr>
                <p:nvPr/>
              </p:nvSpPr>
              <p:spPr bwMode="auto">
                <a:xfrm flipV="1">
                  <a:off x="1930245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2" name="Line 345"/>
                <p:cNvSpPr>
                  <a:spLocks noChangeShapeType="1"/>
                </p:cNvSpPr>
                <p:nvPr/>
              </p:nvSpPr>
              <p:spPr bwMode="auto">
                <a:xfrm flipV="1">
                  <a:off x="2003687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3" name="Line 346"/>
                <p:cNvSpPr>
                  <a:spLocks noChangeShapeType="1"/>
                </p:cNvSpPr>
                <p:nvPr/>
              </p:nvSpPr>
              <p:spPr bwMode="auto">
                <a:xfrm flipV="1">
                  <a:off x="2077130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4" name="Line 347"/>
                <p:cNvSpPr>
                  <a:spLocks noChangeShapeType="1"/>
                </p:cNvSpPr>
                <p:nvPr/>
              </p:nvSpPr>
              <p:spPr bwMode="auto">
                <a:xfrm flipV="1">
                  <a:off x="2149009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5" name="Line 348"/>
                <p:cNvSpPr>
                  <a:spLocks noChangeShapeType="1"/>
                </p:cNvSpPr>
                <p:nvPr/>
              </p:nvSpPr>
              <p:spPr bwMode="auto">
                <a:xfrm flipV="1">
                  <a:off x="2222451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6" name="Line 349"/>
                <p:cNvSpPr>
                  <a:spLocks noChangeShapeType="1"/>
                </p:cNvSpPr>
                <p:nvPr/>
              </p:nvSpPr>
              <p:spPr bwMode="auto">
                <a:xfrm flipV="1">
                  <a:off x="2295894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7" name="Line 350"/>
                <p:cNvSpPr>
                  <a:spLocks noChangeShapeType="1"/>
                </p:cNvSpPr>
                <p:nvPr/>
              </p:nvSpPr>
              <p:spPr bwMode="auto">
                <a:xfrm flipV="1">
                  <a:off x="2369335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8" name="Line 351"/>
                <p:cNvSpPr>
                  <a:spLocks noChangeShapeType="1"/>
                </p:cNvSpPr>
                <p:nvPr/>
              </p:nvSpPr>
              <p:spPr bwMode="auto">
                <a:xfrm flipV="1">
                  <a:off x="244277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09" name="Line 352"/>
                <p:cNvSpPr>
                  <a:spLocks noChangeShapeType="1"/>
                </p:cNvSpPr>
                <p:nvPr/>
              </p:nvSpPr>
              <p:spPr bwMode="auto">
                <a:xfrm flipV="1">
                  <a:off x="2516220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0" name="Line 353"/>
                <p:cNvSpPr>
                  <a:spLocks noChangeShapeType="1"/>
                </p:cNvSpPr>
                <p:nvPr/>
              </p:nvSpPr>
              <p:spPr bwMode="auto">
                <a:xfrm flipV="1">
                  <a:off x="2588099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1" name="Line 354"/>
                <p:cNvSpPr>
                  <a:spLocks noChangeShapeType="1"/>
                </p:cNvSpPr>
                <p:nvPr/>
              </p:nvSpPr>
              <p:spPr bwMode="auto">
                <a:xfrm flipV="1">
                  <a:off x="2661542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2" name="Line 355"/>
                <p:cNvSpPr>
                  <a:spLocks noChangeShapeType="1"/>
                </p:cNvSpPr>
                <p:nvPr/>
              </p:nvSpPr>
              <p:spPr bwMode="auto">
                <a:xfrm flipV="1">
                  <a:off x="2734984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3" name="Line 356"/>
                <p:cNvSpPr>
                  <a:spLocks noChangeShapeType="1"/>
                </p:cNvSpPr>
                <p:nvPr/>
              </p:nvSpPr>
              <p:spPr bwMode="auto">
                <a:xfrm flipV="1">
                  <a:off x="2808427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4" name="Line 357"/>
                <p:cNvSpPr>
                  <a:spLocks noChangeShapeType="1"/>
                </p:cNvSpPr>
                <p:nvPr/>
              </p:nvSpPr>
              <p:spPr bwMode="auto">
                <a:xfrm flipV="1">
                  <a:off x="2880306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5" name="Line 358"/>
                <p:cNvSpPr>
                  <a:spLocks noChangeShapeType="1"/>
                </p:cNvSpPr>
                <p:nvPr/>
              </p:nvSpPr>
              <p:spPr bwMode="auto">
                <a:xfrm flipV="1">
                  <a:off x="295374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6" name="Line 359"/>
                <p:cNvSpPr>
                  <a:spLocks noChangeShapeType="1"/>
                </p:cNvSpPr>
                <p:nvPr/>
              </p:nvSpPr>
              <p:spPr bwMode="auto">
                <a:xfrm flipV="1">
                  <a:off x="3027191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7" name="Line 360"/>
                <p:cNvSpPr>
                  <a:spLocks noChangeShapeType="1"/>
                </p:cNvSpPr>
                <p:nvPr/>
              </p:nvSpPr>
              <p:spPr bwMode="auto">
                <a:xfrm flipV="1">
                  <a:off x="3100632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8" name="Line 361"/>
                <p:cNvSpPr>
                  <a:spLocks noChangeShapeType="1"/>
                </p:cNvSpPr>
                <p:nvPr/>
              </p:nvSpPr>
              <p:spPr bwMode="auto">
                <a:xfrm flipV="1">
                  <a:off x="3174075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19" name="Line 362"/>
                <p:cNvSpPr>
                  <a:spLocks noChangeShapeType="1"/>
                </p:cNvSpPr>
                <p:nvPr/>
              </p:nvSpPr>
              <p:spPr bwMode="auto">
                <a:xfrm flipV="1">
                  <a:off x="3247517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0" name="Line 363"/>
                <p:cNvSpPr>
                  <a:spLocks noChangeShapeType="1"/>
                </p:cNvSpPr>
                <p:nvPr/>
              </p:nvSpPr>
              <p:spPr bwMode="auto">
                <a:xfrm flipV="1">
                  <a:off x="3319396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1" name="Line 364"/>
                <p:cNvSpPr>
                  <a:spLocks noChangeShapeType="1"/>
                </p:cNvSpPr>
                <p:nvPr/>
              </p:nvSpPr>
              <p:spPr bwMode="auto">
                <a:xfrm flipV="1">
                  <a:off x="3392839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2" name="Line 365"/>
                <p:cNvSpPr>
                  <a:spLocks noChangeShapeType="1"/>
                </p:cNvSpPr>
                <p:nvPr/>
              </p:nvSpPr>
              <p:spPr bwMode="auto">
                <a:xfrm flipV="1">
                  <a:off x="3466281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3" name="Line 366"/>
                <p:cNvSpPr>
                  <a:spLocks noChangeShapeType="1"/>
                </p:cNvSpPr>
                <p:nvPr/>
              </p:nvSpPr>
              <p:spPr bwMode="auto">
                <a:xfrm flipV="1">
                  <a:off x="3539724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4" name="Line 367"/>
                <p:cNvSpPr>
                  <a:spLocks noChangeShapeType="1"/>
                </p:cNvSpPr>
                <p:nvPr/>
              </p:nvSpPr>
              <p:spPr bwMode="auto">
                <a:xfrm flipV="1">
                  <a:off x="3613165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5" name="Line 368"/>
                <p:cNvSpPr>
                  <a:spLocks noChangeShapeType="1"/>
                </p:cNvSpPr>
                <p:nvPr/>
              </p:nvSpPr>
              <p:spPr bwMode="auto">
                <a:xfrm flipV="1">
                  <a:off x="368660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6" name="Line 369"/>
                <p:cNvSpPr>
                  <a:spLocks noChangeShapeType="1"/>
                </p:cNvSpPr>
                <p:nvPr/>
              </p:nvSpPr>
              <p:spPr bwMode="auto">
                <a:xfrm flipV="1">
                  <a:off x="375848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7" name="Line 370"/>
                <p:cNvSpPr>
                  <a:spLocks noChangeShapeType="1"/>
                </p:cNvSpPr>
                <p:nvPr/>
              </p:nvSpPr>
              <p:spPr bwMode="auto">
                <a:xfrm flipV="1">
                  <a:off x="3831929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8" name="Line 371"/>
                <p:cNvSpPr>
                  <a:spLocks noChangeShapeType="1"/>
                </p:cNvSpPr>
                <p:nvPr/>
              </p:nvSpPr>
              <p:spPr bwMode="auto">
                <a:xfrm flipV="1">
                  <a:off x="3905372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29" name="Line 372"/>
                <p:cNvSpPr>
                  <a:spLocks noChangeShapeType="1"/>
                </p:cNvSpPr>
                <p:nvPr/>
              </p:nvSpPr>
              <p:spPr bwMode="auto">
                <a:xfrm flipV="1">
                  <a:off x="3978814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0" name="Line 373"/>
                <p:cNvSpPr>
                  <a:spLocks noChangeShapeType="1"/>
                </p:cNvSpPr>
                <p:nvPr/>
              </p:nvSpPr>
              <p:spPr bwMode="auto">
                <a:xfrm flipV="1">
                  <a:off x="4052256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1" name="Line 374"/>
                <p:cNvSpPr>
                  <a:spLocks noChangeShapeType="1"/>
                </p:cNvSpPr>
                <p:nvPr/>
              </p:nvSpPr>
              <p:spPr bwMode="auto">
                <a:xfrm flipV="1">
                  <a:off x="4124136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2" name="Line 375"/>
                <p:cNvSpPr>
                  <a:spLocks noChangeShapeType="1"/>
                </p:cNvSpPr>
                <p:nvPr/>
              </p:nvSpPr>
              <p:spPr bwMode="auto">
                <a:xfrm flipV="1">
                  <a:off x="4197578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3" name="Line 376"/>
                <p:cNvSpPr>
                  <a:spLocks noChangeShapeType="1"/>
                </p:cNvSpPr>
                <p:nvPr/>
              </p:nvSpPr>
              <p:spPr bwMode="auto">
                <a:xfrm flipV="1">
                  <a:off x="4271021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4" name="Line 377"/>
                <p:cNvSpPr>
                  <a:spLocks noChangeShapeType="1"/>
                </p:cNvSpPr>
                <p:nvPr/>
              </p:nvSpPr>
              <p:spPr bwMode="auto">
                <a:xfrm flipV="1">
                  <a:off x="4344462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5" name="Line 378"/>
                <p:cNvSpPr>
                  <a:spLocks noChangeShapeType="1"/>
                </p:cNvSpPr>
                <p:nvPr/>
              </p:nvSpPr>
              <p:spPr bwMode="auto">
                <a:xfrm flipV="1">
                  <a:off x="4417905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6" name="Line 379"/>
                <p:cNvSpPr>
                  <a:spLocks noChangeShapeType="1"/>
                </p:cNvSpPr>
                <p:nvPr/>
              </p:nvSpPr>
              <p:spPr bwMode="auto">
                <a:xfrm flipV="1">
                  <a:off x="4489785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7" name="Line 380"/>
                <p:cNvSpPr>
                  <a:spLocks noChangeShapeType="1"/>
                </p:cNvSpPr>
                <p:nvPr/>
              </p:nvSpPr>
              <p:spPr bwMode="auto">
                <a:xfrm flipV="1">
                  <a:off x="4563226" y="3675879"/>
                  <a:ext cx="0" cy="2812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38" name="Rectangle 381"/>
                <p:cNvSpPr>
                  <a:spLocks noChangeArrowheads="1"/>
                </p:cNvSpPr>
                <p:nvPr/>
              </p:nvSpPr>
              <p:spPr bwMode="auto">
                <a:xfrm>
                  <a:off x="706242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5.00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39" name="Rectangle 382"/>
                <p:cNvSpPr>
                  <a:spLocks noChangeArrowheads="1"/>
                </p:cNvSpPr>
                <p:nvPr/>
              </p:nvSpPr>
              <p:spPr bwMode="auto">
                <a:xfrm>
                  <a:off x="1071890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5.50</a:t>
                  </a:r>
                  <a:endPara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0" name="Rectangle 383"/>
                <p:cNvSpPr>
                  <a:spLocks noChangeArrowheads="1"/>
                </p:cNvSpPr>
                <p:nvPr/>
              </p:nvSpPr>
              <p:spPr bwMode="auto">
                <a:xfrm>
                  <a:off x="1437539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6.00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1" name="Rectangle 384"/>
                <p:cNvSpPr>
                  <a:spLocks noChangeArrowheads="1"/>
                </p:cNvSpPr>
                <p:nvPr/>
              </p:nvSpPr>
              <p:spPr bwMode="auto">
                <a:xfrm>
                  <a:off x="1803189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6.50</a:t>
                  </a:r>
                  <a:endPara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2" name="Rectangle 385"/>
                <p:cNvSpPr>
                  <a:spLocks noChangeArrowheads="1"/>
                </p:cNvSpPr>
                <p:nvPr/>
              </p:nvSpPr>
              <p:spPr bwMode="auto">
                <a:xfrm>
                  <a:off x="2168835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7.00</a:t>
                  </a:r>
                  <a:endPara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3" name="Rectangle 386"/>
                <p:cNvSpPr>
                  <a:spLocks noChangeArrowheads="1"/>
                </p:cNvSpPr>
                <p:nvPr/>
              </p:nvSpPr>
              <p:spPr bwMode="auto">
                <a:xfrm>
                  <a:off x="2534485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7.50</a:t>
                  </a:r>
                  <a:endPara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4" name="Rectangle 387"/>
                <p:cNvSpPr>
                  <a:spLocks noChangeArrowheads="1"/>
                </p:cNvSpPr>
                <p:nvPr/>
              </p:nvSpPr>
              <p:spPr bwMode="auto">
                <a:xfrm>
                  <a:off x="2900134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8.00</a:t>
                  </a:r>
                  <a:endPara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5" name="Rectangle 388"/>
                <p:cNvSpPr>
                  <a:spLocks noChangeArrowheads="1"/>
                </p:cNvSpPr>
                <p:nvPr/>
              </p:nvSpPr>
              <p:spPr bwMode="auto">
                <a:xfrm>
                  <a:off x="3265782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8.50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6" name="Rectangle 389"/>
                <p:cNvSpPr>
                  <a:spLocks noChangeArrowheads="1"/>
                </p:cNvSpPr>
                <p:nvPr/>
              </p:nvSpPr>
              <p:spPr bwMode="auto">
                <a:xfrm>
                  <a:off x="3631430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9.00</a:t>
                  </a:r>
                  <a:endPara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7" name="Rectangle 390"/>
                <p:cNvSpPr>
                  <a:spLocks noChangeArrowheads="1"/>
                </p:cNvSpPr>
                <p:nvPr/>
              </p:nvSpPr>
              <p:spPr bwMode="auto">
                <a:xfrm>
                  <a:off x="3997079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9.50</a:t>
                  </a:r>
                  <a:endPara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8" name="Rectangle 391"/>
                <p:cNvSpPr>
                  <a:spLocks noChangeArrowheads="1"/>
                </p:cNvSpPr>
                <p:nvPr/>
              </p:nvSpPr>
              <p:spPr bwMode="auto">
                <a:xfrm>
                  <a:off x="4362727" y="3748629"/>
                  <a:ext cx="2525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20.00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249" name="Line 392"/>
                <p:cNvSpPr>
                  <a:spLocks noChangeShapeType="1"/>
                </p:cNvSpPr>
                <p:nvPr/>
              </p:nvSpPr>
              <p:spPr bwMode="auto">
                <a:xfrm flipV="1">
                  <a:off x="833300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0" name="Line 393"/>
                <p:cNvSpPr>
                  <a:spLocks noChangeShapeType="1"/>
                </p:cNvSpPr>
                <p:nvPr/>
              </p:nvSpPr>
              <p:spPr bwMode="auto">
                <a:xfrm flipV="1">
                  <a:off x="1198948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1" name="Line 394"/>
                <p:cNvSpPr>
                  <a:spLocks noChangeShapeType="1"/>
                </p:cNvSpPr>
                <p:nvPr/>
              </p:nvSpPr>
              <p:spPr bwMode="auto">
                <a:xfrm flipV="1">
                  <a:off x="1564597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2" name="Line 395"/>
                <p:cNvSpPr>
                  <a:spLocks noChangeShapeType="1"/>
                </p:cNvSpPr>
                <p:nvPr/>
              </p:nvSpPr>
              <p:spPr bwMode="auto">
                <a:xfrm flipV="1">
                  <a:off x="1930245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3" name="Line 396"/>
                <p:cNvSpPr>
                  <a:spLocks noChangeShapeType="1"/>
                </p:cNvSpPr>
                <p:nvPr/>
              </p:nvSpPr>
              <p:spPr bwMode="auto">
                <a:xfrm flipV="1">
                  <a:off x="2295894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4" name="Line 397"/>
                <p:cNvSpPr>
                  <a:spLocks noChangeShapeType="1"/>
                </p:cNvSpPr>
                <p:nvPr/>
              </p:nvSpPr>
              <p:spPr bwMode="auto">
                <a:xfrm flipV="1">
                  <a:off x="2661542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5" name="Line 398"/>
                <p:cNvSpPr>
                  <a:spLocks noChangeShapeType="1"/>
                </p:cNvSpPr>
                <p:nvPr/>
              </p:nvSpPr>
              <p:spPr bwMode="auto">
                <a:xfrm flipV="1">
                  <a:off x="3027191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6" name="Line 399"/>
                <p:cNvSpPr>
                  <a:spLocks noChangeShapeType="1"/>
                </p:cNvSpPr>
                <p:nvPr/>
              </p:nvSpPr>
              <p:spPr bwMode="auto">
                <a:xfrm flipV="1">
                  <a:off x="3392839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7" name="Line 400"/>
                <p:cNvSpPr>
                  <a:spLocks noChangeShapeType="1"/>
                </p:cNvSpPr>
                <p:nvPr/>
              </p:nvSpPr>
              <p:spPr bwMode="auto">
                <a:xfrm flipV="1">
                  <a:off x="3758488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8" name="Line 401"/>
                <p:cNvSpPr>
                  <a:spLocks noChangeShapeType="1"/>
                </p:cNvSpPr>
                <p:nvPr/>
              </p:nvSpPr>
              <p:spPr bwMode="auto">
                <a:xfrm flipV="1">
                  <a:off x="4124136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59" name="Line 402"/>
                <p:cNvSpPr>
                  <a:spLocks noChangeShapeType="1"/>
                </p:cNvSpPr>
                <p:nvPr/>
              </p:nvSpPr>
              <p:spPr bwMode="auto">
                <a:xfrm flipV="1">
                  <a:off x="4489785" y="3675879"/>
                  <a:ext cx="0" cy="5469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0" name="Line 403"/>
                <p:cNvSpPr>
                  <a:spLocks noChangeShapeType="1"/>
                </p:cNvSpPr>
                <p:nvPr/>
              </p:nvSpPr>
              <p:spPr bwMode="auto">
                <a:xfrm flipV="1">
                  <a:off x="695791" y="1086650"/>
                  <a:ext cx="0" cy="258922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1" name="Line 404"/>
                <p:cNvSpPr>
                  <a:spLocks noChangeShapeType="1"/>
                </p:cNvSpPr>
                <p:nvPr/>
              </p:nvSpPr>
              <p:spPr bwMode="auto">
                <a:xfrm>
                  <a:off x="689540" y="3641502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2" name="Line 405"/>
                <p:cNvSpPr>
                  <a:spLocks noChangeShapeType="1"/>
                </p:cNvSpPr>
                <p:nvPr/>
              </p:nvSpPr>
              <p:spPr bwMode="auto">
                <a:xfrm>
                  <a:off x="689540" y="3582123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3" name="Line 406"/>
                <p:cNvSpPr>
                  <a:spLocks noChangeShapeType="1"/>
                </p:cNvSpPr>
                <p:nvPr/>
              </p:nvSpPr>
              <p:spPr bwMode="auto">
                <a:xfrm>
                  <a:off x="689540" y="3524306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4" name="Line 407"/>
                <p:cNvSpPr>
                  <a:spLocks noChangeShapeType="1"/>
                </p:cNvSpPr>
                <p:nvPr/>
              </p:nvSpPr>
              <p:spPr bwMode="auto">
                <a:xfrm>
                  <a:off x="689540" y="3464927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5" name="Line 408"/>
                <p:cNvSpPr>
                  <a:spLocks noChangeShapeType="1"/>
                </p:cNvSpPr>
                <p:nvPr/>
              </p:nvSpPr>
              <p:spPr bwMode="auto">
                <a:xfrm>
                  <a:off x="689540" y="3407112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6" name="Line 409"/>
                <p:cNvSpPr>
                  <a:spLocks noChangeShapeType="1"/>
                </p:cNvSpPr>
                <p:nvPr/>
              </p:nvSpPr>
              <p:spPr bwMode="auto">
                <a:xfrm>
                  <a:off x="689540" y="3349295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7" name="Line 410"/>
                <p:cNvSpPr>
                  <a:spLocks noChangeShapeType="1"/>
                </p:cNvSpPr>
                <p:nvPr/>
              </p:nvSpPr>
              <p:spPr bwMode="auto">
                <a:xfrm>
                  <a:off x="689540" y="3289916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8" name="Line 411"/>
                <p:cNvSpPr>
                  <a:spLocks noChangeShapeType="1"/>
                </p:cNvSpPr>
                <p:nvPr/>
              </p:nvSpPr>
              <p:spPr bwMode="auto">
                <a:xfrm>
                  <a:off x="689540" y="3232100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69" name="Line 412"/>
                <p:cNvSpPr>
                  <a:spLocks noChangeShapeType="1"/>
                </p:cNvSpPr>
                <p:nvPr/>
              </p:nvSpPr>
              <p:spPr bwMode="auto">
                <a:xfrm>
                  <a:off x="689540" y="3174284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0" name="Line 413"/>
                <p:cNvSpPr>
                  <a:spLocks noChangeShapeType="1"/>
                </p:cNvSpPr>
                <p:nvPr/>
              </p:nvSpPr>
              <p:spPr bwMode="auto">
                <a:xfrm>
                  <a:off x="689540" y="3114905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1" name="Line 414"/>
                <p:cNvSpPr>
                  <a:spLocks noChangeShapeType="1"/>
                </p:cNvSpPr>
                <p:nvPr/>
              </p:nvSpPr>
              <p:spPr bwMode="auto">
                <a:xfrm>
                  <a:off x="689540" y="3057089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2" name="Line 415"/>
                <p:cNvSpPr>
                  <a:spLocks noChangeShapeType="1"/>
                </p:cNvSpPr>
                <p:nvPr/>
              </p:nvSpPr>
              <p:spPr bwMode="auto">
                <a:xfrm>
                  <a:off x="689540" y="2997710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3" name="Line 416"/>
                <p:cNvSpPr>
                  <a:spLocks noChangeShapeType="1"/>
                </p:cNvSpPr>
                <p:nvPr/>
              </p:nvSpPr>
              <p:spPr bwMode="auto">
                <a:xfrm>
                  <a:off x="689540" y="2939894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4" name="Line 417"/>
                <p:cNvSpPr>
                  <a:spLocks noChangeShapeType="1"/>
                </p:cNvSpPr>
                <p:nvPr/>
              </p:nvSpPr>
              <p:spPr bwMode="auto">
                <a:xfrm>
                  <a:off x="689540" y="2882078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5" name="Line 418"/>
                <p:cNvSpPr>
                  <a:spLocks noChangeShapeType="1"/>
                </p:cNvSpPr>
                <p:nvPr/>
              </p:nvSpPr>
              <p:spPr bwMode="auto">
                <a:xfrm>
                  <a:off x="689540" y="2822699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6" name="Line 419"/>
                <p:cNvSpPr>
                  <a:spLocks noChangeShapeType="1"/>
                </p:cNvSpPr>
                <p:nvPr/>
              </p:nvSpPr>
              <p:spPr bwMode="auto">
                <a:xfrm>
                  <a:off x="689540" y="2764883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7" name="Line 420"/>
                <p:cNvSpPr>
                  <a:spLocks noChangeShapeType="1"/>
                </p:cNvSpPr>
                <p:nvPr/>
              </p:nvSpPr>
              <p:spPr bwMode="auto">
                <a:xfrm>
                  <a:off x="689540" y="2707067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8" name="Line 421"/>
                <p:cNvSpPr>
                  <a:spLocks noChangeShapeType="1"/>
                </p:cNvSpPr>
                <p:nvPr/>
              </p:nvSpPr>
              <p:spPr bwMode="auto">
                <a:xfrm>
                  <a:off x="689540" y="2647688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79" name="Line 422"/>
                <p:cNvSpPr>
                  <a:spLocks noChangeShapeType="1"/>
                </p:cNvSpPr>
                <p:nvPr/>
              </p:nvSpPr>
              <p:spPr bwMode="auto">
                <a:xfrm>
                  <a:off x="689540" y="2589871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0" name="Line 423"/>
                <p:cNvSpPr>
                  <a:spLocks noChangeShapeType="1"/>
                </p:cNvSpPr>
                <p:nvPr/>
              </p:nvSpPr>
              <p:spPr bwMode="auto">
                <a:xfrm>
                  <a:off x="689540" y="2530493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1" name="Line 424"/>
                <p:cNvSpPr>
                  <a:spLocks noChangeShapeType="1"/>
                </p:cNvSpPr>
                <p:nvPr/>
              </p:nvSpPr>
              <p:spPr bwMode="auto">
                <a:xfrm>
                  <a:off x="689540" y="2472677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2" name="Line 425"/>
                <p:cNvSpPr>
                  <a:spLocks noChangeShapeType="1"/>
                </p:cNvSpPr>
                <p:nvPr/>
              </p:nvSpPr>
              <p:spPr bwMode="auto">
                <a:xfrm>
                  <a:off x="689540" y="2414860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3" name="Line 426"/>
                <p:cNvSpPr>
                  <a:spLocks noChangeShapeType="1"/>
                </p:cNvSpPr>
                <p:nvPr/>
              </p:nvSpPr>
              <p:spPr bwMode="auto">
                <a:xfrm>
                  <a:off x="689540" y="2355481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4" name="Line 427"/>
                <p:cNvSpPr>
                  <a:spLocks noChangeShapeType="1"/>
                </p:cNvSpPr>
                <p:nvPr/>
              </p:nvSpPr>
              <p:spPr bwMode="auto">
                <a:xfrm>
                  <a:off x="689540" y="2297666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5" name="Line 428"/>
                <p:cNvSpPr>
                  <a:spLocks noChangeShapeType="1"/>
                </p:cNvSpPr>
                <p:nvPr/>
              </p:nvSpPr>
              <p:spPr bwMode="auto">
                <a:xfrm>
                  <a:off x="689540" y="2239849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6" name="Line 429"/>
                <p:cNvSpPr>
                  <a:spLocks noChangeShapeType="1"/>
                </p:cNvSpPr>
                <p:nvPr/>
              </p:nvSpPr>
              <p:spPr bwMode="auto">
                <a:xfrm>
                  <a:off x="689540" y="2180470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7" name="Line 430"/>
                <p:cNvSpPr>
                  <a:spLocks noChangeShapeType="1"/>
                </p:cNvSpPr>
                <p:nvPr/>
              </p:nvSpPr>
              <p:spPr bwMode="auto">
                <a:xfrm>
                  <a:off x="689540" y="2122654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8" name="Line 431"/>
                <p:cNvSpPr>
                  <a:spLocks noChangeShapeType="1"/>
                </p:cNvSpPr>
                <p:nvPr/>
              </p:nvSpPr>
              <p:spPr bwMode="auto">
                <a:xfrm>
                  <a:off x="689540" y="2063276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89" name="Line 432"/>
                <p:cNvSpPr>
                  <a:spLocks noChangeShapeType="1"/>
                </p:cNvSpPr>
                <p:nvPr/>
              </p:nvSpPr>
              <p:spPr bwMode="auto">
                <a:xfrm>
                  <a:off x="689540" y="2005459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0" name="Line 433"/>
                <p:cNvSpPr>
                  <a:spLocks noChangeShapeType="1"/>
                </p:cNvSpPr>
                <p:nvPr/>
              </p:nvSpPr>
              <p:spPr bwMode="auto">
                <a:xfrm>
                  <a:off x="689540" y="1947643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1" name="Line 434"/>
                <p:cNvSpPr>
                  <a:spLocks noChangeShapeType="1"/>
                </p:cNvSpPr>
                <p:nvPr/>
              </p:nvSpPr>
              <p:spPr bwMode="auto">
                <a:xfrm>
                  <a:off x="689540" y="1888264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2" name="Line 435"/>
                <p:cNvSpPr>
                  <a:spLocks noChangeShapeType="1"/>
                </p:cNvSpPr>
                <p:nvPr/>
              </p:nvSpPr>
              <p:spPr bwMode="auto">
                <a:xfrm>
                  <a:off x="689540" y="1830448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3" name="Line 436"/>
                <p:cNvSpPr>
                  <a:spLocks noChangeShapeType="1"/>
                </p:cNvSpPr>
                <p:nvPr/>
              </p:nvSpPr>
              <p:spPr bwMode="auto">
                <a:xfrm>
                  <a:off x="689540" y="1772632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4" name="Line 437"/>
                <p:cNvSpPr>
                  <a:spLocks noChangeShapeType="1"/>
                </p:cNvSpPr>
                <p:nvPr/>
              </p:nvSpPr>
              <p:spPr bwMode="auto">
                <a:xfrm>
                  <a:off x="689540" y="1713253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5" name="Line 438"/>
                <p:cNvSpPr>
                  <a:spLocks noChangeShapeType="1"/>
                </p:cNvSpPr>
                <p:nvPr/>
              </p:nvSpPr>
              <p:spPr bwMode="auto">
                <a:xfrm>
                  <a:off x="689540" y="1655436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6" name="Line 439"/>
                <p:cNvSpPr>
                  <a:spLocks noChangeShapeType="1"/>
                </p:cNvSpPr>
                <p:nvPr/>
              </p:nvSpPr>
              <p:spPr bwMode="auto">
                <a:xfrm>
                  <a:off x="689540" y="1596058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7" name="Line 440"/>
                <p:cNvSpPr>
                  <a:spLocks noChangeShapeType="1"/>
                </p:cNvSpPr>
                <p:nvPr/>
              </p:nvSpPr>
              <p:spPr bwMode="auto">
                <a:xfrm>
                  <a:off x="689540" y="1538242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8" name="Line 441"/>
                <p:cNvSpPr>
                  <a:spLocks noChangeShapeType="1"/>
                </p:cNvSpPr>
                <p:nvPr/>
              </p:nvSpPr>
              <p:spPr bwMode="auto">
                <a:xfrm>
                  <a:off x="689540" y="1480425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299" name="Line 442"/>
                <p:cNvSpPr>
                  <a:spLocks noChangeShapeType="1"/>
                </p:cNvSpPr>
                <p:nvPr/>
              </p:nvSpPr>
              <p:spPr bwMode="auto">
                <a:xfrm>
                  <a:off x="689540" y="1421046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0" name="Line 443"/>
                <p:cNvSpPr>
                  <a:spLocks noChangeShapeType="1"/>
                </p:cNvSpPr>
                <p:nvPr/>
              </p:nvSpPr>
              <p:spPr bwMode="auto">
                <a:xfrm>
                  <a:off x="689540" y="1363231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1" name="Line 444"/>
                <p:cNvSpPr>
                  <a:spLocks noChangeShapeType="1"/>
                </p:cNvSpPr>
                <p:nvPr/>
              </p:nvSpPr>
              <p:spPr bwMode="auto">
                <a:xfrm>
                  <a:off x="689540" y="1305414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2" name="Line 445"/>
                <p:cNvSpPr>
                  <a:spLocks noChangeShapeType="1"/>
                </p:cNvSpPr>
                <p:nvPr/>
              </p:nvSpPr>
              <p:spPr bwMode="auto">
                <a:xfrm>
                  <a:off x="689540" y="1246035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3" name="Line 446"/>
                <p:cNvSpPr>
                  <a:spLocks noChangeShapeType="1"/>
                </p:cNvSpPr>
                <p:nvPr/>
              </p:nvSpPr>
              <p:spPr bwMode="auto">
                <a:xfrm>
                  <a:off x="689540" y="1188219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4" name="Line 447"/>
                <p:cNvSpPr>
                  <a:spLocks noChangeShapeType="1"/>
                </p:cNvSpPr>
                <p:nvPr/>
              </p:nvSpPr>
              <p:spPr bwMode="auto">
                <a:xfrm>
                  <a:off x="689540" y="1128841"/>
                  <a:ext cx="625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5" name="Line 448"/>
                <p:cNvSpPr>
                  <a:spLocks noChangeShapeType="1"/>
                </p:cNvSpPr>
                <p:nvPr/>
              </p:nvSpPr>
              <p:spPr bwMode="auto">
                <a:xfrm>
                  <a:off x="683290" y="3407112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6" name="Rectangle 449"/>
                <p:cNvSpPr>
                  <a:spLocks noChangeArrowheads="1"/>
                </p:cNvSpPr>
                <p:nvPr/>
              </p:nvSpPr>
              <p:spPr bwMode="auto">
                <a:xfrm>
                  <a:off x="575697" y="3351963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07" name="Line 450"/>
                <p:cNvSpPr>
                  <a:spLocks noChangeShapeType="1"/>
                </p:cNvSpPr>
                <p:nvPr/>
              </p:nvSpPr>
              <p:spPr bwMode="auto">
                <a:xfrm>
                  <a:off x="683290" y="3114905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08" name="Rectangle 451"/>
                <p:cNvSpPr>
                  <a:spLocks noChangeArrowheads="1"/>
                </p:cNvSpPr>
                <p:nvPr/>
              </p:nvSpPr>
              <p:spPr bwMode="auto">
                <a:xfrm>
                  <a:off x="575697" y="3059759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2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09" name="Line 452"/>
                <p:cNvSpPr>
                  <a:spLocks noChangeShapeType="1"/>
                </p:cNvSpPr>
                <p:nvPr/>
              </p:nvSpPr>
              <p:spPr bwMode="auto">
                <a:xfrm>
                  <a:off x="683290" y="2822699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10" name="Rectangle 453"/>
                <p:cNvSpPr>
                  <a:spLocks noChangeArrowheads="1"/>
                </p:cNvSpPr>
                <p:nvPr/>
              </p:nvSpPr>
              <p:spPr bwMode="auto">
                <a:xfrm>
                  <a:off x="575697" y="2767551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3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11" name="Line 454"/>
                <p:cNvSpPr>
                  <a:spLocks noChangeShapeType="1"/>
                </p:cNvSpPr>
                <p:nvPr/>
              </p:nvSpPr>
              <p:spPr bwMode="auto">
                <a:xfrm>
                  <a:off x="683290" y="2530493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12" name="Rectangle 455"/>
                <p:cNvSpPr>
                  <a:spLocks noChangeArrowheads="1"/>
                </p:cNvSpPr>
                <p:nvPr/>
              </p:nvSpPr>
              <p:spPr bwMode="auto">
                <a:xfrm>
                  <a:off x="575697" y="2475344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4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13" name="Line 456"/>
                <p:cNvSpPr>
                  <a:spLocks noChangeShapeType="1"/>
                </p:cNvSpPr>
                <p:nvPr/>
              </p:nvSpPr>
              <p:spPr bwMode="auto">
                <a:xfrm>
                  <a:off x="683290" y="2239849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14" name="Rectangle 457"/>
                <p:cNvSpPr>
                  <a:spLocks noChangeArrowheads="1"/>
                </p:cNvSpPr>
                <p:nvPr/>
              </p:nvSpPr>
              <p:spPr bwMode="auto">
                <a:xfrm>
                  <a:off x="575697" y="2183139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5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15" name="Line 458"/>
                <p:cNvSpPr>
                  <a:spLocks noChangeShapeType="1"/>
                </p:cNvSpPr>
                <p:nvPr/>
              </p:nvSpPr>
              <p:spPr bwMode="auto">
                <a:xfrm>
                  <a:off x="683290" y="1947643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16" name="Rectangle 459"/>
                <p:cNvSpPr>
                  <a:spLocks noChangeArrowheads="1"/>
                </p:cNvSpPr>
                <p:nvPr/>
              </p:nvSpPr>
              <p:spPr bwMode="auto">
                <a:xfrm>
                  <a:off x="575697" y="1890932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6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17" name="Line 460"/>
                <p:cNvSpPr>
                  <a:spLocks noChangeShapeType="1"/>
                </p:cNvSpPr>
                <p:nvPr/>
              </p:nvSpPr>
              <p:spPr bwMode="auto">
                <a:xfrm>
                  <a:off x="683290" y="1655436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18" name="Rectangle 461"/>
                <p:cNvSpPr>
                  <a:spLocks noChangeArrowheads="1"/>
                </p:cNvSpPr>
                <p:nvPr/>
              </p:nvSpPr>
              <p:spPr bwMode="auto">
                <a:xfrm>
                  <a:off x="575697" y="1598726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19" name="Line 462"/>
                <p:cNvSpPr>
                  <a:spLocks noChangeShapeType="1"/>
                </p:cNvSpPr>
                <p:nvPr/>
              </p:nvSpPr>
              <p:spPr bwMode="auto">
                <a:xfrm>
                  <a:off x="683290" y="1363231"/>
                  <a:ext cx="12501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SG"/>
                </a:p>
              </p:txBody>
            </p:sp>
            <p:sp>
              <p:nvSpPr>
                <p:cNvPr id="320" name="Rectangle 463"/>
                <p:cNvSpPr>
                  <a:spLocks noChangeArrowheads="1"/>
                </p:cNvSpPr>
                <p:nvPr/>
              </p:nvSpPr>
              <p:spPr bwMode="auto">
                <a:xfrm>
                  <a:off x="575697" y="1308083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321" name="Rectangle 449"/>
                <p:cNvSpPr>
                  <a:spLocks noChangeArrowheads="1"/>
                </p:cNvSpPr>
                <p:nvPr/>
              </p:nvSpPr>
              <p:spPr bwMode="auto">
                <a:xfrm>
                  <a:off x="579486" y="3617128"/>
                  <a:ext cx="56114" cy="1224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0</a:t>
                  </a:r>
                  <a:endPara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</p:grpSp>
          <p:sp>
            <p:nvSpPr>
              <p:cNvPr id="182" name="Freeform 467"/>
              <p:cNvSpPr>
                <a:spLocks/>
              </p:cNvSpPr>
              <p:nvPr/>
            </p:nvSpPr>
            <p:spPr bwMode="auto">
              <a:xfrm flipV="1">
                <a:off x="632604" y="1375740"/>
                <a:ext cx="3284065" cy="1855585"/>
              </a:xfrm>
              <a:custGeom>
                <a:avLst/>
                <a:gdLst>
                  <a:gd name="T0" fmla="*/ 153 w 10100"/>
                  <a:gd name="T1" fmla="*/ 51 h 5955"/>
                  <a:gd name="T2" fmla="*/ 320 w 10100"/>
                  <a:gd name="T3" fmla="*/ 45 h 5955"/>
                  <a:gd name="T4" fmla="*/ 486 w 10100"/>
                  <a:gd name="T5" fmla="*/ 70 h 5955"/>
                  <a:gd name="T6" fmla="*/ 653 w 10100"/>
                  <a:gd name="T7" fmla="*/ 81 h 5955"/>
                  <a:gd name="T8" fmla="*/ 820 w 10100"/>
                  <a:gd name="T9" fmla="*/ 64 h 5955"/>
                  <a:gd name="T10" fmla="*/ 987 w 10100"/>
                  <a:gd name="T11" fmla="*/ 50 h 5955"/>
                  <a:gd name="T12" fmla="*/ 1154 w 10100"/>
                  <a:gd name="T13" fmla="*/ 144 h 5955"/>
                  <a:gd name="T14" fmla="*/ 1320 w 10100"/>
                  <a:gd name="T15" fmla="*/ 48 h 5955"/>
                  <a:gd name="T16" fmla="*/ 1487 w 10100"/>
                  <a:gd name="T17" fmla="*/ 71 h 5955"/>
                  <a:gd name="T18" fmla="*/ 1654 w 10100"/>
                  <a:gd name="T19" fmla="*/ 55 h 5955"/>
                  <a:gd name="T20" fmla="*/ 1821 w 10100"/>
                  <a:gd name="T21" fmla="*/ 68 h 5955"/>
                  <a:gd name="T22" fmla="*/ 1988 w 10100"/>
                  <a:gd name="T23" fmla="*/ 34 h 5955"/>
                  <a:gd name="T24" fmla="*/ 2154 w 10100"/>
                  <a:gd name="T25" fmla="*/ 12 h 5955"/>
                  <a:gd name="T26" fmla="*/ 2321 w 10100"/>
                  <a:gd name="T27" fmla="*/ 49 h 5955"/>
                  <a:gd name="T28" fmla="*/ 2488 w 10100"/>
                  <a:gd name="T29" fmla="*/ 7 h 5955"/>
                  <a:gd name="T30" fmla="*/ 2655 w 10100"/>
                  <a:gd name="T31" fmla="*/ 46 h 5955"/>
                  <a:gd name="T32" fmla="*/ 2822 w 10100"/>
                  <a:gd name="T33" fmla="*/ 17 h 5955"/>
                  <a:gd name="T34" fmla="*/ 2988 w 10100"/>
                  <a:gd name="T35" fmla="*/ 5 h 5955"/>
                  <a:gd name="T36" fmla="*/ 3155 w 10100"/>
                  <a:gd name="T37" fmla="*/ 8 h 5955"/>
                  <a:gd name="T38" fmla="*/ 3322 w 10100"/>
                  <a:gd name="T39" fmla="*/ 28 h 5955"/>
                  <a:gd name="T40" fmla="*/ 3489 w 10100"/>
                  <a:gd name="T41" fmla="*/ 71 h 5955"/>
                  <a:gd name="T42" fmla="*/ 3656 w 10100"/>
                  <a:gd name="T43" fmla="*/ 82 h 5955"/>
                  <a:gd name="T44" fmla="*/ 3822 w 10100"/>
                  <a:gd name="T45" fmla="*/ 19 h 5955"/>
                  <a:gd name="T46" fmla="*/ 3989 w 10100"/>
                  <a:gd name="T47" fmla="*/ 19 h 5955"/>
                  <a:gd name="T48" fmla="*/ 4156 w 10100"/>
                  <a:gd name="T49" fmla="*/ 39 h 5955"/>
                  <a:gd name="T50" fmla="*/ 4323 w 10100"/>
                  <a:gd name="T51" fmla="*/ 29 h 5955"/>
                  <a:gd name="T52" fmla="*/ 4490 w 10100"/>
                  <a:gd name="T53" fmla="*/ 1983 h 5955"/>
                  <a:gd name="T54" fmla="*/ 4656 w 10100"/>
                  <a:gd name="T55" fmla="*/ 2246 h 5955"/>
                  <a:gd name="T56" fmla="*/ 4823 w 10100"/>
                  <a:gd name="T57" fmla="*/ 405 h 5955"/>
                  <a:gd name="T58" fmla="*/ 4990 w 10100"/>
                  <a:gd name="T59" fmla="*/ 177 h 5955"/>
                  <a:gd name="T60" fmla="*/ 5157 w 10100"/>
                  <a:gd name="T61" fmla="*/ 182 h 5955"/>
                  <a:gd name="T62" fmla="*/ 5324 w 10100"/>
                  <a:gd name="T63" fmla="*/ 151 h 5955"/>
                  <a:gd name="T64" fmla="*/ 5490 w 10100"/>
                  <a:gd name="T65" fmla="*/ 330 h 5955"/>
                  <a:gd name="T66" fmla="*/ 5657 w 10100"/>
                  <a:gd name="T67" fmla="*/ 299 h 5955"/>
                  <a:gd name="T68" fmla="*/ 5824 w 10100"/>
                  <a:gd name="T69" fmla="*/ 172 h 5955"/>
                  <a:gd name="T70" fmla="*/ 5991 w 10100"/>
                  <a:gd name="T71" fmla="*/ 171 h 5955"/>
                  <a:gd name="T72" fmla="*/ 6158 w 10100"/>
                  <a:gd name="T73" fmla="*/ 382 h 5955"/>
                  <a:gd name="T74" fmla="*/ 6324 w 10100"/>
                  <a:gd name="T75" fmla="*/ 467 h 5955"/>
                  <a:gd name="T76" fmla="*/ 6491 w 10100"/>
                  <a:gd name="T77" fmla="*/ 714 h 5955"/>
                  <a:gd name="T78" fmla="*/ 6658 w 10100"/>
                  <a:gd name="T79" fmla="*/ 287 h 5955"/>
                  <a:gd name="T80" fmla="*/ 6825 w 10100"/>
                  <a:gd name="T81" fmla="*/ 243 h 5955"/>
                  <a:gd name="T82" fmla="*/ 6992 w 10100"/>
                  <a:gd name="T83" fmla="*/ 242 h 5955"/>
                  <a:gd name="T84" fmla="*/ 7158 w 10100"/>
                  <a:gd name="T85" fmla="*/ 301 h 5955"/>
                  <a:gd name="T86" fmla="*/ 7325 w 10100"/>
                  <a:gd name="T87" fmla="*/ 183 h 5955"/>
                  <a:gd name="T88" fmla="*/ 7492 w 10100"/>
                  <a:gd name="T89" fmla="*/ 187 h 5955"/>
                  <a:gd name="T90" fmla="*/ 7659 w 10100"/>
                  <a:gd name="T91" fmla="*/ 115 h 5955"/>
                  <a:gd name="T92" fmla="*/ 7826 w 10100"/>
                  <a:gd name="T93" fmla="*/ 123 h 5955"/>
                  <a:gd name="T94" fmla="*/ 7992 w 10100"/>
                  <a:gd name="T95" fmla="*/ 151 h 5955"/>
                  <a:gd name="T96" fmla="*/ 8159 w 10100"/>
                  <a:gd name="T97" fmla="*/ 103 h 5955"/>
                  <a:gd name="T98" fmla="*/ 8326 w 10100"/>
                  <a:gd name="T99" fmla="*/ 135 h 5955"/>
                  <a:gd name="T100" fmla="*/ 8493 w 10100"/>
                  <a:gd name="T101" fmla="*/ 122 h 5955"/>
                  <a:gd name="T102" fmla="*/ 8660 w 10100"/>
                  <a:gd name="T103" fmla="*/ 104 h 5955"/>
                  <a:gd name="T104" fmla="*/ 8826 w 10100"/>
                  <a:gd name="T105" fmla="*/ 83 h 5955"/>
                  <a:gd name="T106" fmla="*/ 8993 w 10100"/>
                  <a:gd name="T107" fmla="*/ 135 h 5955"/>
                  <a:gd name="T108" fmla="*/ 9160 w 10100"/>
                  <a:gd name="T109" fmla="*/ 194 h 5955"/>
                  <a:gd name="T110" fmla="*/ 9327 w 10100"/>
                  <a:gd name="T111" fmla="*/ 303 h 5955"/>
                  <a:gd name="T112" fmla="*/ 9494 w 10100"/>
                  <a:gd name="T113" fmla="*/ 124 h 5955"/>
                  <a:gd name="T114" fmla="*/ 9660 w 10100"/>
                  <a:gd name="T115" fmla="*/ 90 h 5955"/>
                  <a:gd name="T116" fmla="*/ 9827 w 10100"/>
                  <a:gd name="T117" fmla="*/ 87 h 5955"/>
                  <a:gd name="T118" fmla="*/ 9994 w 10100"/>
                  <a:gd name="T119" fmla="*/ 78 h 59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10100" h="5955">
                    <a:moveTo>
                      <a:pt x="0" y="51"/>
                    </a:moveTo>
                    <a:lnTo>
                      <a:pt x="12" y="52"/>
                    </a:lnTo>
                    <a:lnTo>
                      <a:pt x="24" y="51"/>
                    </a:lnTo>
                    <a:lnTo>
                      <a:pt x="37" y="48"/>
                    </a:lnTo>
                    <a:lnTo>
                      <a:pt x="50" y="49"/>
                    </a:lnTo>
                    <a:lnTo>
                      <a:pt x="63" y="53"/>
                    </a:lnTo>
                    <a:lnTo>
                      <a:pt x="76" y="49"/>
                    </a:lnTo>
                    <a:lnTo>
                      <a:pt x="89" y="46"/>
                    </a:lnTo>
                    <a:lnTo>
                      <a:pt x="101" y="45"/>
                    </a:lnTo>
                    <a:lnTo>
                      <a:pt x="114" y="39"/>
                    </a:lnTo>
                    <a:lnTo>
                      <a:pt x="127" y="40"/>
                    </a:lnTo>
                    <a:lnTo>
                      <a:pt x="140" y="47"/>
                    </a:lnTo>
                    <a:lnTo>
                      <a:pt x="153" y="51"/>
                    </a:lnTo>
                    <a:lnTo>
                      <a:pt x="166" y="51"/>
                    </a:lnTo>
                    <a:lnTo>
                      <a:pt x="178" y="50"/>
                    </a:lnTo>
                    <a:lnTo>
                      <a:pt x="191" y="49"/>
                    </a:lnTo>
                    <a:lnTo>
                      <a:pt x="204" y="44"/>
                    </a:lnTo>
                    <a:lnTo>
                      <a:pt x="217" y="52"/>
                    </a:lnTo>
                    <a:lnTo>
                      <a:pt x="230" y="46"/>
                    </a:lnTo>
                    <a:lnTo>
                      <a:pt x="243" y="52"/>
                    </a:lnTo>
                    <a:lnTo>
                      <a:pt x="255" y="46"/>
                    </a:lnTo>
                    <a:lnTo>
                      <a:pt x="268" y="46"/>
                    </a:lnTo>
                    <a:lnTo>
                      <a:pt x="281" y="44"/>
                    </a:lnTo>
                    <a:lnTo>
                      <a:pt x="294" y="44"/>
                    </a:lnTo>
                    <a:lnTo>
                      <a:pt x="307" y="44"/>
                    </a:lnTo>
                    <a:lnTo>
                      <a:pt x="320" y="45"/>
                    </a:lnTo>
                    <a:lnTo>
                      <a:pt x="332" y="44"/>
                    </a:lnTo>
                    <a:lnTo>
                      <a:pt x="345" y="40"/>
                    </a:lnTo>
                    <a:lnTo>
                      <a:pt x="358" y="41"/>
                    </a:lnTo>
                    <a:lnTo>
                      <a:pt x="371" y="43"/>
                    </a:lnTo>
                    <a:lnTo>
                      <a:pt x="384" y="50"/>
                    </a:lnTo>
                    <a:lnTo>
                      <a:pt x="397" y="48"/>
                    </a:lnTo>
                    <a:lnTo>
                      <a:pt x="409" y="51"/>
                    </a:lnTo>
                    <a:lnTo>
                      <a:pt x="422" y="55"/>
                    </a:lnTo>
                    <a:lnTo>
                      <a:pt x="435" y="64"/>
                    </a:lnTo>
                    <a:lnTo>
                      <a:pt x="448" y="69"/>
                    </a:lnTo>
                    <a:lnTo>
                      <a:pt x="461" y="68"/>
                    </a:lnTo>
                    <a:lnTo>
                      <a:pt x="474" y="71"/>
                    </a:lnTo>
                    <a:lnTo>
                      <a:pt x="486" y="70"/>
                    </a:lnTo>
                    <a:lnTo>
                      <a:pt x="499" y="70"/>
                    </a:lnTo>
                    <a:lnTo>
                      <a:pt x="512" y="80"/>
                    </a:lnTo>
                    <a:lnTo>
                      <a:pt x="525" y="77"/>
                    </a:lnTo>
                    <a:lnTo>
                      <a:pt x="538" y="73"/>
                    </a:lnTo>
                    <a:lnTo>
                      <a:pt x="551" y="81"/>
                    </a:lnTo>
                    <a:lnTo>
                      <a:pt x="563" y="80"/>
                    </a:lnTo>
                    <a:lnTo>
                      <a:pt x="576" y="86"/>
                    </a:lnTo>
                    <a:lnTo>
                      <a:pt x="589" y="79"/>
                    </a:lnTo>
                    <a:lnTo>
                      <a:pt x="602" y="82"/>
                    </a:lnTo>
                    <a:lnTo>
                      <a:pt x="615" y="81"/>
                    </a:lnTo>
                    <a:lnTo>
                      <a:pt x="628" y="89"/>
                    </a:lnTo>
                    <a:lnTo>
                      <a:pt x="640" y="81"/>
                    </a:lnTo>
                    <a:lnTo>
                      <a:pt x="653" y="81"/>
                    </a:lnTo>
                    <a:lnTo>
                      <a:pt x="666" y="72"/>
                    </a:lnTo>
                    <a:lnTo>
                      <a:pt x="679" y="73"/>
                    </a:lnTo>
                    <a:lnTo>
                      <a:pt x="692" y="64"/>
                    </a:lnTo>
                    <a:lnTo>
                      <a:pt x="705" y="64"/>
                    </a:lnTo>
                    <a:lnTo>
                      <a:pt x="717" y="59"/>
                    </a:lnTo>
                    <a:lnTo>
                      <a:pt x="730" y="46"/>
                    </a:lnTo>
                    <a:lnTo>
                      <a:pt x="743" y="47"/>
                    </a:lnTo>
                    <a:lnTo>
                      <a:pt x="756" y="41"/>
                    </a:lnTo>
                    <a:lnTo>
                      <a:pt x="769" y="44"/>
                    </a:lnTo>
                    <a:lnTo>
                      <a:pt x="782" y="48"/>
                    </a:lnTo>
                    <a:lnTo>
                      <a:pt x="794" y="54"/>
                    </a:lnTo>
                    <a:lnTo>
                      <a:pt x="807" y="60"/>
                    </a:lnTo>
                    <a:lnTo>
                      <a:pt x="820" y="64"/>
                    </a:lnTo>
                    <a:lnTo>
                      <a:pt x="833" y="54"/>
                    </a:lnTo>
                    <a:lnTo>
                      <a:pt x="846" y="62"/>
                    </a:lnTo>
                    <a:lnTo>
                      <a:pt x="858" y="60"/>
                    </a:lnTo>
                    <a:lnTo>
                      <a:pt x="871" y="58"/>
                    </a:lnTo>
                    <a:lnTo>
                      <a:pt x="884" y="59"/>
                    </a:lnTo>
                    <a:lnTo>
                      <a:pt x="897" y="59"/>
                    </a:lnTo>
                    <a:lnTo>
                      <a:pt x="910" y="60"/>
                    </a:lnTo>
                    <a:lnTo>
                      <a:pt x="923" y="79"/>
                    </a:lnTo>
                    <a:lnTo>
                      <a:pt x="935" y="57"/>
                    </a:lnTo>
                    <a:lnTo>
                      <a:pt x="948" y="53"/>
                    </a:lnTo>
                    <a:lnTo>
                      <a:pt x="961" y="53"/>
                    </a:lnTo>
                    <a:lnTo>
                      <a:pt x="974" y="54"/>
                    </a:lnTo>
                    <a:lnTo>
                      <a:pt x="987" y="50"/>
                    </a:lnTo>
                    <a:lnTo>
                      <a:pt x="1000" y="51"/>
                    </a:lnTo>
                    <a:lnTo>
                      <a:pt x="1012" y="48"/>
                    </a:lnTo>
                    <a:lnTo>
                      <a:pt x="1025" y="52"/>
                    </a:lnTo>
                    <a:lnTo>
                      <a:pt x="1038" y="58"/>
                    </a:lnTo>
                    <a:lnTo>
                      <a:pt x="1051" y="62"/>
                    </a:lnTo>
                    <a:lnTo>
                      <a:pt x="1064" y="81"/>
                    </a:lnTo>
                    <a:lnTo>
                      <a:pt x="1077" y="84"/>
                    </a:lnTo>
                    <a:lnTo>
                      <a:pt x="1089" y="87"/>
                    </a:lnTo>
                    <a:lnTo>
                      <a:pt x="1102" y="111"/>
                    </a:lnTo>
                    <a:lnTo>
                      <a:pt x="1115" y="112"/>
                    </a:lnTo>
                    <a:lnTo>
                      <a:pt x="1128" y="180"/>
                    </a:lnTo>
                    <a:lnTo>
                      <a:pt x="1141" y="140"/>
                    </a:lnTo>
                    <a:lnTo>
                      <a:pt x="1154" y="144"/>
                    </a:lnTo>
                    <a:lnTo>
                      <a:pt x="1166" y="158"/>
                    </a:lnTo>
                    <a:lnTo>
                      <a:pt x="1179" y="154"/>
                    </a:lnTo>
                    <a:lnTo>
                      <a:pt x="1192" y="156"/>
                    </a:lnTo>
                    <a:lnTo>
                      <a:pt x="1205" y="138"/>
                    </a:lnTo>
                    <a:lnTo>
                      <a:pt x="1218" y="136"/>
                    </a:lnTo>
                    <a:lnTo>
                      <a:pt x="1231" y="131"/>
                    </a:lnTo>
                    <a:lnTo>
                      <a:pt x="1243" y="111"/>
                    </a:lnTo>
                    <a:lnTo>
                      <a:pt x="1256" y="97"/>
                    </a:lnTo>
                    <a:lnTo>
                      <a:pt x="1269" y="80"/>
                    </a:lnTo>
                    <a:lnTo>
                      <a:pt x="1282" y="72"/>
                    </a:lnTo>
                    <a:lnTo>
                      <a:pt x="1295" y="55"/>
                    </a:lnTo>
                    <a:lnTo>
                      <a:pt x="1308" y="57"/>
                    </a:lnTo>
                    <a:lnTo>
                      <a:pt x="1320" y="48"/>
                    </a:lnTo>
                    <a:lnTo>
                      <a:pt x="1333" y="45"/>
                    </a:lnTo>
                    <a:lnTo>
                      <a:pt x="1346" y="42"/>
                    </a:lnTo>
                    <a:lnTo>
                      <a:pt x="1359" y="41"/>
                    </a:lnTo>
                    <a:lnTo>
                      <a:pt x="1372" y="48"/>
                    </a:lnTo>
                    <a:lnTo>
                      <a:pt x="1385" y="49"/>
                    </a:lnTo>
                    <a:lnTo>
                      <a:pt x="1397" y="49"/>
                    </a:lnTo>
                    <a:lnTo>
                      <a:pt x="1410" y="56"/>
                    </a:lnTo>
                    <a:lnTo>
                      <a:pt x="1423" y="62"/>
                    </a:lnTo>
                    <a:lnTo>
                      <a:pt x="1436" y="61"/>
                    </a:lnTo>
                    <a:lnTo>
                      <a:pt x="1449" y="65"/>
                    </a:lnTo>
                    <a:lnTo>
                      <a:pt x="1462" y="68"/>
                    </a:lnTo>
                    <a:lnTo>
                      <a:pt x="1474" y="59"/>
                    </a:lnTo>
                    <a:lnTo>
                      <a:pt x="1487" y="71"/>
                    </a:lnTo>
                    <a:lnTo>
                      <a:pt x="1500" y="69"/>
                    </a:lnTo>
                    <a:lnTo>
                      <a:pt x="1513" y="66"/>
                    </a:lnTo>
                    <a:lnTo>
                      <a:pt x="1526" y="57"/>
                    </a:lnTo>
                    <a:lnTo>
                      <a:pt x="1539" y="66"/>
                    </a:lnTo>
                    <a:lnTo>
                      <a:pt x="1551" y="86"/>
                    </a:lnTo>
                    <a:lnTo>
                      <a:pt x="1564" y="61"/>
                    </a:lnTo>
                    <a:lnTo>
                      <a:pt x="1577" y="57"/>
                    </a:lnTo>
                    <a:lnTo>
                      <a:pt x="1590" y="59"/>
                    </a:lnTo>
                    <a:lnTo>
                      <a:pt x="1603" y="58"/>
                    </a:lnTo>
                    <a:lnTo>
                      <a:pt x="1616" y="59"/>
                    </a:lnTo>
                    <a:lnTo>
                      <a:pt x="1628" y="59"/>
                    </a:lnTo>
                    <a:lnTo>
                      <a:pt x="1641" y="56"/>
                    </a:lnTo>
                    <a:lnTo>
                      <a:pt x="1654" y="55"/>
                    </a:lnTo>
                    <a:lnTo>
                      <a:pt x="1667" y="58"/>
                    </a:lnTo>
                    <a:lnTo>
                      <a:pt x="1680" y="59"/>
                    </a:lnTo>
                    <a:lnTo>
                      <a:pt x="1692" y="66"/>
                    </a:lnTo>
                    <a:lnTo>
                      <a:pt x="1705" y="69"/>
                    </a:lnTo>
                    <a:lnTo>
                      <a:pt x="1718" y="70"/>
                    </a:lnTo>
                    <a:lnTo>
                      <a:pt x="1731" y="71"/>
                    </a:lnTo>
                    <a:lnTo>
                      <a:pt x="1744" y="68"/>
                    </a:lnTo>
                    <a:lnTo>
                      <a:pt x="1757" y="66"/>
                    </a:lnTo>
                    <a:lnTo>
                      <a:pt x="1769" y="68"/>
                    </a:lnTo>
                    <a:lnTo>
                      <a:pt x="1782" y="62"/>
                    </a:lnTo>
                    <a:lnTo>
                      <a:pt x="1795" y="64"/>
                    </a:lnTo>
                    <a:lnTo>
                      <a:pt x="1808" y="85"/>
                    </a:lnTo>
                    <a:lnTo>
                      <a:pt x="1821" y="68"/>
                    </a:lnTo>
                    <a:lnTo>
                      <a:pt x="1834" y="53"/>
                    </a:lnTo>
                    <a:lnTo>
                      <a:pt x="1846" y="54"/>
                    </a:lnTo>
                    <a:lnTo>
                      <a:pt x="1859" y="50"/>
                    </a:lnTo>
                    <a:lnTo>
                      <a:pt x="1872" y="43"/>
                    </a:lnTo>
                    <a:lnTo>
                      <a:pt x="1885" y="53"/>
                    </a:lnTo>
                    <a:lnTo>
                      <a:pt x="1898" y="36"/>
                    </a:lnTo>
                    <a:lnTo>
                      <a:pt x="1911" y="38"/>
                    </a:lnTo>
                    <a:lnTo>
                      <a:pt x="1923" y="35"/>
                    </a:lnTo>
                    <a:lnTo>
                      <a:pt x="1936" y="35"/>
                    </a:lnTo>
                    <a:lnTo>
                      <a:pt x="1949" y="42"/>
                    </a:lnTo>
                    <a:lnTo>
                      <a:pt x="1962" y="38"/>
                    </a:lnTo>
                    <a:lnTo>
                      <a:pt x="1975" y="40"/>
                    </a:lnTo>
                    <a:lnTo>
                      <a:pt x="1988" y="34"/>
                    </a:lnTo>
                    <a:lnTo>
                      <a:pt x="2000" y="38"/>
                    </a:lnTo>
                    <a:lnTo>
                      <a:pt x="2013" y="41"/>
                    </a:lnTo>
                    <a:lnTo>
                      <a:pt x="2026" y="39"/>
                    </a:lnTo>
                    <a:lnTo>
                      <a:pt x="2039" y="35"/>
                    </a:lnTo>
                    <a:lnTo>
                      <a:pt x="2052" y="31"/>
                    </a:lnTo>
                    <a:lnTo>
                      <a:pt x="2065" y="24"/>
                    </a:lnTo>
                    <a:lnTo>
                      <a:pt x="2077" y="26"/>
                    </a:lnTo>
                    <a:lnTo>
                      <a:pt x="2090" y="19"/>
                    </a:lnTo>
                    <a:lnTo>
                      <a:pt x="2103" y="18"/>
                    </a:lnTo>
                    <a:lnTo>
                      <a:pt x="2116" y="26"/>
                    </a:lnTo>
                    <a:lnTo>
                      <a:pt x="2129" y="14"/>
                    </a:lnTo>
                    <a:lnTo>
                      <a:pt x="2142" y="17"/>
                    </a:lnTo>
                    <a:lnTo>
                      <a:pt x="2154" y="12"/>
                    </a:lnTo>
                    <a:lnTo>
                      <a:pt x="2167" y="16"/>
                    </a:lnTo>
                    <a:lnTo>
                      <a:pt x="2180" y="10"/>
                    </a:lnTo>
                    <a:lnTo>
                      <a:pt x="2193" y="43"/>
                    </a:lnTo>
                    <a:lnTo>
                      <a:pt x="2206" y="15"/>
                    </a:lnTo>
                    <a:lnTo>
                      <a:pt x="2219" y="30"/>
                    </a:lnTo>
                    <a:lnTo>
                      <a:pt x="2231" y="12"/>
                    </a:lnTo>
                    <a:lnTo>
                      <a:pt x="2244" y="7"/>
                    </a:lnTo>
                    <a:lnTo>
                      <a:pt x="2257" y="25"/>
                    </a:lnTo>
                    <a:lnTo>
                      <a:pt x="2270" y="20"/>
                    </a:lnTo>
                    <a:lnTo>
                      <a:pt x="2283" y="18"/>
                    </a:lnTo>
                    <a:lnTo>
                      <a:pt x="2296" y="31"/>
                    </a:lnTo>
                    <a:lnTo>
                      <a:pt x="2308" y="21"/>
                    </a:lnTo>
                    <a:lnTo>
                      <a:pt x="2321" y="49"/>
                    </a:lnTo>
                    <a:lnTo>
                      <a:pt x="2334" y="29"/>
                    </a:lnTo>
                    <a:lnTo>
                      <a:pt x="2347" y="32"/>
                    </a:lnTo>
                    <a:lnTo>
                      <a:pt x="2360" y="9"/>
                    </a:lnTo>
                    <a:lnTo>
                      <a:pt x="2373" y="18"/>
                    </a:lnTo>
                    <a:lnTo>
                      <a:pt x="2385" y="25"/>
                    </a:lnTo>
                    <a:lnTo>
                      <a:pt x="2398" y="8"/>
                    </a:lnTo>
                    <a:lnTo>
                      <a:pt x="2411" y="4"/>
                    </a:lnTo>
                    <a:lnTo>
                      <a:pt x="2424" y="5"/>
                    </a:lnTo>
                    <a:lnTo>
                      <a:pt x="2437" y="5"/>
                    </a:lnTo>
                    <a:lnTo>
                      <a:pt x="2449" y="13"/>
                    </a:lnTo>
                    <a:lnTo>
                      <a:pt x="2462" y="8"/>
                    </a:lnTo>
                    <a:lnTo>
                      <a:pt x="2475" y="9"/>
                    </a:lnTo>
                    <a:lnTo>
                      <a:pt x="2488" y="7"/>
                    </a:lnTo>
                    <a:lnTo>
                      <a:pt x="2501" y="12"/>
                    </a:lnTo>
                    <a:lnTo>
                      <a:pt x="2514" y="16"/>
                    </a:lnTo>
                    <a:lnTo>
                      <a:pt x="2526" y="19"/>
                    </a:lnTo>
                    <a:lnTo>
                      <a:pt x="2539" y="19"/>
                    </a:lnTo>
                    <a:lnTo>
                      <a:pt x="2552" y="25"/>
                    </a:lnTo>
                    <a:lnTo>
                      <a:pt x="2565" y="27"/>
                    </a:lnTo>
                    <a:lnTo>
                      <a:pt x="2578" y="32"/>
                    </a:lnTo>
                    <a:lnTo>
                      <a:pt x="2591" y="36"/>
                    </a:lnTo>
                    <a:lnTo>
                      <a:pt x="2603" y="41"/>
                    </a:lnTo>
                    <a:lnTo>
                      <a:pt x="2616" y="44"/>
                    </a:lnTo>
                    <a:lnTo>
                      <a:pt x="2629" y="48"/>
                    </a:lnTo>
                    <a:lnTo>
                      <a:pt x="2642" y="52"/>
                    </a:lnTo>
                    <a:lnTo>
                      <a:pt x="2655" y="46"/>
                    </a:lnTo>
                    <a:lnTo>
                      <a:pt x="2668" y="49"/>
                    </a:lnTo>
                    <a:lnTo>
                      <a:pt x="2680" y="45"/>
                    </a:lnTo>
                    <a:lnTo>
                      <a:pt x="2693" y="46"/>
                    </a:lnTo>
                    <a:lnTo>
                      <a:pt x="2706" y="43"/>
                    </a:lnTo>
                    <a:lnTo>
                      <a:pt x="2719" y="35"/>
                    </a:lnTo>
                    <a:lnTo>
                      <a:pt x="2732" y="34"/>
                    </a:lnTo>
                    <a:lnTo>
                      <a:pt x="2745" y="35"/>
                    </a:lnTo>
                    <a:lnTo>
                      <a:pt x="2757" y="29"/>
                    </a:lnTo>
                    <a:lnTo>
                      <a:pt x="2770" y="20"/>
                    </a:lnTo>
                    <a:lnTo>
                      <a:pt x="2783" y="16"/>
                    </a:lnTo>
                    <a:lnTo>
                      <a:pt x="2796" y="21"/>
                    </a:lnTo>
                    <a:lnTo>
                      <a:pt x="2809" y="19"/>
                    </a:lnTo>
                    <a:lnTo>
                      <a:pt x="2822" y="17"/>
                    </a:lnTo>
                    <a:lnTo>
                      <a:pt x="2834" y="11"/>
                    </a:lnTo>
                    <a:lnTo>
                      <a:pt x="2847" y="6"/>
                    </a:lnTo>
                    <a:lnTo>
                      <a:pt x="2860" y="11"/>
                    </a:lnTo>
                    <a:lnTo>
                      <a:pt x="2873" y="4"/>
                    </a:lnTo>
                    <a:lnTo>
                      <a:pt x="2886" y="2"/>
                    </a:lnTo>
                    <a:lnTo>
                      <a:pt x="2899" y="4"/>
                    </a:lnTo>
                    <a:lnTo>
                      <a:pt x="2911" y="6"/>
                    </a:lnTo>
                    <a:lnTo>
                      <a:pt x="2924" y="9"/>
                    </a:lnTo>
                    <a:lnTo>
                      <a:pt x="2937" y="5"/>
                    </a:lnTo>
                    <a:lnTo>
                      <a:pt x="2950" y="7"/>
                    </a:lnTo>
                    <a:lnTo>
                      <a:pt x="2963" y="8"/>
                    </a:lnTo>
                    <a:lnTo>
                      <a:pt x="2976" y="1"/>
                    </a:lnTo>
                    <a:lnTo>
                      <a:pt x="2988" y="5"/>
                    </a:lnTo>
                    <a:lnTo>
                      <a:pt x="3001" y="5"/>
                    </a:lnTo>
                    <a:lnTo>
                      <a:pt x="3014" y="3"/>
                    </a:lnTo>
                    <a:lnTo>
                      <a:pt x="3027" y="2"/>
                    </a:lnTo>
                    <a:lnTo>
                      <a:pt x="3040" y="0"/>
                    </a:lnTo>
                    <a:lnTo>
                      <a:pt x="3053" y="3"/>
                    </a:lnTo>
                    <a:lnTo>
                      <a:pt x="3065" y="6"/>
                    </a:lnTo>
                    <a:lnTo>
                      <a:pt x="3078" y="6"/>
                    </a:lnTo>
                    <a:lnTo>
                      <a:pt x="3091" y="5"/>
                    </a:lnTo>
                    <a:lnTo>
                      <a:pt x="3104" y="7"/>
                    </a:lnTo>
                    <a:lnTo>
                      <a:pt x="3117" y="7"/>
                    </a:lnTo>
                    <a:lnTo>
                      <a:pt x="3130" y="6"/>
                    </a:lnTo>
                    <a:lnTo>
                      <a:pt x="3142" y="9"/>
                    </a:lnTo>
                    <a:lnTo>
                      <a:pt x="3155" y="8"/>
                    </a:lnTo>
                    <a:lnTo>
                      <a:pt x="3168" y="9"/>
                    </a:lnTo>
                    <a:lnTo>
                      <a:pt x="3181" y="14"/>
                    </a:lnTo>
                    <a:lnTo>
                      <a:pt x="3194" y="7"/>
                    </a:lnTo>
                    <a:lnTo>
                      <a:pt x="3207" y="10"/>
                    </a:lnTo>
                    <a:lnTo>
                      <a:pt x="3219" y="13"/>
                    </a:lnTo>
                    <a:lnTo>
                      <a:pt x="3232" y="9"/>
                    </a:lnTo>
                    <a:lnTo>
                      <a:pt x="3245" y="12"/>
                    </a:lnTo>
                    <a:lnTo>
                      <a:pt x="3258" y="9"/>
                    </a:lnTo>
                    <a:lnTo>
                      <a:pt x="3271" y="20"/>
                    </a:lnTo>
                    <a:lnTo>
                      <a:pt x="3283" y="19"/>
                    </a:lnTo>
                    <a:lnTo>
                      <a:pt x="3296" y="18"/>
                    </a:lnTo>
                    <a:lnTo>
                      <a:pt x="3309" y="23"/>
                    </a:lnTo>
                    <a:lnTo>
                      <a:pt x="3322" y="28"/>
                    </a:lnTo>
                    <a:lnTo>
                      <a:pt x="3335" y="29"/>
                    </a:lnTo>
                    <a:lnTo>
                      <a:pt x="3348" y="33"/>
                    </a:lnTo>
                    <a:lnTo>
                      <a:pt x="3360" y="36"/>
                    </a:lnTo>
                    <a:lnTo>
                      <a:pt x="3373" y="41"/>
                    </a:lnTo>
                    <a:lnTo>
                      <a:pt x="3386" y="41"/>
                    </a:lnTo>
                    <a:lnTo>
                      <a:pt x="3399" y="44"/>
                    </a:lnTo>
                    <a:lnTo>
                      <a:pt x="3412" y="43"/>
                    </a:lnTo>
                    <a:lnTo>
                      <a:pt x="3425" y="50"/>
                    </a:lnTo>
                    <a:lnTo>
                      <a:pt x="3437" y="57"/>
                    </a:lnTo>
                    <a:lnTo>
                      <a:pt x="3450" y="63"/>
                    </a:lnTo>
                    <a:lnTo>
                      <a:pt x="3463" y="59"/>
                    </a:lnTo>
                    <a:lnTo>
                      <a:pt x="3476" y="64"/>
                    </a:lnTo>
                    <a:lnTo>
                      <a:pt x="3489" y="71"/>
                    </a:lnTo>
                    <a:lnTo>
                      <a:pt x="3502" y="71"/>
                    </a:lnTo>
                    <a:lnTo>
                      <a:pt x="3514" y="85"/>
                    </a:lnTo>
                    <a:lnTo>
                      <a:pt x="3527" y="77"/>
                    </a:lnTo>
                    <a:lnTo>
                      <a:pt x="3540" y="92"/>
                    </a:lnTo>
                    <a:lnTo>
                      <a:pt x="3553" y="117"/>
                    </a:lnTo>
                    <a:lnTo>
                      <a:pt x="3566" y="117"/>
                    </a:lnTo>
                    <a:lnTo>
                      <a:pt x="3579" y="119"/>
                    </a:lnTo>
                    <a:lnTo>
                      <a:pt x="3591" y="116"/>
                    </a:lnTo>
                    <a:lnTo>
                      <a:pt x="3604" y="105"/>
                    </a:lnTo>
                    <a:lnTo>
                      <a:pt x="3617" y="103"/>
                    </a:lnTo>
                    <a:lnTo>
                      <a:pt x="3630" y="114"/>
                    </a:lnTo>
                    <a:lnTo>
                      <a:pt x="3643" y="86"/>
                    </a:lnTo>
                    <a:lnTo>
                      <a:pt x="3656" y="82"/>
                    </a:lnTo>
                    <a:lnTo>
                      <a:pt x="3668" y="86"/>
                    </a:lnTo>
                    <a:lnTo>
                      <a:pt x="3681" y="53"/>
                    </a:lnTo>
                    <a:lnTo>
                      <a:pt x="3694" y="51"/>
                    </a:lnTo>
                    <a:lnTo>
                      <a:pt x="3707" y="48"/>
                    </a:lnTo>
                    <a:lnTo>
                      <a:pt x="3720" y="36"/>
                    </a:lnTo>
                    <a:lnTo>
                      <a:pt x="3733" y="36"/>
                    </a:lnTo>
                    <a:lnTo>
                      <a:pt x="3745" y="30"/>
                    </a:lnTo>
                    <a:lnTo>
                      <a:pt x="3758" y="29"/>
                    </a:lnTo>
                    <a:lnTo>
                      <a:pt x="3771" y="24"/>
                    </a:lnTo>
                    <a:lnTo>
                      <a:pt x="3784" y="24"/>
                    </a:lnTo>
                    <a:lnTo>
                      <a:pt x="3797" y="25"/>
                    </a:lnTo>
                    <a:lnTo>
                      <a:pt x="3810" y="18"/>
                    </a:lnTo>
                    <a:lnTo>
                      <a:pt x="3822" y="19"/>
                    </a:lnTo>
                    <a:lnTo>
                      <a:pt x="3835" y="21"/>
                    </a:lnTo>
                    <a:lnTo>
                      <a:pt x="3848" y="14"/>
                    </a:lnTo>
                    <a:lnTo>
                      <a:pt x="3861" y="17"/>
                    </a:lnTo>
                    <a:lnTo>
                      <a:pt x="3874" y="11"/>
                    </a:lnTo>
                    <a:lnTo>
                      <a:pt x="3887" y="16"/>
                    </a:lnTo>
                    <a:lnTo>
                      <a:pt x="3899" y="14"/>
                    </a:lnTo>
                    <a:lnTo>
                      <a:pt x="3912" y="21"/>
                    </a:lnTo>
                    <a:lnTo>
                      <a:pt x="3925" y="15"/>
                    </a:lnTo>
                    <a:lnTo>
                      <a:pt x="3938" y="20"/>
                    </a:lnTo>
                    <a:lnTo>
                      <a:pt x="3951" y="14"/>
                    </a:lnTo>
                    <a:lnTo>
                      <a:pt x="3964" y="19"/>
                    </a:lnTo>
                    <a:lnTo>
                      <a:pt x="3976" y="31"/>
                    </a:lnTo>
                    <a:lnTo>
                      <a:pt x="3989" y="19"/>
                    </a:lnTo>
                    <a:lnTo>
                      <a:pt x="4002" y="39"/>
                    </a:lnTo>
                    <a:lnTo>
                      <a:pt x="4015" y="47"/>
                    </a:lnTo>
                    <a:lnTo>
                      <a:pt x="4028" y="36"/>
                    </a:lnTo>
                    <a:lnTo>
                      <a:pt x="4041" y="37"/>
                    </a:lnTo>
                    <a:lnTo>
                      <a:pt x="4053" y="39"/>
                    </a:lnTo>
                    <a:lnTo>
                      <a:pt x="4066" y="33"/>
                    </a:lnTo>
                    <a:lnTo>
                      <a:pt x="4079" y="29"/>
                    </a:lnTo>
                    <a:lnTo>
                      <a:pt x="4092" y="53"/>
                    </a:lnTo>
                    <a:lnTo>
                      <a:pt x="4105" y="43"/>
                    </a:lnTo>
                    <a:lnTo>
                      <a:pt x="4117" y="29"/>
                    </a:lnTo>
                    <a:lnTo>
                      <a:pt x="4130" y="51"/>
                    </a:lnTo>
                    <a:lnTo>
                      <a:pt x="4143" y="44"/>
                    </a:lnTo>
                    <a:lnTo>
                      <a:pt x="4156" y="39"/>
                    </a:lnTo>
                    <a:lnTo>
                      <a:pt x="4169" y="22"/>
                    </a:lnTo>
                    <a:lnTo>
                      <a:pt x="4182" y="23"/>
                    </a:lnTo>
                    <a:lnTo>
                      <a:pt x="4194" y="31"/>
                    </a:lnTo>
                    <a:lnTo>
                      <a:pt x="4207" y="27"/>
                    </a:lnTo>
                    <a:lnTo>
                      <a:pt x="4220" y="48"/>
                    </a:lnTo>
                    <a:lnTo>
                      <a:pt x="4233" y="68"/>
                    </a:lnTo>
                    <a:lnTo>
                      <a:pt x="4246" y="65"/>
                    </a:lnTo>
                    <a:lnTo>
                      <a:pt x="4259" y="44"/>
                    </a:lnTo>
                    <a:lnTo>
                      <a:pt x="4271" y="39"/>
                    </a:lnTo>
                    <a:lnTo>
                      <a:pt x="4284" y="46"/>
                    </a:lnTo>
                    <a:lnTo>
                      <a:pt x="4297" y="39"/>
                    </a:lnTo>
                    <a:lnTo>
                      <a:pt x="4310" y="38"/>
                    </a:lnTo>
                    <a:lnTo>
                      <a:pt x="4323" y="29"/>
                    </a:lnTo>
                    <a:lnTo>
                      <a:pt x="4336" y="27"/>
                    </a:lnTo>
                    <a:lnTo>
                      <a:pt x="4348" y="56"/>
                    </a:lnTo>
                    <a:lnTo>
                      <a:pt x="4361" y="63"/>
                    </a:lnTo>
                    <a:lnTo>
                      <a:pt x="4374" y="38"/>
                    </a:lnTo>
                    <a:lnTo>
                      <a:pt x="4387" y="29"/>
                    </a:lnTo>
                    <a:lnTo>
                      <a:pt x="4400" y="46"/>
                    </a:lnTo>
                    <a:lnTo>
                      <a:pt x="4413" y="53"/>
                    </a:lnTo>
                    <a:lnTo>
                      <a:pt x="4425" y="96"/>
                    </a:lnTo>
                    <a:lnTo>
                      <a:pt x="4438" y="196"/>
                    </a:lnTo>
                    <a:lnTo>
                      <a:pt x="4451" y="390"/>
                    </a:lnTo>
                    <a:lnTo>
                      <a:pt x="4464" y="849"/>
                    </a:lnTo>
                    <a:lnTo>
                      <a:pt x="4477" y="1416"/>
                    </a:lnTo>
                    <a:lnTo>
                      <a:pt x="4490" y="1983"/>
                    </a:lnTo>
                    <a:lnTo>
                      <a:pt x="4502" y="2537"/>
                    </a:lnTo>
                    <a:lnTo>
                      <a:pt x="4515" y="3038"/>
                    </a:lnTo>
                    <a:lnTo>
                      <a:pt x="4528" y="3567"/>
                    </a:lnTo>
                    <a:lnTo>
                      <a:pt x="4541" y="4101"/>
                    </a:lnTo>
                    <a:lnTo>
                      <a:pt x="4554" y="4762"/>
                    </a:lnTo>
                    <a:lnTo>
                      <a:pt x="4567" y="5454"/>
                    </a:lnTo>
                    <a:lnTo>
                      <a:pt x="4579" y="5657"/>
                    </a:lnTo>
                    <a:lnTo>
                      <a:pt x="4592" y="5955"/>
                    </a:lnTo>
                    <a:lnTo>
                      <a:pt x="4605" y="5921"/>
                    </a:lnTo>
                    <a:lnTo>
                      <a:pt x="4618" y="5374"/>
                    </a:lnTo>
                    <a:lnTo>
                      <a:pt x="4631" y="4251"/>
                    </a:lnTo>
                    <a:lnTo>
                      <a:pt x="4644" y="3110"/>
                    </a:lnTo>
                    <a:lnTo>
                      <a:pt x="4656" y="2246"/>
                    </a:lnTo>
                    <a:lnTo>
                      <a:pt x="4669" y="1717"/>
                    </a:lnTo>
                    <a:lnTo>
                      <a:pt x="4682" y="1240"/>
                    </a:lnTo>
                    <a:lnTo>
                      <a:pt x="4695" y="923"/>
                    </a:lnTo>
                    <a:lnTo>
                      <a:pt x="4708" y="835"/>
                    </a:lnTo>
                    <a:lnTo>
                      <a:pt x="4721" y="672"/>
                    </a:lnTo>
                    <a:lnTo>
                      <a:pt x="4733" y="618"/>
                    </a:lnTo>
                    <a:lnTo>
                      <a:pt x="4746" y="492"/>
                    </a:lnTo>
                    <a:lnTo>
                      <a:pt x="4759" y="466"/>
                    </a:lnTo>
                    <a:lnTo>
                      <a:pt x="4772" y="472"/>
                    </a:lnTo>
                    <a:lnTo>
                      <a:pt x="4785" y="369"/>
                    </a:lnTo>
                    <a:lnTo>
                      <a:pt x="4798" y="338"/>
                    </a:lnTo>
                    <a:lnTo>
                      <a:pt x="4810" y="299"/>
                    </a:lnTo>
                    <a:lnTo>
                      <a:pt x="4823" y="405"/>
                    </a:lnTo>
                    <a:lnTo>
                      <a:pt x="4836" y="401"/>
                    </a:lnTo>
                    <a:lnTo>
                      <a:pt x="4849" y="393"/>
                    </a:lnTo>
                    <a:lnTo>
                      <a:pt x="4862" y="361"/>
                    </a:lnTo>
                    <a:lnTo>
                      <a:pt x="4874" y="338"/>
                    </a:lnTo>
                    <a:lnTo>
                      <a:pt x="4887" y="321"/>
                    </a:lnTo>
                    <a:lnTo>
                      <a:pt x="4900" y="279"/>
                    </a:lnTo>
                    <a:lnTo>
                      <a:pt x="4913" y="253"/>
                    </a:lnTo>
                    <a:lnTo>
                      <a:pt x="4926" y="229"/>
                    </a:lnTo>
                    <a:lnTo>
                      <a:pt x="4939" y="215"/>
                    </a:lnTo>
                    <a:lnTo>
                      <a:pt x="4951" y="210"/>
                    </a:lnTo>
                    <a:lnTo>
                      <a:pt x="4964" y="200"/>
                    </a:lnTo>
                    <a:lnTo>
                      <a:pt x="4977" y="190"/>
                    </a:lnTo>
                    <a:lnTo>
                      <a:pt x="4990" y="177"/>
                    </a:lnTo>
                    <a:lnTo>
                      <a:pt x="5003" y="174"/>
                    </a:lnTo>
                    <a:lnTo>
                      <a:pt x="5016" y="145"/>
                    </a:lnTo>
                    <a:lnTo>
                      <a:pt x="5028" y="201"/>
                    </a:lnTo>
                    <a:lnTo>
                      <a:pt x="5041" y="226"/>
                    </a:lnTo>
                    <a:lnTo>
                      <a:pt x="5054" y="205"/>
                    </a:lnTo>
                    <a:lnTo>
                      <a:pt x="5067" y="181"/>
                    </a:lnTo>
                    <a:lnTo>
                      <a:pt x="5080" y="171"/>
                    </a:lnTo>
                    <a:lnTo>
                      <a:pt x="5093" y="179"/>
                    </a:lnTo>
                    <a:lnTo>
                      <a:pt x="5105" y="164"/>
                    </a:lnTo>
                    <a:lnTo>
                      <a:pt x="5118" y="146"/>
                    </a:lnTo>
                    <a:lnTo>
                      <a:pt x="5131" y="210"/>
                    </a:lnTo>
                    <a:lnTo>
                      <a:pt x="5144" y="191"/>
                    </a:lnTo>
                    <a:lnTo>
                      <a:pt x="5157" y="182"/>
                    </a:lnTo>
                    <a:lnTo>
                      <a:pt x="5170" y="190"/>
                    </a:lnTo>
                    <a:lnTo>
                      <a:pt x="5182" y="193"/>
                    </a:lnTo>
                    <a:lnTo>
                      <a:pt x="5195" y="202"/>
                    </a:lnTo>
                    <a:lnTo>
                      <a:pt x="5208" y="198"/>
                    </a:lnTo>
                    <a:lnTo>
                      <a:pt x="5221" y="248"/>
                    </a:lnTo>
                    <a:lnTo>
                      <a:pt x="5234" y="201"/>
                    </a:lnTo>
                    <a:lnTo>
                      <a:pt x="5247" y="192"/>
                    </a:lnTo>
                    <a:lnTo>
                      <a:pt x="5259" y="196"/>
                    </a:lnTo>
                    <a:lnTo>
                      <a:pt x="5272" y="199"/>
                    </a:lnTo>
                    <a:lnTo>
                      <a:pt x="5285" y="177"/>
                    </a:lnTo>
                    <a:lnTo>
                      <a:pt x="5298" y="170"/>
                    </a:lnTo>
                    <a:lnTo>
                      <a:pt x="5311" y="170"/>
                    </a:lnTo>
                    <a:lnTo>
                      <a:pt x="5324" y="151"/>
                    </a:lnTo>
                    <a:lnTo>
                      <a:pt x="5336" y="144"/>
                    </a:lnTo>
                    <a:lnTo>
                      <a:pt x="5349" y="134"/>
                    </a:lnTo>
                    <a:lnTo>
                      <a:pt x="5362" y="237"/>
                    </a:lnTo>
                    <a:lnTo>
                      <a:pt x="5375" y="252"/>
                    </a:lnTo>
                    <a:lnTo>
                      <a:pt x="5388" y="270"/>
                    </a:lnTo>
                    <a:lnTo>
                      <a:pt x="5401" y="274"/>
                    </a:lnTo>
                    <a:lnTo>
                      <a:pt x="5413" y="268"/>
                    </a:lnTo>
                    <a:lnTo>
                      <a:pt x="5426" y="263"/>
                    </a:lnTo>
                    <a:lnTo>
                      <a:pt x="5439" y="264"/>
                    </a:lnTo>
                    <a:lnTo>
                      <a:pt x="5452" y="287"/>
                    </a:lnTo>
                    <a:lnTo>
                      <a:pt x="5465" y="294"/>
                    </a:lnTo>
                    <a:lnTo>
                      <a:pt x="5478" y="307"/>
                    </a:lnTo>
                    <a:lnTo>
                      <a:pt x="5490" y="330"/>
                    </a:lnTo>
                    <a:lnTo>
                      <a:pt x="5503" y="350"/>
                    </a:lnTo>
                    <a:lnTo>
                      <a:pt x="5516" y="363"/>
                    </a:lnTo>
                    <a:lnTo>
                      <a:pt x="5529" y="404"/>
                    </a:lnTo>
                    <a:lnTo>
                      <a:pt x="5542" y="408"/>
                    </a:lnTo>
                    <a:lnTo>
                      <a:pt x="5555" y="445"/>
                    </a:lnTo>
                    <a:lnTo>
                      <a:pt x="5567" y="475"/>
                    </a:lnTo>
                    <a:lnTo>
                      <a:pt x="5580" y="494"/>
                    </a:lnTo>
                    <a:lnTo>
                      <a:pt x="5593" y="482"/>
                    </a:lnTo>
                    <a:lnTo>
                      <a:pt x="5606" y="456"/>
                    </a:lnTo>
                    <a:lnTo>
                      <a:pt x="5619" y="433"/>
                    </a:lnTo>
                    <a:lnTo>
                      <a:pt x="5632" y="387"/>
                    </a:lnTo>
                    <a:lnTo>
                      <a:pt x="5644" y="335"/>
                    </a:lnTo>
                    <a:lnTo>
                      <a:pt x="5657" y="299"/>
                    </a:lnTo>
                    <a:lnTo>
                      <a:pt x="5670" y="259"/>
                    </a:lnTo>
                    <a:lnTo>
                      <a:pt x="5683" y="252"/>
                    </a:lnTo>
                    <a:lnTo>
                      <a:pt x="5696" y="228"/>
                    </a:lnTo>
                    <a:lnTo>
                      <a:pt x="5708" y="229"/>
                    </a:lnTo>
                    <a:lnTo>
                      <a:pt x="5721" y="236"/>
                    </a:lnTo>
                    <a:lnTo>
                      <a:pt x="5734" y="213"/>
                    </a:lnTo>
                    <a:lnTo>
                      <a:pt x="5747" y="205"/>
                    </a:lnTo>
                    <a:lnTo>
                      <a:pt x="5760" y="197"/>
                    </a:lnTo>
                    <a:lnTo>
                      <a:pt x="5773" y="195"/>
                    </a:lnTo>
                    <a:lnTo>
                      <a:pt x="5785" y="193"/>
                    </a:lnTo>
                    <a:lnTo>
                      <a:pt x="5798" y="179"/>
                    </a:lnTo>
                    <a:lnTo>
                      <a:pt x="5811" y="173"/>
                    </a:lnTo>
                    <a:lnTo>
                      <a:pt x="5824" y="172"/>
                    </a:lnTo>
                    <a:lnTo>
                      <a:pt x="5837" y="173"/>
                    </a:lnTo>
                    <a:lnTo>
                      <a:pt x="5850" y="162"/>
                    </a:lnTo>
                    <a:lnTo>
                      <a:pt x="5862" y="146"/>
                    </a:lnTo>
                    <a:lnTo>
                      <a:pt x="5875" y="154"/>
                    </a:lnTo>
                    <a:lnTo>
                      <a:pt x="5888" y="152"/>
                    </a:lnTo>
                    <a:lnTo>
                      <a:pt x="5901" y="151"/>
                    </a:lnTo>
                    <a:lnTo>
                      <a:pt x="5914" y="149"/>
                    </a:lnTo>
                    <a:lnTo>
                      <a:pt x="5927" y="157"/>
                    </a:lnTo>
                    <a:lnTo>
                      <a:pt x="5939" y="153"/>
                    </a:lnTo>
                    <a:lnTo>
                      <a:pt x="5952" y="155"/>
                    </a:lnTo>
                    <a:lnTo>
                      <a:pt x="5965" y="154"/>
                    </a:lnTo>
                    <a:lnTo>
                      <a:pt x="5978" y="156"/>
                    </a:lnTo>
                    <a:lnTo>
                      <a:pt x="5991" y="171"/>
                    </a:lnTo>
                    <a:lnTo>
                      <a:pt x="6004" y="175"/>
                    </a:lnTo>
                    <a:lnTo>
                      <a:pt x="6016" y="185"/>
                    </a:lnTo>
                    <a:lnTo>
                      <a:pt x="6029" y="200"/>
                    </a:lnTo>
                    <a:lnTo>
                      <a:pt x="6042" y="207"/>
                    </a:lnTo>
                    <a:lnTo>
                      <a:pt x="6055" y="238"/>
                    </a:lnTo>
                    <a:lnTo>
                      <a:pt x="6068" y="262"/>
                    </a:lnTo>
                    <a:lnTo>
                      <a:pt x="6081" y="287"/>
                    </a:lnTo>
                    <a:lnTo>
                      <a:pt x="6093" y="313"/>
                    </a:lnTo>
                    <a:lnTo>
                      <a:pt x="6106" y="318"/>
                    </a:lnTo>
                    <a:lnTo>
                      <a:pt x="6119" y="340"/>
                    </a:lnTo>
                    <a:lnTo>
                      <a:pt x="6132" y="345"/>
                    </a:lnTo>
                    <a:lnTo>
                      <a:pt x="6145" y="366"/>
                    </a:lnTo>
                    <a:lnTo>
                      <a:pt x="6158" y="382"/>
                    </a:lnTo>
                    <a:lnTo>
                      <a:pt x="6170" y="415"/>
                    </a:lnTo>
                    <a:lnTo>
                      <a:pt x="6183" y="433"/>
                    </a:lnTo>
                    <a:lnTo>
                      <a:pt x="6196" y="453"/>
                    </a:lnTo>
                    <a:lnTo>
                      <a:pt x="6209" y="449"/>
                    </a:lnTo>
                    <a:lnTo>
                      <a:pt x="6222" y="430"/>
                    </a:lnTo>
                    <a:lnTo>
                      <a:pt x="6235" y="423"/>
                    </a:lnTo>
                    <a:lnTo>
                      <a:pt x="6247" y="412"/>
                    </a:lnTo>
                    <a:lnTo>
                      <a:pt x="6260" y="404"/>
                    </a:lnTo>
                    <a:lnTo>
                      <a:pt x="6273" y="389"/>
                    </a:lnTo>
                    <a:lnTo>
                      <a:pt x="6286" y="402"/>
                    </a:lnTo>
                    <a:lnTo>
                      <a:pt x="6299" y="412"/>
                    </a:lnTo>
                    <a:lnTo>
                      <a:pt x="6312" y="429"/>
                    </a:lnTo>
                    <a:lnTo>
                      <a:pt x="6324" y="467"/>
                    </a:lnTo>
                    <a:lnTo>
                      <a:pt x="6337" y="495"/>
                    </a:lnTo>
                    <a:lnTo>
                      <a:pt x="6350" y="538"/>
                    </a:lnTo>
                    <a:lnTo>
                      <a:pt x="6363" y="576"/>
                    </a:lnTo>
                    <a:lnTo>
                      <a:pt x="6376" y="608"/>
                    </a:lnTo>
                    <a:lnTo>
                      <a:pt x="6389" y="631"/>
                    </a:lnTo>
                    <a:lnTo>
                      <a:pt x="6401" y="683"/>
                    </a:lnTo>
                    <a:lnTo>
                      <a:pt x="6414" y="742"/>
                    </a:lnTo>
                    <a:lnTo>
                      <a:pt x="6427" y="802"/>
                    </a:lnTo>
                    <a:lnTo>
                      <a:pt x="6440" y="848"/>
                    </a:lnTo>
                    <a:lnTo>
                      <a:pt x="6453" y="880"/>
                    </a:lnTo>
                    <a:lnTo>
                      <a:pt x="6466" y="856"/>
                    </a:lnTo>
                    <a:lnTo>
                      <a:pt x="6478" y="793"/>
                    </a:lnTo>
                    <a:lnTo>
                      <a:pt x="6491" y="714"/>
                    </a:lnTo>
                    <a:lnTo>
                      <a:pt x="6504" y="613"/>
                    </a:lnTo>
                    <a:lnTo>
                      <a:pt x="6517" y="510"/>
                    </a:lnTo>
                    <a:lnTo>
                      <a:pt x="6530" y="431"/>
                    </a:lnTo>
                    <a:lnTo>
                      <a:pt x="6542" y="380"/>
                    </a:lnTo>
                    <a:lnTo>
                      <a:pt x="6555" y="378"/>
                    </a:lnTo>
                    <a:lnTo>
                      <a:pt x="6568" y="335"/>
                    </a:lnTo>
                    <a:lnTo>
                      <a:pt x="6581" y="313"/>
                    </a:lnTo>
                    <a:lnTo>
                      <a:pt x="6594" y="348"/>
                    </a:lnTo>
                    <a:lnTo>
                      <a:pt x="6607" y="340"/>
                    </a:lnTo>
                    <a:lnTo>
                      <a:pt x="6619" y="320"/>
                    </a:lnTo>
                    <a:lnTo>
                      <a:pt x="6632" y="304"/>
                    </a:lnTo>
                    <a:lnTo>
                      <a:pt x="6645" y="285"/>
                    </a:lnTo>
                    <a:lnTo>
                      <a:pt x="6658" y="287"/>
                    </a:lnTo>
                    <a:lnTo>
                      <a:pt x="6671" y="271"/>
                    </a:lnTo>
                    <a:lnTo>
                      <a:pt x="6684" y="276"/>
                    </a:lnTo>
                    <a:lnTo>
                      <a:pt x="6696" y="268"/>
                    </a:lnTo>
                    <a:lnTo>
                      <a:pt x="6709" y="265"/>
                    </a:lnTo>
                    <a:lnTo>
                      <a:pt x="6722" y="262"/>
                    </a:lnTo>
                    <a:lnTo>
                      <a:pt x="6735" y="287"/>
                    </a:lnTo>
                    <a:lnTo>
                      <a:pt x="6748" y="263"/>
                    </a:lnTo>
                    <a:lnTo>
                      <a:pt x="6761" y="265"/>
                    </a:lnTo>
                    <a:lnTo>
                      <a:pt x="6773" y="260"/>
                    </a:lnTo>
                    <a:lnTo>
                      <a:pt x="6786" y="250"/>
                    </a:lnTo>
                    <a:lnTo>
                      <a:pt x="6799" y="235"/>
                    </a:lnTo>
                    <a:lnTo>
                      <a:pt x="6812" y="247"/>
                    </a:lnTo>
                    <a:lnTo>
                      <a:pt x="6825" y="243"/>
                    </a:lnTo>
                    <a:lnTo>
                      <a:pt x="6838" y="238"/>
                    </a:lnTo>
                    <a:lnTo>
                      <a:pt x="6850" y="317"/>
                    </a:lnTo>
                    <a:lnTo>
                      <a:pt x="6863" y="329"/>
                    </a:lnTo>
                    <a:lnTo>
                      <a:pt x="6876" y="326"/>
                    </a:lnTo>
                    <a:lnTo>
                      <a:pt x="6889" y="329"/>
                    </a:lnTo>
                    <a:lnTo>
                      <a:pt x="6902" y="316"/>
                    </a:lnTo>
                    <a:lnTo>
                      <a:pt x="6915" y="271"/>
                    </a:lnTo>
                    <a:lnTo>
                      <a:pt x="6927" y="260"/>
                    </a:lnTo>
                    <a:lnTo>
                      <a:pt x="6940" y="243"/>
                    </a:lnTo>
                    <a:lnTo>
                      <a:pt x="6953" y="233"/>
                    </a:lnTo>
                    <a:lnTo>
                      <a:pt x="6966" y="231"/>
                    </a:lnTo>
                    <a:lnTo>
                      <a:pt x="6979" y="212"/>
                    </a:lnTo>
                    <a:lnTo>
                      <a:pt x="6992" y="242"/>
                    </a:lnTo>
                    <a:lnTo>
                      <a:pt x="7004" y="209"/>
                    </a:lnTo>
                    <a:lnTo>
                      <a:pt x="7017" y="196"/>
                    </a:lnTo>
                    <a:lnTo>
                      <a:pt x="7030" y="213"/>
                    </a:lnTo>
                    <a:lnTo>
                      <a:pt x="7043" y="225"/>
                    </a:lnTo>
                    <a:lnTo>
                      <a:pt x="7056" y="279"/>
                    </a:lnTo>
                    <a:lnTo>
                      <a:pt x="7069" y="329"/>
                    </a:lnTo>
                    <a:lnTo>
                      <a:pt x="7081" y="432"/>
                    </a:lnTo>
                    <a:lnTo>
                      <a:pt x="7094" y="459"/>
                    </a:lnTo>
                    <a:lnTo>
                      <a:pt x="7107" y="449"/>
                    </a:lnTo>
                    <a:lnTo>
                      <a:pt x="7120" y="438"/>
                    </a:lnTo>
                    <a:lnTo>
                      <a:pt x="7133" y="414"/>
                    </a:lnTo>
                    <a:lnTo>
                      <a:pt x="7146" y="358"/>
                    </a:lnTo>
                    <a:lnTo>
                      <a:pt x="7158" y="301"/>
                    </a:lnTo>
                    <a:lnTo>
                      <a:pt x="7171" y="258"/>
                    </a:lnTo>
                    <a:lnTo>
                      <a:pt x="7184" y="231"/>
                    </a:lnTo>
                    <a:lnTo>
                      <a:pt x="7197" y="198"/>
                    </a:lnTo>
                    <a:lnTo>
                      <a:pt x="7210" y="186"/>
                    </a:lnTo>
                    <a:lnTo>
                      <a:pt x="7223" y="170"/>
                    </a:lnTo>
                    <a:lnTo>
                      <a:pt x="7235" y="152"/>
                    </a:lnTo>
                    <a:lnTo>
                      <a:pt x="7248" y="148"/>
                    </a:lnTo>
                    <a:lnTo>
                      <a:pt x="7261" y="153"/>
                    </a:lnTo>
                    <a:lnTo>
                      <a:pt x="7274" y="145"/>
                    </a:lnTo>
                    <a:lnTo>
                      <a:pt x="7287" y="158"/>
                    </a:lnTo>
                    <a:lnTo>
                      <a:pt x="7299" y="166"/>
                    </a:lnTo>
                    <a:lnTo>
                      <a:pt x="7312" y="165"/>
                    </a:lnTo>
                    <a:lnTo>
                      <a:pt x="7325" y="183"/>
                    </a:lnTo>
                    <a:lnTo>
                      <a:pt x="7338" y="187"/>
                    </a:lnTo>
                    <a:lnTo>
                      <a:pt x="7351" y="188"/>
                    </a:lnTo>
                    <a:lnTo>
                      <a:pt x="7364" y="196"/>
                    </a:lnTo>
                    <a:lnTo>
                      <a:pt x="7376" y="204"/>
                    </a:lnTo>
                    <a:lnTo>
                      <a:pt x="7389" y="204"/>
                    </a:lnTo>
                    <a:lnTo>
                      <a:pt x="7402" y="217"/>
                    </a:lnTo>
                    <a:lnTo>
                      <a:pt x="7415" y="234"/>
                    </a:lnTo>
                    <a:lnTo>
                      <a:pt x="7428" y="243"/>
                    </a:lnTo>
                    <a:lnTo>
                      <a:pt x="7441" y="267"/>
                    </a:lnTo>
                    <a:lnTo>
                      <a:pt x="7453" y="252"/>
                    </a:lnTo>
                    <a:lnTo>
                      <a:pt x="7466" y="234"/>
                    </a:lnTo>
                    <a:lnTo>
                      <a:pt x="7479" y="203"/>
                    </a:lnTo>
                    <a:lnTo>
                      <a:pt x="7492" y="187"/>
                    </a:lnTo>
                    <a:lnTo>
                      <a:pt x="7505" y="171"/>
                    </a:lnTo>
                    <a:lnTo>
                      <a:pt x="7518" y="157"/>
                    </a:lnTo>
                    <a:lnTo>
                      <a:pt x="7530" y="135"/>
                    </a:lnTo>
                    <a:lnTo>
                      <a:pt x="7543" y="134"/>
                    </a:lnTo>
                    <a:lnTo>
                      <a:pt x="7556" y="123"/>
                    </a:lnTo>
                    <a:lnTo>
                      <a:pt x="7569" y="117"/>
                    </a:lnTo>
                    <a:lnTo>
                      <a:pt x="7582" y="112"/>
                    </a:lnTo>
                    <a:lnTo>
                      <a:pt x="7595" y="109"/>
                    </a:lnTo>
                    <a:lnTo>
                      <a:pt x="7607" y="101"/>
                    </a:lnTo>
                    <a:lnTo>
                      <a:pt x="7620" y="105"/>
                    </a:lnTo>
                    <a:lnTo>
                      <a:pt x="7633" y="104"/>
                    </a:lnTo>
                    <a:lnTo>
                      <a:pt x="7646" y="113"/>
                    </a:lnTo>
                    <a:lnTo>
                      <a:pt x="7659" y="115"/>
                    </a:lnTo>
                    <a:lnTo>
                      <a:pt x="7672" y="122"/>
                    </a:lnTo>
                    <a:lnTo>
                      <a:pt x="7684" y="121"/>
                    </a:lnTo>
                    <a:lnTo>
                      <a:pt x="7697" y="123"/>
                    </a:lnTo>
                    <a:lnTo>
                      <a:pt x="7710" y="140"/>
                    </a:lnTo>
                    <a:lnTo>
                      <a:pt x="7723" y="139"/>
                    </a:lnTo>
                    <a:lnTo>
                      <a:pt x="7736" y="145"/>
                    </a:lnTo>
                    <a:lnTo>
                      <a:pt x="7749" y="138"/>
                    </a:lnTo>
                    <a:lnTo>
                      <a:pt x="7761" y="133"/>
                    </a:lnTo>
                    <a:lnTo>
                      <a:pt x="7774" y="137"/>
                    </a:lnTo>
                    <a:lnTo>
                      <a:pt x="7787" y="130"/>
                    </a:lnTo>
                    <a:lnTo>
                      <a:pt x="7800" y="125"/>
                    </a:lnTo>
                    <a:lnTo>
                      <a:pt x="7813" y="124"/>
                    </a:lnTo>
                    <a:lnTo>
                      <a:pt x="7826" y="123"/>
                    </a:lnTo>
                    <a:lnTo>
                      <a:pt x="7838" y="123"/>
                    </a:lnTo>
                    <a:lnTo>
                      <a:pt x="7851" y="125"/>
                    </a:lnTo>
                    <a:lnTo>
                      <a:pt x="7864" y="118"/>
                    </a:lnTo>
                    <a:lnTo>
                      <a:pt x="7877" y="129"/>
                    </a:lnTo>
                    <a:lnTo>
                      <a:pt x="7890" y="129"/>
                    </a:lnTo>
                    <a:lnTo>
                      <a:pt x="7903" y="123"/>
                    </a:lnTo>
                    <a:lnTo>
                      <a:pt x="7915" y="129"/>
                    </a:lnTo>
                    <a:lnTo>
                      <a:pt x="7928" y="131"/>
                    </a:lnTo>
                    <a:lnTo>
                      <a:pt x="7941" y="143"/>
                    </a:lnTo>
                    <a:lnTo>
                      <a:pt x="7954" y="147"/>
                    </a:lnTo>
                    <a:lnTo>
                      <a:pt x="7967" y="158"/>
                    </a:lnTo>
                    <a:lnTo>
                      <a:pt x="7980" y="149"/>
                    </a:lnTo>
                    <a:lnTo>
                      <a:pt x="7992" y="151"/>
                    </a:lnTo>
                    <a:lnTo>
                      <a:pt x="8005" y="152"/>
                    </a:lnTo>
                    <a:lnTo>
                      <a:pt x="8018" y="145"/>
                    </a:lnTo>
                    <a:lnTo>
                      <a:pt x="8031" y="142"/>
                    </a:lnTo>
                    <a:lnTo>
                      <a:pt x="8044" y="131"/>
                    </a:lnTo>
                    <a:lnTo>
                      <a:pt x="8057" y="133"/>
                    </a:lnTo>
                    <a:lnTo>
                      <a:pt x="8069" y="125"/>
                    </a:lnTo>
                    <a:lnTo>
                      <a:pt x="8082" y="129"/>
                    </a:lnTo>
                    <a:lnTo>
                      <a:pt x="8095" y="121"/>
                    </a:lnTo>
                    <a:lnTo>
                      <a:pt x="8108" y="117"/>
                    </a:lnTo>
                    <a:lnTo>
                      <a:pt x="8121" y="116"/>
                    </a:lnTo>
                    <a:lnTo>
                      <a:pt x="8133" y="113"/>
                    </a:lnTo>
                    <a:lnTo>
                      <a:pt x="8146" y="115"/>
                    </a:lnTo>
                    <a:lnTo>
                      <a:pt x="8159" y="103"/>
                    </a:lnTo>
                    <a:lnTo>
                      <a:pt x="8172" y="94"/>
                    </a:lnTo>
                    <a:lnTo>
                      <a:pt x="8185" y="101"/>
                    </a:lnTo>
                    <a:lnTo>
                      <a:pt x="8198" y="105"/>
                    </a:lnTo>
                    <a:lnTo>
                      <a:pt x="8210" y="109"/>
                    </a:lnTo>
                    <a:lnTo>
                      <a:pt x="8223" y="117"/>
                    </a:lnTo>
                    <a:lnTo>
                      <a:pt x="8236" y="120"/>
                    </a:lnTo>
                    <a:lnTo>
                      <a:pt x="8249" y="129"/>
                    </a:lnTo>
                    <a:lnTo>
                      <a:pt x="8262" y="127"/>
                    </a:lnTo>
                    <a:lnTo>
                      <a:pt x="8275" y="125"/>
                    </a:lnTo>
                    <a:lnTo>
                      <a:pt x="8287" y="119"/>
                    </a:lnTo>
                    <a:lnTo>
                      <a:pt x="8300" y="134"/>
                    </a:lnTo>
                    <a:lnTo>
                      <a:pt x="8313" y="123"/>
                    </a:lnTo>
                    <a:lnTo>
                      <a:pt x="8326" y="135"/>
                    </a:lnTo>
                    <a:lnTo>
                      <a:pt x="8339" y="117"/>
                    </a:lnTo>
                    <a:lnTo>
                      <a:pt x="8352" y="116"/>
                    </a:lnTo>
                    <a:lnTo>
                      <a:pt x="8364" y="113"/>
                    </a:lnTo>
                    <a:lnTo>
                      <a:pt x="8377" y="114"/>
                    </a:lnTo>
                    <a:lnTo>
                      <a:pt x="8390" y="118"/>
                    </a:lnTo>
                    <a:lnTo>
                      <a:pt x="8403" y="123"/>
                    </a:lnTo>
                    <a:lnTo>
                      <a:pt x="8416" y="129"/>
                    </a:lnTo>
                    <a:lnTo>
                      <a:pt x="8429" y="132"/>
                    </a:lnTo>
                    <a:lnTo>
                      <a:pt x="8441" y="135"/>
                    </a:lnTo>
                    <a:lnTo>
                      <a:pt x="8454" y="139"/>
                    </a:lnTo>
                    <a:lnTo>
                      <a:pt x="8467" y="137"/>
                    </a:lnTo>
                    <a:lnTo>
                      <a:pt x="8480" y="125"/>
                    </a:lnTo>
                    <a:lnTo>
                      <a:pt x="8493" y="122"/>
                    </a:lnTo>
                    <a:lnTo>
                      <a:pt x="8506" y="106"/>
                    </a:lnTo>
                    <a:lnTo>
                      <a:pt x="8518" y="110"/>
                    </a:lnTo>
                    <a:lnTo>
                      <a:pt x="8531" y="109"/>
                    </a:lnTo>
                    <a:lnTo>
                      <a:pt x="8544" y="109"/>
                    </a:lnTo>
                    <a:lnTo>
                      <a:pt x="8557" y="108"/>
                    </a:lnTo>
                    <a:lnTo>
                      <a:pt x="8570" y="106"/>
                    </a:lnTo>
                    <a:lnTo>
                      <a:pt x="8583" y="113"/>
                    </a:lnTo>
                    <a:lnTo>
                      <a:pt x="8595" y="120"/>
                    </a:lnTo>
                    <a:lnTo>
                      <a:pt x="8608" y="119"/>
                    </a:lnTo>
                    <a:lnTo>
                      <a:pt x="8621" y="115"/>
                    </a:lnTo>
                    <a:lnTo>
                      <a:pt x="8634" y="107"/>
                    </a:lnTo>
                    <a:lnTo>
                      <a:pt x="8647" y="108"/>
                    </a:lnTo>
                    <a:lnTo>
                      <a:pt x="8660" y="104"/>
                    </a:lnTo>
                    <a:lnTo>
                      <a:pt x="8672" y="99"/>
                    </a:lnTo>
                    <a:lnTo>
                      <a:pt x="8685" y="94"/>
                    </a:lnTo>
                    <a:lnTo>
                      <a:pt x="8698" y="92"/>
                    </a:lnTo>
                    <a:lnTo>
                      <a:pt x="8711" y="90"/>
                    </a:lnTo>
                    <a:lnTo>
                      <a:pt x="8724" y="98"/>
                    </a:lnTo>
                    <a:lnTo>
                      <a:pt x="8737" y="96"/>
                    </a:lnTo>
                    <a:lnTo>
                      <a:pt x="8749" y="100"/>
                    </a:lnTo>
                    <a:lnTo>
                      <a:pt x="8762" y="96"/>
                    </a:lnTo>
                    <a:lnTo>
                      <a:pt x="8775" y="94"/>
                    </a:lnTo>
                    <a:lnTo>
                      <a:pt x="8788" y="92"/>
                    </a:lnTo>
                    <a:lnTo>
                      <a:pt x="8801" y="85"/>
                    </a:lnTo>
                    <a:lnTo>
                      <a:pt x="8814" y="89"/>
                    </a:lnTo>
                    <a:lnTo>
                      <a:pt x="8826" y="83"/>
                    </a:lnTo>
                    <a:lnTo>
                      <a:pt x="8839" y="89"/>
                    </a:lnTo>
                    <a:lnTo>
                      <a:pt x="8852" y="92"/>
                    </a:lnTo>
                    <a:lnTo>
                      <a:pt x="8865" y="92"/>
                    </a:lnTo>
                    <a:lnTo>
                      <a:pt x="8878" y="93"/>
                    </a:lnTo>
                    <a:lnTo>
                      <a:pt x="8891" y="98"/>
                    </a:lnTo>
                    <a:lnTo>
                      <a:pt x="8903" y="94"/>
                    </a:lnTo>
                    <a:lnTo>
                      <a:pt x="8916" y="106"/>
                    </a:lnTo>
                    <a:lnTo>
                      <a:pt x="8929" y="108"/>
                    </a:lnTo>
                    <a:lnTo>
                      <a:pt x="8942" y="107"/>
                    </a:lnTo>
                    <a:lnTo>
                      <a:pt x="8955" y="137"/>
                    </a:lnTo>
                    <a:lnTo>
                      <a:pt x="8967" y="135"/>
                    </a:lnTo>
                    <a:lnTo>
                      <a:pt x="8980" y="125"/>
                    </a:lnTo>
                    <a:lnTo>
                      <a:pt x="8993" y="135"/>
                    </a:lnTo>
                    <a:lnTo>
                      <a:pt x="9006" y="150"/>
                    </a:lnTo>
                    <a:lnTo>
                      <a:pt x="9019" y="158"/>
                    </a:lnTo>
                    <a:lnTo>
                      <a:pt x="9032" y="167"/>
                    </a:lnTo>
                    <a:lnTo>
                      <a:pt x="9044" y="179"/>
                    </a:lnTo>
                    <a:lnTo>
                      <a:pt x="9057" y="173"/>
                    </a:lnTo>
                    <a:lnTo>
                      <a:pt x="9070" y="186"/>
                    </a:lnTo>
                    <a:lnTo>
                      <a:pt x="9083" y="185"/>
                    </a:lnTo>
                    <a:lnTo>
                      <a:pt x="9096" y="188"/>
                    </a:lnTo>
                    <a:lnTo>
                      <a:pt x="9109" y="184"/>
                    </a:lnTo>
                    <a:lnTo>
                      <a:pt x="9121" y="186"/>
                    </a:lnTo>
                    <a:lnTo>
                      <a:pt x="9134" y="187"/>
                    </a:lnTo>
                    <a:lnTo>
                      <a:pt x="9147" y="188"/>
                    </a:lnTo>
                    <a:lnTo>
                      <a:pt x="9160" y="194"/>
                    </a:lnTo>
                    <a:lnTo>
                      <a:pt x="9173" y="201"/>
                    </a:lnTo>
                    <a:lnTo>
                      <a:pt x="9186" y="232"/>
                    </a:lnTo>
                    <a:lnTo>
                      <a:pt x="9198" y="232"/>
                    </a:lnTo>
                    <a:lnTo>
                      <a:pt x="9211" y="254"/>
                    </a:lnTo>
                    <a:lnTo>
                      <a:pt x="9224" y="247"/>
                    </a:lnTo>
                    <a:lnTo>
                      <a:pt x="9237" y="253"/>
                    </a:lnTo>
                    <a:lnTo>
                      <a:pt x="9250" y="254"/>
                    </a:lnTo>
                    <a:lnTo>
                      <a:pt x="9263" y="265"/>
                    </a:lnTo>
                    <a:lnTo>
                      <a:pt x="9275" y="256"/>
                    </a:lnTo>
                    <a:lnTo>
                      <a:pt x="9288" y="273"/>
                    </a:lnTo>
                    <a:lnTo>
                      <a:pt x="9301" y="280"/>
                    </a:lnTo>
                    <a:lnTo>
                      <a:pt x="9314" y="298"/>
                    </a:lnTo>
                    <a:lnTo>
                      <a:pt x="9327" y="303"/>
                    </a:lnTo>
                    <a:lnTo>
                      <a:pt x="9340" y="297"/>
                    </a:lnTo>
                    <a:lnTo>
                      <a:pt x="9352" y="299"/>
                    </a:lnTo>
                    <a:lnTo>
                      <a:pt x="9365" y="272"/>
                    </a:lnTo>
                    <a:lnTo>
                      <a:pt x="9378" y="247"/>
                    </a:lnTo>
                    <a:lnTo>
                      <a:pt x="9391" y="226"/>
                    </a:lnTo>
                    <a:lnTo>
                      <a:pt x="9404" y="211"/>
                    </a:lnTo>
                    <a:lnTo>
                      <a:pt x="9417" y="196"/>
                    </a:lnTo>
                    <a:lnTo>
                      <a:pt x="9429" y="184"/>
                    </a:lnTo>
                    <a:lnTo>
                      <a:pt x="9442" y="161"/>
                    </a:lnTo>
                    <a:lnTo>
                      <a:pt x="9455" y="151"/>
                    </a:lnTo>
                    <a:lnTo>
                      <a:pt x="9468" y="144"/>
                    </a:lnTo>
                    <a:lnTo>
                      <a:pt x="9481" y="124"/>
                    </a:lnTo>
                    <a:lnTo>
                      <a:pt x="9494" y="124"/>
                    </a:lnTo>
                    <a:lnTo>
                      <a:pt x="9506" y="114"/>
                    </a:lnTo>
                    <a:lnTo>
                      <a:pt x="9519" y="109"/>
                    </a:lnTo>
                    <a:lnTo>
                      <a:pt x="9532" y="108"/>
                    </a:lnTo>
                    <a:lnTo>
                      <a:pt x="9545" y="101"/>
                    </a:lnTo>
                    <a:lnTo>
                      <a:pt x="9558" y="102"/>
                    </a:lnTo>
                    <a:lnTo>
                      <a:pt x="9571" y="100"/>
                    </a:lnTo>
                    <a:lnTo>
                      <a:pt x="9583" y="93"/>
                    </a:lnTo>
                    <a:lnTo>
                      <a:pt x="9596" y="99"/>
                    </a:lnTo>
                    <a:lnTo>
                      <a:pt x="9609" y="98"/>
                    </a:lnTo>
                    <a:lnTo>
                      <a:pt x="9622" y="92"/>
                    </a:lnTo>
                    <a:lnTo>
                      <a:pt x="9635" y="84"/>
                    </a:lnTo>
                    <a:lnTo>
                      <a:pt x="9648" y="90"/>
                    </a:lnTo>
                    <a:lnTo>
                      <a:pt x="9660" y="90"/>
                    </a:lnTo>
                    <a:lnTo>
                      <a:pt x="9673" y="86"/>
                    </a:lnTo>
                    <a:lnTo>
                      <a:pt x="9686" y="85"/>
                    </a:lnTo>
                    <a:lnTo>
                      <a:pt x="9699" y="84"/>
                    </a:lnTo>
                    <a:lnTo>
                      <a:pt x="9712" y="80"/>
                    </a:lnTo>
                    <a:lnTo>
                      <a:pt x="9725" y="90"/>
                    </a:lnTo>
                    <a:lnTo>
                      <a:pt x="9737" y="78"/>
                    </a:lnTo>
                    <a:lnTo>
                      <a:pt x="9750" y="84"/>
                    </a:lnTo>
                    <a:lnTo>
                      <a:pt x="9763" y="77"/>
                    </a:lnTo>
                    <a:lnTo>
                      <a:pt x="9776" y="78"/>
                    </a:lnTo>
                    <a:lnTo>
                      <a:pt x="9789" y="77"/>
                    </a:lnTo>
                    <a:lnTo>
                      <a:pt x="9801" y="81"/>
                    </a:lnTo>
                    <a:lnTo>
                      <a:pt x="9814" y="86"/>
                    </a:lnTo>
                    <a:lnTo>
                      <a:pt x="9827" y="87"/>
                    </a:lnTo>
                    <a:lnTo>
                      <a:pt x="9840" y="87"/>
                    </a:lnTo>
                    <a:lnTo>
                      <a:pt x="9853" y="88"/>
                    </a:lnTo>
                    <a:lnTo>
                      <a:pt x="9866" y="89"/>
                    </a:lnTo>
                    <a:lnTo>
                      <a:pt x="9878" y="91"/>
                    </a:lnTo>
                    <a:lnTo>
                      <a:pt x="9891" y="85"/>
                    </a:lnTo>
                    <a:lnTo>
                      <a:pt x="9904" y="82"/>
                    </a:lnTo>
                    <a:lnTo>
                      <a:pt x="9917" y="83"/>
                    </a:lnTo>
                    <a:lnTo>
                      <a:pt x="9930" y="83"/>
                    </a:lnTo>
                    <a:lnTo>
                      <a:pt x="9943" y="80"/>
                    </a:lnTo>
                    <a:lnTo>
                      <a:pt x="9955" y="78"/>
                    </a:lnTo>
                    <a:lnTo>
                      <a:pt x="9968" y="81"/>
                    </a:lnTo>
                    <a:lnTo>
                      <a:pt x="9981" y="82"/>
                    </a:lnTo>
                    <a:lnTo>
                      <a:pt x="9994" y="78"/>
                    </a:lnTo>
                    <a:lnTo>
                      <a:pt x="10007" y="77"/>
                    </a:lnTo>
                    <a:lnTo>
                      <a:pt x="10020" y="87"/>
                    </a:lnTo>
                    <a:lnTo>
                      <a:pt x="10032" y="75"/>
                    </a:lnTo>
                    <a:lnTo>
                      <a:pt x="10045" y="77"/>
                    </a:lnTo>
                    <a:lnTo>
                      <a:pt x="10058" y="73"/>
                    </a:lnTo>
                    <a:lnTo>
                      <a:pt x="10071" y="67"/>
                    </a:lnTo>
                    <a:lnTo>
                      <a:pt x="10084" y="62"/>
                    </a:lnTo>
                    <a:lnTo>
                      <a:pt x="10097" y="63"/>
                    </a:lnTo>
                    <a:lnTo>
                      <a:pt x="10100" y="62"/>
                    </a:lnTo>
                  </a:path>
                </a:pathLst>
              </a:cu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83" name="Freeform 473"/>
              <p:cNvSpPr>
                <a:spLocks/>
              </p:cNvSpPr>
              <p:nvPr/>
            </p:nvSpPr>
            <p:spPr bwMode="auto">
              <a:xfrm flipV="1">
                <a:off x="632604" y="2813330"/>
                <a:ext cx="3284065" cy="416692"/>
              </a:xfrm>
              <a:custGeom>
                <a:avLst/>
                <a:gdLst>
                  <a:gd name="T0" fmla="*/ 152 w 10099"/>
                  <a:gd name="T1" fmla="*/ 35 h 1339"/>
                  <a:gd name="T2" fmla="*/ 319 w 10099"/>
                  <a:gd name="T3" fmla="*/ 29 h 1339"/>
                  <a:gd name="T4" fmla="*/ 485 w 10099"/>
                  <a:gd name="T5" fmla="*/ 57 h 1339"/>
                  <a:gd name="T6" fmla="*/ 652 w 10099"/>
                  <a:gd name="T7" fmla="*/ 73 h 1339"/>
                  <a:gd name="T8" fmla="*/ 819 w 10099"/>
                  <a:gd name="T9" fmla="*/ 45 h 1339"/>
                  <a:gd name="T10" fmla="*/ 986 w 10099"/>
                  <a:gd name="T11" fmla="*/ 48 h 1339"/>
                  <a:gd name="T12" fmla="*/ 1153 w 10099"/>
                  <a:gd name="T13" fmla="*/ 99 h 1339"/>
                  <a:gd name="T14" fmla="*/ 1319 w 10099"/>
                  <a:gd name="T15" fmla="*/ 48 h 1339"/>
                  <a:gd name="T16" fmla="*/ 1486 w 10099"/>
                  <a:gd name="T17" fmla="*/ 59 h 1339"/>
                  <a:gd name="T18" fmla="*/ 1653 w 10099"/>
                  <a:gd name="T19" fmla="*/ 49 h 1339"/>
                  <a:gd name="T20" fmla="*/ 1820 w 10099"/>
                  <a:gd name="T21" fmla="*/ 47 h 1339"/>
                  <a:gd name="T22" fmla="*/ 1987 w 10099"/>
                  <a:gd name="T23" fmla="*/ 32 h 1339"/>
                  <a:gd name="T24" fmla="*/ 2153 w 10099"/>
                  <a:gd name="T25" fmla="*/ 28 h 1339"/>
                  <a:gd name="T26" fmla="*/ 2320 w 10099"/>
                  <a:gd name="T27" fmla="*/ 26 h 1339"/>
                  <a:gd name="T28" fmla="*/ 2487 w 10099"/>
                  <a:gd name="T29" fmla="*/ 38 h 1339"/>
                  <a:gd name="T30" fmla="*/ 2654 w 10099"/>
                  <a:gd name="T31" fmla="*/ 73 h 1339"/>
                  <a:gd name="T32" fmla="*/ 2821 w 10099"/>
                  <a:gd name="T33" fmla="*/ 107 h 1339"/>
                  <a:gd name="T34" fmla="*/ 2987 w 10099"/>
                  <a:gd name="T35" fmla="*/ 75 h 1339"/>
                  <a:gd name="T36" fmla="*/ 3154 w 10099"/>
                  <a:gd name="T37" fmla="*/ 76 h 1339"/>
                  <a:gd name="T38" fmla="*/ 3321 w 10099"/>
                  <a:gd name="T39" fmla="*/ 91 h 1339"/>
                  <a:gd name="T40" fmla="*/ 3488 w 10099"/>
                  <a:gd name="T41" fmla="*/ 163 h 1339"/>
                  <a:gd name="T42" fmla="*/ 3655 w 10099"/>
                  <a:gd name="T43" fmla="*/ 181 h 1339"/>
                  <a:gd name="T44" fmla="*/ 3821 w 10099"/>
                  <a:gd name="T45" fmla="*/ 107 h 1339"/>
                  <a:gd name="T46" fmla="*/ 3988 w 10099"/>
                  <a:gd name="T47" fmla="*/ 95 h 1339"/>
                  <a:gd name="T48" fmla="*/ 4155 w 10099"/>
                  <a:gd name="T49" fmla="*/ 76 h 1339"/>
                  <a:gd name="T50" fmla="*/ 4322 w 10099"/>
                  <a:gd name="T51" fmla="*/ 78 h 1339"/>
                  <a:gd name="T52" fmla="*/ 4489 w 10099"/>
                  <a:gd name="T53" fmla="*/ 88 h 1339"/>
                  <a:gd name="T54" fmla="*/ 4655 w 10099"/>
                  <a:gd name="T55" fmla="*/ 84 h 1339"/>
                  <a:gd name="T56" fmla="*/ 4822 w 10099"/>
                  <a:gd name="T57" fmla="*/ 90 h 1339"/>
                  <a:gd name="T58" fmla="*/ 4989 w 10099"/>
                  <a:gd name="T59" fmla="*/ 128 h 1339"/>
                  <a:gd name="T60" fmla="*/ 5156 w 10099"/>
                  <a:gd name="T61" fmla="*/ 171 h 1339"/>
                  <a:gd name="T62" fmla="*/ 5323 w 10099"/>
                  <a:gd name="T63" fmla="*/ 264 h 1339"/>
                  <a:gd name="T64" fmla="*/ 5489 w 10099"/>
                  <a:gd name="T65" fmla="*/ 212 h 1339"/>
                  <a:gd name="T66" fmla="*/ 5656 w 10099"/>
                  <a:gd name="T67" fmla="*/ 129 h 1339"/>
                  <a:gd name="T68" fmla="*/ 5823 w 10099"/>
                  <a:gd name="T69" fmla="*/ 134 h 1339"/>
                  <a:gd name="T70" fmla="*/ 5990 w 10099"/>
                  <a:gd name="T71" fmla="*/ 129 h 1339"/>
                  <a:gd name="T72" fmla="*/ 6157 w 10099"/>
                  <a:gd name="T73" fmla="*/ 313 h 1339"/>
                  <a:gd name="T74" fmla="*/ 6323 w 10099"/>
                  <a:gd name="T75" fmla="*/ 421 h 1339"/>
                  <a:gd name="T76" fmla="*/ 6490 w 10099"/>
                  <a:gd name="T77" fmla="*/ 1048 h 1339"/>
                  <a:gd name="T78" fmla="*/ 6657 w 10099"/>
                  <a:gd name="T79" fmla="*/ 401 h 1339"/>
                  <a:gd name="T80" fmla="*/ 6824 w 10099"/>
                  <a:gd name="T81" fmla="*/ 353 h 1339"/>
                  <a:gd name="T82" fmla="*/ 6991 w 10099"/>
                  <a:gd name="T83" fmla="*/ 297 h 1339"/>
                  <a:gd name="T84" fmla="*/ 7157 w 10099"/>
                  <a:gd name="T85" fmla="*/ 516 h 1339"/>
                  <a:gd name="T86" fmla="*/ 7324 w 10099"/>
                  <a:gd name="T87" fmla="*/ 284 h 1339"/>
                  <a:gd name="T88" fmla="*/ 7491 w 10099"/>
                  <a:gd name="T89" fmla="*/ 333 h 1339"/>
                  <a:gd name="T90" fmla="*/ 7658 w 10099"/>
                  <a:gd name="T91" fmla="*/ 211 h 1339"/>
                  <a:gd name="T92" fmla="*/ 7825 w 10099"/>
                  <a:gd name="T93" fmla="*/ 224 h 1339"/>
                  <a:gd name="T94" fmla="*/ 7991 w 10099"/>
                  <a:gd name="T95" fmla="*/ 275 h 1339"/>
                  <a:gd name="T96" fmla="*/ 8158 w 10099"/>
                  <a:gd name="T97" fmla="*/ 213 h 1339"/>
                  <a:gd name="T98" fmla="*/ 8325 w 10099"/>
                  <a:gd name="T99" fmla="*/ 236 h 1339"/>
                  <a:gd name="T100" fmla="*/ 8492 w 10099"/>
                  <a:gd name="T101" fmla="*/ 194 h 1339"/>
                  <a:gd name="T102" fmla="*/ 8659 w 10099"/>
                  <a:gd name="T103" fmla="*/ 181 h 1339"/>
                  <a:gd name="T104" fmla="*/ 8825 w 10099"/>
                  <a:gd name="T105" fmla="*/ 181 h 1339"/>
                  <a:gd name="T106" fmla="*/ 8992 w 10099"/>
                  <a:gd name="T107" fmla="*/ 241 h 1339"/>
                  <a:gd name="T108" fmla="*/ 9159 w 10099"/>
                  <a:gd name="T109" fmla="*/ 307 h 1339"/>
                  <a:gd name="T110" fmla="*/ 9326 w 10099"/>
                  <a:gd name="T111" fmla="*/ 233 h 1339"/>
                  <a:gd name="T112" fmla="*/ 9492 w 10099"/>
                  <a:gd name="T113" fmla="*/ 183 h 1339"/>
                  <a:gd name="T114" fmla="*/ 9659 w 10099"/>
                  <a:gd name="T115" fmla="*/ 184 h 1339"/>
                  <a:gd name="T116" fmla="*/ 9826 w 10099"/>
                  <a:gd name="T117" fmla="*/ 181 h 1339"/>
                  <a:gd name="T118" fmla="*/ 9993 w 10099"/>
                  <a:gd name="T119" fmla="*/ 167 h 13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10099" h="1339">
                    <a:moveTo>
                      <a:pt x="0" y="42"/>
                    </a:moveTo>
                    <a:lnTo>
                      <a:pt x="11" y="36"/>
                    </a:lnTo>
                    <a:lnTo>
                      <a:pt x="23" y="38"/>
                    </a:lnTo>
                    <a:lnTo>
                      <a:pt x="36" y="36"/>
                    </a:lnTo>
                    <a:lnTo>
                      <a:pt x="49" y="39"/>
                    </a:lnTo>
                    <a:lnTo>
                      <a:pt x="62" y="39"/>
                    </a:lnTo>
                    <a:lnTo>
                      <a:pt x="75" y="43"/>
                    </a:lnTo>
                    <a:lnTo>
                      <a:pt x="88" y="40"/>
                    </a:lnTo>
                    <a:lnTo>
                      <a:pt x="100" y="44"/>
                    </a:lnTo>
                    <a:lnTo>
                      <a:pt x="113" y="36"/>
                    </a:lnTo>
                    <a:lnTo>
                      <a:pt x="126" y="31"/>
                    </a:lnTo>
                    <a:lnTo>
                      <a:pt x="139" y="34"/>
                    </a:lnTo>
                    <a:lnTo>
                      <a:pt x="152" y="35"/>
                    </a:lnTo>
                    <a:lnTo>
                      <a:pt x="165" y="33"/>
                    </a:lnTo>
                    <a:lnTo>
                      <a:pt x="177" y="34"/>
                    </a:lnTo>
                    <a:lnTo>
                      <a:pt x="190" y="40"/>
                    </a:lnTo>
                    <a:lnTo>
                      <a:pt x="203" y="42"/>
                    </a:lnTo>
                    <a:lnTo>
                      <a:pt x="216" y="46"/>
                    </a:lnTo>
                    <a:lnTo>
                      <a:pt x="229" y="39"/>
                    </a:lnTo>
                    <a:lnTo>
                      <a:pt x="242" y="38"/>
                    </a:lnTo>
                    <a:lnTo>
                      <a:pt x="254" y="42"/>
                    </a:lnTo>
                    <a:lnTo>
                      <a:pt x="267" y="40"/>
                    </a:lnTo>
                    <a:lnTo>
                      <a:pt x="280" y="38"/>
                    </a:lnTo>
                    <a:lnTo>
                      <a:pt x="293" y="34"/>
                    </a:lnTo>
                    <a:lnTo>
                      <a:pt x="306" y="38"/>
                    </a:lnTo>
                    <a:lnTo>
                      <a:pt x="319" y="29"/>
                    </a:lnTo>
                    <a:lnTo>
                      <a:pt x="331" y="28"/>
                    </a:lnTo>
                    <a:lnTo>
                      <a:pt x="344" y="35"/>
                    </a:lnTo>
                    <a:lnTo>
                      <a:pt x="357" y="31"/>
                    </a:lnTo>
                    <a:lnTo>
                      <a:pt x="370" y="25"/>
                    </a:lnTo>
                    <a:lnTo>
                      <a:pt x="383" y="31"/>
                    </a:lnTo>
                    <a:lnTo>
                      <a:pt x="396" y="34"/>
                    </a:lnTo>
                    <a:lnTo>
                      <a:pt x="408" y="38"/>
                    </a:lnTo>
                    <a:lnTo>
                      <a:pt x="421" y="40"/>
                    </a:lnTo>
                    <a:lnTo>
                      <a:pt x="434" y="45"/>
                    </a:lnTo>
                    <a:lnTo>
                      <a:pt x="447" y="45"/>
                    </a:lnTo>
                    <a:lnTo>
                      <a:pt x="460" y="48"/>
                    </a:lnTo>
                    <a:lnTo>
                      <a:pt x="473" y="56"/>
                    </a:lnTo>
                    <a:lnTo>
                      <a:pt x="485" y="57"/>
                    </a:lnTo>
                    <a:lnTo>
                      <a:pt x="498" y="58"/>
                    </a:lnTo>
                    <a:lnTo>
                      <a:pt x="511" y="63"/>
                    </a:lnTo>
                    <a:lnTo>
                      <a:pt x="524" y="61"/>
                    </a:lnTo>
                    <a:lnTo>
                      <a:pt x="537" y="59"/>
                    </a:lnTo>
                    <a:lnTo>
                      <a:pt x="550" y="58"/>
                    </a:lnTo>
                    <a:lnTo>
                      <a:pt x="562" y="63"/>
                    </a:lnTo>
                    <a:lnTo>
                      <a:pt x="575" y="61"/>
                    </a:lnTo>
                    <a:lnTo>
                      <a:pt x="588" y="68"/>
                    </a:lnTo>
                    <a:lnTo>
                      <a:pt x="601" y="78"/>
                    </a:lnTo>
                    <a:lnTo>
                      <a:pt x="614" y="68"/>
                    </a:lnTo>
                    <a:lnTo>
                      <a:pt x="626" y="68"/>
                    </a:lnTo>
                    <a:lnTo>
                      <a:pt x="639" y="73"/>
                    </a:lnTo>
                    <a:lnTo>
                      <a:pt x="652" y="73"/>
                    </a:lnTo>
                    <a:lnTo>
                      <a:pt x="665" y="66"/>
                    </a:lnTo>
                    <a:lnTo>
                      <a:pt x="678" y="56"/>
                    </a:lnTo>
                    <a:lnTo>
                      <a:pt x="691" y="53"/>
                    </a:lnTo>
                    <a:lnTo>
                      <a:pt x="703" y="52"/>
                    </a:lnTo>
                    <a:lnTo>
                      <a:pt x="716" y="50"/>
                    </a:lnTo>
                    <a:lnTo>
                      <a:pt x="729" y="51"/>
                    </a:lnTo>
                    <a:lnTo>
                      <a:pt x="742" y="45"/>
                    </a:lnTo>
                    <a:lnTo>
                      <a:pt x="755" y="41"/>
                    </a:lnTo>
                    <a:lnTo>
                      <a:pt x="768" y="46"/>
                    </a:lnTo>
                    <a:lnTo>
                      <a:pt x="780" y="42"/>
                    </a:lnTo>
                    <a:lnTo>
                      <a:pt x="793" y="42"/>
                    </a:lnTo>
                    <a:lnTo>
                      <a:pt x="806" y="43"/>
                    </a:lnTo>
                    <a:lnTo>
                      <a:pt x="819" y="45"/>
                    </a:lnTo>
                    <a:lnTo>
                      <a:pt x="832" y="47"/>
                    </a:lnTo>
                    <a:lnTo>
                      <a:pt x="845" y="46"/>
                    </a:lnTo>
                    <a:lnTo>
                      <a:pt x="857" y="47"/>
                    </a:lnTo>
                    <a:lnTo>
                      <a:pt x="870" y="44"/>
                    </a:lnTo>
                    <a:lnTo>
                      <a:pt x="883" y="45"/>
                    </a:lnTo>
                    <a:lnTo>
                      <a:pt x="896" y="64"/>
                    </a:lnTo>
                    <a:lnTo>
                      <a:pt x="909" y="76"/>
                    </a:lnTo>
                    <a:lnTo>
                      <a:pt x="922" y="66"/>
                    </a:lnTo>
                    <a:lnTo>
                      <a:pt x="934" y="47"/>
                    </a:lnTo>
                    <a:lnTo>
                      <a:pt x="947" y="40"/>
                    </a:lnTo>
                    <a:lnTo>
                      <a:pt x="960" y="46"/>
                    </a:lnTo>
                    <a:lnTo>
                      <a:pt x="973" y="48"/>
                    </a:lnTo>
                    <a:lnTo>
                      <a:pt x="986" y="48"/>
                    </a:lnTo>
                    <a:lnTo>
                      <a:pt x="999" y="41"/>
                    </a:lnTo>
                    <a:lnTo>
                      <a:pt x="1011" y="39"/>
                    </a:lnTo>
                    <a:lnTo>
                      <a:pt x="1024" y="47"/>
                    </a:lnTo>
                    <a:lnTo>
                      <a:pt x="1037" y="40"/>
                    </a:lnTo>
                    <a:lnTo>
                      <a:pt x="1050" y="46"/>
                    </a:lnTo>
                    <a:lnTo>
                      <a:pt x="1063" y="47"/>
                    </a:lnTo>
                    <a:lnTo>
                      <a:pt x="1076" y="55"/>
                    </a:lnTo>
                    <a:lnTo>
                      <a:pt x="1088" y="58"/>
                    </a:lnTo>
                    <a:lnTo>
                      <a:pt x="1101" y="66"/>
                    </a:lnTo>
                    <a:lnTo>
                      <a:pt x="1114" y="81"/>
                    </a:lnTo>
                    <a:lnTo>
                      <a:pt x="1127" y="86"/>
                    </a:lnTo>
                    <a:lnTo>
                      <a:pt x="1140" y="95"/>
                    </a:lnTo>
                    <a:lnTo>
                      <a:pt x="1153" y="99"/>
                    </a:lnTo>
                    <a:lnTo>
                      <a:pt x="1165" y="114"/>
                    </a:lnTo>
                    <a:lnTo>
                      <a:pt x="1178" y="120"/>
                    </a:lnTo>
                    <a:lnTo>
                      <a:pt x="1191" y="116"/>
                    </a:lnTo>
                    <a:lnTo>
                      <a:pt x="1204" y="119"/>
                    </a:lnTo>
                    <a:lnTo>
                      <a:pt x="1217" y="116"/>
                    </a:lnTo>
                    <a:lnTo>
                      <a:pt x="1230" y="103"/>
                    </a:lnTo>
                    <a:lnTo>
                      <a:pt x="1242" y="98"/>
                    </a:lnTo>
                    <a:lnTo>
                      <a:pt x="1255" y="92"/>
                    </a:lnTo>
                    <a:lnTo>
                      <a:pt x="1268" y="75"/>
                    </a:lnTo>
                    <a:lnTo>
                      <a:pt x="1281" y="74"/>
                    </a:lnTo>
                    <a:lnTo>
                      <a:pt x="1294" y="63"/>
                    </a:lnTo>
                    <a:lnTo>
                      <a:pt x="1307" y="50"/>
                    </a:lnTo>
                    <a:lnTo>
                      <a:pt x="1319" y="48"/>
                    </a:lnTo>
                    <a:lnTo>
                      <a:pt x="1332" y="46"/>
                    </a:lnTo>
                    <a:lnTo>
                      <a:pt x="1345" y="35"/>
                    </a:lnTo>
                    <a:lnTo>
                      <a:pt x="1358" y="39"/>
                    </a:lnTo>
                    <a:lnTo>
                      <a:pt x="1371" y="41"/>
                    </a:lnTo>
                    <a:lnTo>
                      <a:pt x="1383" y="40"/>
                    </a:lnTo>
                    <a:lnTo>
                      <a:pt x="1396" y="45"/>
                    </a:lnTo>
                    <a:lnTo>
                      <a:pt x="1409" y="37"/>
                    </a:lnTo>
                    <a:lnTo>
                      <a:pt x="1422" y="39"/>
                    </a:lnTo>
                    <a:lnTo>
                      <a:pt x="1435" y="44"/>
                    </a:lnTo>
                    <a:lnTo>
                      <a:pt x="1448" y="49"/>
                    </a:lnTo>
                    <a:lnTo>
                      <a:pt x="1460" y="53"/>
                    </a:lnTo>
                    <a:lnTo>
                      <a:pt x="1473" y="55"/>
                    </a:lnTo>
                    <a:lnTo>
                      <a:pt x="1486" y="59"/>
                    </a:lnTo>
                    <a:lnTo>
                      <a:pt x="1499" y="54"/>
                    </a:lnTo>
                    <a:lnTo>
                      <a:pt x="1512" y="56"/>
                    </a:lnTo>
                    <a:lnTo>
                      <a:pt x="1525" y="53"/>
                    </a:lnTo>
                    <a:lnTo>
                      <a:pt x="1537" y="52"/>
                    </a:lnTo>
                    <a:lnTo>
                      <a:pt x="1550" y="51"/>
                    </a:lnTo>
                    <a:lnTo>
                      <a:pt x="1563" y="55"/>
                    </a:lnTo>
                    <a:lnTo>
                      <a:pt x="1576" y="45"/>
                    </a:lnTo>
                    <a:lnTo>
                      <a:pt x="1589" y="46"/>
                    </a:lnTo>
                    <a:lnTo>
                      <a:pt x="1602" y="46"/>
                    </a:lnTo>
                    <a:lnTo>
                      <a:pt x="1614" y="46"/>
                    </a:lnTo>
                    <a:lnTo>
                      <a:pt x="1627" y="47"/>
                    </a:lnTo>
                    <a:lnTo>
                      <a:pt x="1640" y="46"/>
                    </a:lnTo>
                    <a:lnTo>
                      <a:pt x="1653" y="49"/>
                    </a:lnTo>
                    <a:lnTo>
                      <a:pt x="1666" y="56"/>
                    </a:lnTo>
                    <a:lnTo>
                      <a:pt x="1679" y="45"/>
                    </a:lnTo>
                    <a:lnTo>
                      <a:pt x="1691" y="49"/>
                    </a:lnTo>
                    <a:lnTo>
                      <a:pt x="1704" y="57"/>
                    </a:lnTo>
                    <a:lnTo>
                      <a:pt x="1717" y="60"/>
                    </a:lnTo>
                    <a:lnTo>
                      <a:pt x="1730" y="60"/>
                    </a:lnTo>
                    <a:lnTo>
                      <a:pt x="1743" y="57"/>
                    </a:lnTo>
                    <a:lnTo>
                      <a:pt x="1756" y="54"/>
                    </a:lnTo>
                    <a:lnTo>
                      <a:pt x="1768" y="70"/>
                    </a:lnTo>
                    <a:lnTo>
                      <a:pt x="1781" y="64"/>
                    </a:lnTo>
                    <a:lnTo>
                      <a:pt x="1794" y="54"/>
                    </a:lnTo>
                    <a:lnTo>
                      <a:pt x="1807" y="49"/>
                    </a:lnTo>
                    <a:lnTo>
                      <a:pt x="1820" y="47"/>
                    </a:lnTo>
                    <a:lnTo>
                      <a:pt x="1833" y="44"/>
                    </a:lnTo>
                    <a:lnTo>
                      <a:pt x="1845" y="44"/>
                    </a:lnTo>
                    <a:lnTo>
                      <a:pt x="1858" y="36"/>
                    </a:lnTo>
                    <a:lnTo>
                      <a:pt x="1871" y="37"/>
                    </a:lnTo>
                    <a:lnTo>
                      <a:pt x="1884" y="34"/>
                    </a:lnTo>
                    <a:lnTo>
                      <a:pt x="1897" y="34"/>
                    </a:lnTo>
                    <a:lnTo>
                      <a:pt x="1910" y="31"/>
                    </a:lnTo>
                    <a:lnTo>
                      <a:pt x="1922" y="30"/>
                    </a:lnTo>
                    <a:lnTo>
                      <a:pt x="1935" y="32"/>
                    </a:lnTo>
                    <a:lnTo>
                      <a:pt x="1948" y="36"/>
                    </a:lnTo>
                    <a:lnTo>
                      <a:pt x="1961" y="50"/>
                    </a:lnTo>
                    <a:lnTo>
                      <a:pt x="1974" y="33"/>
                    </a:lnTo>
                    <a:lnTo>
                      <a:pt x="1987" y="32"/>
                    </a:lnTo>
                    <a:lnTo>
                      <a:pt x="1999" y="49"/>
                    </a:lnTo>
                    <a:lnTo>
                      <a:pt x="2012" y="52"/>
                    </a:lnTo>
                    <a:lnTo>
                      <a:pt x="2025" y="41"/>
                    </a:lnTo>
                    <a:lnTo>
                      <a:pt x="2038" y="52"/>
                    </a:lnTo>
                    <a:lnTo>
                      <a:pt x="2051" y="41"/>
                    </a:lnTo>
                    <a:lnTo>
                      <a:pt x="2064" y="32"/>
                    </a:lnTo>
                    <a:lnTo>
                      <a:pt x="2076" y="33"/>
                    </a:lnTo>
                    <a:lnTo>
                      <a:pt x="2089" y="36"/>
                    </a:lnTo>
                    <a:lnTo>
                      <a:pt x="2102" y="38"/>
                    </a:lnTo>
                    <a:lnTo>
                      <a:pt x="2115" y="18"/>
                    </a:lnTo>
                    <a:lnTo>
                      <a:pt x="2128" y="37"/>
                    </a:lnTo>
                    <a:lnTo>
                      <a:pt x="2141" y="18"/>
                    </a:lnTo>
                    <a:lnTo>
                      <a:pt x="2153" y="28"/>
                    </a:lnTo>
                    <a:lnTo>
                      <a:pt x="2166" y="33"/>
                    </a:lnTo>
                    <a:lnTo>
                      <a:pt x="2179" y="26"/>
                    </a:lnTo>
                    <a:lnTo>
                      <a:pt x="2192" y="25"/>
                    </a:lnTo>
                    <a:lnTo>
                      <a:pt x="2205" y="18"/>
                    </a:lnTo>
                    <a:lnTo>
                      <a:pt x="2217" y="34"/>
                    </a:lnTo>
                    <a:lnTo>
                      <a:pt x="2230" y="14"/>
                    </a:lnTo>
                    <a:lnTo>
                      <a:pt x="2243" y="14"/>
                    </a:lnTo>
                    <a:lnTo>
                      <a:pt x="2256" y="20"/>
                    </a:lnTo>
                    <a:lnTo>
                      <a:pt x="2269" y="12"/>
                    </a:lnTo>
                    <a:lnTo>
                      <a:pt x="2282" y="0"/>
                    </a:lnTo>
                    <a:lnTo>
                      <a:pt x="2294" y="22"/>
                    </a:lnTo>
                    <a:lnTo>
                      <a:pt x="2307" y="22"/>
                    </a:lnTo>
                    <a:lnTo>
                      <a:pt x="2320" y="26"/>
                    </a:lnTo>
                    <a:lnTo>
                      <a:pt x="2333" y="18"/>
                    </a:lnTo>
                    <a:lnTo>
                      <a:pt x="2346" y="13"/>
                    </a:lnTo>
                    <a:lnTo>
                      <a:pt x="2359" y="11"/>
                    </a:lnTo>
                    <a:lnTo>
                      <a:pt x="2371" y="5"/>
                    </a:lnTo>
                    <a:lnTo>
                      <a:pt x="2384" y="34"/>
                    </a:lnTo>
                    <a:lnTo>
                      <a:pt x="2397" y="52"/>
                    </a:lnTo>
                    <a:lnTo>
                      <a:pt x="2410" y="38"/>
                    </a:lnTo>
                    <a:lnTo>
                      <a:pt x="2423" y="30"/>
                    </a:lnTo>
                    <a:lnTo>
                      <a:pt x="2436" y="22"/>
                    </a:lnTo>
                    <a:lnTo>
                      <a:pt x="2448" y="16"/>
                    </a:lnTo>
                    <a:lnTo>
                      <a:pt x="2461" y="27"/>
                    </a:lnTo>
                    <a:lnTo>
                      <a:pt x="2474" y="19"/>
                    </a:lnTo>
                    <a:lnTo>
                      <a:pt x="2487" y="38"/>
                    </a:lnTo>
                    <a:lnTo>
                      <a:pt x="2500" y="25"/>
                    </a:lnTo>
                    <a:lnTo>
                      <a:pt x="2513" y="22"/>
                    </a:lnTo>
                    <a:lnTo>
                      <a:pt x="2525" y="23"/>
                    </a:lnTo>
                    <a:lnTo>
                      <a:pt x="2538" y="31"/>
                    </a:lnTo>
                    <a:lnTo>
                      <a:pt x="2551" y="39"/>
                    </a:lnTo>
                    <a:lnTo>
                      <a:pt x="2564" y="77"/>
                    </a:lnTo>
                    <a:lnTo>
                      <a:pt x="2577" y="80"/>
                    </a:lnTo>
                    <a:lnTo>
                      <a:pt x="2590" y="59"/>
                    </a:lnTo>
                    <a:lnTo>
                      <a:pt x="2602" y="49"/>
                    </a:lnTo>
                    <a:lnTo>
                      <a:pt x="2615" y="61"/>
                    </a:lnTo>
                    <a:lnTo>
                      <a:pt x="2628" y="60"/>
                    </a:lnTo>
                    <a:lnTo>
                      <a:pt x="2641" y="66"/>
                    </a:lnTo>
                    <a:lnTo>
                      <a:pt x="2654" y="73"/>
                    </a:lnTo>
                    <a:lnTo>
                      <a:pt x="2667" y="62"/>
                    </a:lnTo>
                    <a:lnTo>
                      <a:pt x="2679" y="64"/>
                    </a:lnTo>
                    <a:lnTo>
                      <a:pt x="2692" y="63"/>
                    </a:lnTo>
                    <a:lnTo>
                      <a:pt x="2705" y="83"/>
                    </a:lnTo>
                    <a:lnTo>
                      <a:pt x="2718" y="70"/>
                    </a:lnTo>
                    <a:lnTo>
                      <a:pt x="2731" y="52"/>
                    </a:lnTo>
                    <a:lnTo>
                      <a:pt x="2744" y="96"/>
                    </a:lnTo>
                    <a:lnTo>
                      <a:pt x="2756" y="118"/>
                    </a:lnTo>
                    <a:lnTo>
                      <a:pt x="2769" y="116"/>
                    </a:lnTo>
                    <a:lnTo>
                      <a:pt x="2782" y="111"/>
                    </a:lnTo>
                    <a:lnTo>
                      <a:pt x="2795" y="104"/>
                    </a:lnTo>
                    <a:lnTo>
                      <a:pt x="2808" y="109"/>
                    </a:lnTo>
                    <a:lnTo>
                      <a:pt x="2821" y="107"/>
                    </a:lnTo>
                    <a:lnTo>
                      <a:pt x="2833" y="98"/>
                    </a:lnTo>
                    <a:lnTo>
                      <a:pt x="2846" y="96"/>
                    </a:lnTo>
                    <a:lnTo>
                      <a:pt x="2859" y="88"/>
                    </a:lnTo>
                    <a:lnTo>
                      <a:pt x="2872" y="84"/>
                    </a:lnTo>
                    <a:lnTo>
                      <a:pt x="2885" y="89"/>
                    </a:lnTo>
                    <a:lnTo>
                      <a:pt x="2898" y="81"/>
                    </a:lnTo>
                    <a:lnTo>
                      <a:pt x="2910" y="84"/>
                    </a:lnTo>
                    <a:lnTo>
                      <a:pt x="2923" y="85"/>
                    </a:lnTo>
                    <a:lnTo>
                      <a:pt x="2936" y="78"/>
                    </a:lnTo>
                    <a:lnTo>
                      <a:pt x="2949" y="87"/>
                    </a:lnTo>
                    <a:lnTo>
                      <a:pt x="2962" y="77"/>
                    </a:lnTo>
                    <a:lnTo>
                      <a:pt x="2975" y="81"/>
                    </a:lnTo>
                    <a:lnTo>
                      <a:pt x="2987" y="75"/>
                    </a:lnTo>
                    <a:lnTo>
                      <a:pt x="3000" y="74"/>
                    </a:lnTo>
                    <a:lnTo>
                      <a:pt x="3013" y="77"/>
                    </a:lnTo>
                    <a:lnTo>
                      <a:pt x="3026" y="83"/>
                    </a:lnTo>
                    <a:lnTo>
                      <a:pt x="3039" y="80"/>
                    </a:lnTo>
                    <a:lnTo>
                      <a:pt x="3051" y="82"/>
                    </a:lnTo>
                    <a:lnTo>
                      <a:pt x="3064" y="71"/>
                    </a:lnTo>
                    <a:lnTo>
                      <a:pt x="3077" y="81"/>
                    </a:lnTo>
                    <a:lnTo>
                      <a:pt x="3090" y="79"/>
                    </a:lnTo>
                    <a:lnTo>
                      <a:pt x="3103" y="76"/>
                    </a:lnTo>
                    <a:lnTo>
                      <a:pt x="3116" y="72"/>
                    </a:lnTo>
                    <a:lnTo>
                      <a:pt x="3128" y="76"/>
                    </a:lnTo>
                    <a:lnTo>
                      <a:pt x="3141" y="77"/>
                    </a:lnTo>
                    <a:lnTo>
                      <a:pt x="3154" y="76"/>
                    </a:lnTo>
                    <a:lnTo>
                      <a:pt x="3167" y="77"/>
                    </a:lnTo>
                    <a:lnTo>
                      <a:pt x="3180" y="81"/>
                    </a:lnTo>
                    <a:lnTo>
                      <a:pt x="3193" y="84"/>
                    </a:lnTo>
                    <a:lnTo>
                      <a:pt x="3205" y="84"/>
                    </a:lnTo>
                    <a:lnTo>
                      <a:pt x="3218" y="76"/>
                    </a:lnTo>
                    <a:lnTo>
                      <a:pt x="3231" y="83"/>
                    </a:lnTo>
                    <a:lnTo>
                      <a:pt x="3244" y="81"/>
                    </a:lnTo>
                    <a:lnTo>
                      <a:pt x="3257" y="86"/>
                    </a:lnTo>
                    <a:lnTo>
                      <a:pt x="3270" y="83"/>
                    </a:lnTo>
                    <a:lnTo>
                      <a:pt x="3282" y="84"/>
                    </a:lnTo>
                    <a:lnTo>
                      <a:pt x="3295" y="88"/>
                    </a:lnTo>
                    <a:lnTo>
                      <a:pt x="3308" y="85"/>
                    </a:lnTo>
                    <a:lnTo>
                      <a:pt x="3321" y="91"/>
                    </a:lnTo>
                    <a:lnTo>
                      <a:pt x="3334" y="94"/>
                    </a:lnTo>
                    <a:lnTo>
                      <a:pt x="3347" y="101"/>
                    </a:lnTo>
                    <a:lnTo>
                      <a:pt x="3359" y="102"/>
                    </a:lnTo>
                    <a:lnTo>
                      <a:pt x="3372" y="106"/>
                    </a:lnTo>
                    <a:lnTo>
                      <a:pt x="3385" y="106"/>
                    </a:lnTo>
                    <a:lnTo>
                      <a:pt x="3398" y="121"/>
                    </a:lnTo>
                    <a:lnTo>
                      <a:pt x="3411" y="129"/>
                    </a:lnTo>
                    <a:lnTo>
                      <a:pt x="3424" y="128"/>
                    </a:lnTo>
                    <a:lnTo>
                      <a:pt x="3436" y="136"/>
                    </a:lnTo>
                    <a:lnTo>
                      <a:pt x="3449" y="153"/>
                    </a:lnTo>
                    <a:lnTo>
                      <a:pt x="3462" y="158"/>
                    </a:lnTo>
                    <a:lnTo>
                      <a:pt x="3475" y="160"/>
                    </a:lnTo>
                    <a:lnTo>
                      <a:pt x="3488" y="163"/>
                    </a:lnTo>
                    <a:lnTo>
                      <a:pt x="3501" y="174"/>
                    </a:lnTo>
                    <a:lnTo>
                      <a:pt x="3513" y="176"/>
                    </a:lnTo>
                    <a:lnTo>
                      <a:pt x="3526" y="194"/>
                    </a:lnTo>
                    <a:lnTo>
                      <a:pt x="3539" y="213"/>
                    </a:lnTo>
                    <a:lnTo>
                      <a:pt x="3552" y="225"/>
                    </a:lnTo>
                    <a:lnTo>
                      <a:pt x="3565" y="236"/>
                    </a:lnTo>
                    <a:lnTo>
                      <a:pt x="3578" y="246"/>
                    </a:lnTo>
                    <a:lnTo>
                      <a:pt x="3590" y="242"/>
                    </a:lnTo>
                    <a:lnTo>
                      <a:pt x="3603" y="241"/>
                    </a:lnTo>
                    <a:lnTo>
                      <a:pt x="3616" y="224"/>
                    </a:lnTo>
                    <a:lnTo>
                      <a:pt x="3629" y="213"/>
                    </a:lnTo>
                    <a:lnTo>
                      <a:pt x="3642" y="194"/>
                    </a:lnTo>
                    <a:lnTo>
                      <a:pt x="3655" y="181"/>
                    </a:lnTo>
                    <a:lnTo>
                      <a:pt x="3667" y="161"/>
                    </a:lnTo>
                    <a:lnTo>
                      <a:pt x="3680" y="158"/>
                    </a:lnTo>
                    <a:lnTo>
                      <a:pt x="3693" y="153"/>
                    </a:lnTo>
                    <a:lnTo>
                      <a:pt x="3706" y="154"/>
                    </a:lnTo>
                    <a:lnTo>
                      <a:pt x="3719" y="131"/>
                    </a:lnTo>
                    <a:lnTo>
                      <a:pt x="3732" y="132"/>
                    </a:lnTo>
                    <a:lnTo>
                      <a:pt x="3744" y="133"/>
                    </a:lnTo>
                    <a:lnTo>
                      <a:pt x="3757" y="119"/>
                    </a:lnTo>
                    <a:lnTo>
                      <a:pt x="3770" y="121"/>
                    </a:lnTo>
                    <a:lnTo>
                      <a:pt x="3783" y="116"/>
                    </a:lnTo>
                    <a:lnTo>
                      <a:pt x="3796" y="110"/>
                    </a:lnTo>
                    <a:lnTo>
                      <a:pt x="3808" y="110"/>
                    </a:lnTo>
                    <a:lnTo>
                      <a:pt x="3821" y="107"/>
                    </a:lnTo>
                    <a:lnTo>
                      <a:pt x="3834" y="111"/>
                    </a:lnTo>
                    <a:lnTo>
                      <a:pt x="3847" y="102"/>
                    </a:lnTo>
                    <a:lnTo>
                      <a:pt x="3860" y="97"/>
                    </a:lnTo>
                    <a:lnTo>
                      <a:pt x="3873" y="97"/>
                    </a:lnTo>
                    <a:lnTo>
                      <a:pt x="3885" y="96"/>
                    </a:lnTo>
                    <a:lnTo>
                      <a:pt x="3898" y="95"/>
                    </a:lnTo>
                    <a:lnTo>
                      <a:pt x="3911" y="96"/>
                    </a:lnTo>
                    <a:lnTo>
                      <a:pt x="3924" y="90"/>
                    </a:lnTo>
                    <a:lnTo>
                      <a:pt x="3937" y="95"/>
                    </a:lnTo>
                    <a:lnTo>
                      <a:pt x="3950" y="95"/>
                    </a:lnTo>
                    <a:lnTo>
                      <a:pt x="3962" y="101"/>
                    </a:lnTo>
                    <a:lnTo>
                      <a:pt x="3975" y="92"/>
                    </a:lnTo>
                    <a:lnTo>
                      <a:pt x="3988" y="95"/>
                    </a:lnTo>
                    <a:lnTo>
                      <a:pt x="4001" y="100"/>
                    </a:lnTo>
                    <a:lnTo>
                      <a:pt x="4014" y="100"/>
                    </a:lnTo>
                    <a:lnTo>
                      <a:pt x="4027" y="99"/>
                    </a:lnTo>
                    <a:lnTo>
                      <a:pt x="4039" y="96"/>
                    </a:lnTo>
                    <a:lnTo>
                      <a:pt x="4052" y="97"/>
                    </a:lnTo>
                    <a:lnTo>
                      <a:pt x="4065" y="103"/>
                    </a:lnTo>
                    <a:lnTo>
                      <a:pt x="4078" y="100"/>
                    </a:lnTo>
                    <a:lnTo>
                      <a:pt x="4091" y="96"/>
                    </a:lnTo>
                    <a:lnTo>
                      <a:pt x="4104" y="87"/>
                    </a:lnTo>
                    <a:lnTo>
                      <a:pt x="4116" y="85"/>
                    </a:lnTo>
                    <a:lnTo>
                      <a:pt x="4129" y="85"/>
                    </a:lnTo>
                    <a:lnTo>
                      <a:pt x="4142" y="83"/>
                    </a:lnTo>
                    <a:lnTo>
                      <a:pt x="4155" y="76"/>
                    </a:lnTo>
                    <a:lnTo>
                      <a:pt x="4168" y="78"/>
                    </a:lnTo>
                    <a:lnTo>
                      <a:pt x="4181" y="75"/>
                    </a:lnTo>
                    <a:lnTo>
                      <a:pt x="4193" y="86"/>
                    </a:lnTo>
                    <a:lnTo>
                      <a:pt x="4206" y="85"/>
                    </a:lnTo>
                    <a:lnTo>
                      <a:pt x="4219" y="80"/>
                    </a:lnTo>
                    <a:lnTo>
                      <a:pt x="4232" y="76"/>
                    </a:lnTo>
                    <a:lnTo>
                      <a:pt x="4245" y="77"/>
                    </a:lnTo>
                    <a:lnTo>
                      <a:pt x="4258" y="79"/>
                    </a:lnTo>
                    <a:lnTo>
                      <a:pt x="4270" y="74"/>
                    </a:lnTo>
                    <a:lnTo>
                      <a:pt x="4283" y="79"/>
                    </a:lnTo>
                    <a:lnTo>
                      <a:pt x="4296" y="87"/>
                    </a:lnTo>
                    <a:lnTo>
                      <a:pt x="4309" y="74"/>
                    </a:lnTo>
                    <a:lnTo>
                      <a:pt x="4322" y="78"/>
                    </a:lnTo>
                    <a:lnTo>
                      <a:pt x="4335" y="75"/>
                    </a:lnTo>
                    <a:lnTo>
                      <a:pt x="4347" y="74"/>
                    </a:lnTo>
                    <a:lnTo>
                      <a:pt x="4360" y="70"/>
                    </a:lnTo>
                    <a:lnTo>
                      <a:pt x="4373" y="69"/>
                    </a:lnTo>
                    <a:lnTo>
                      <a:pt x="4386" y="65"/>
                    </a:lnTo>
                    <a:lnTo>
                      <a:pt x="4399" y="70"/>
                    </a:lnTo>
                    <a:lnTo>
                      <a:pt x="4412" y="74"/>
                    </a:lnTo>
                    <a:lnTo>
                      <a:pt x="4424" y="74"/>
                    </a:lnTo>
                    <a:lnTo>
                      <a:pt x="4437" y="73"/>
                    </a:lnTo>
                    <a:lnTo>
                      <a:pt x="4450" y="76"/>
                    </a:lnTo>
                    <a:lnTo>
                      <a:pt x="4463" y="71"/>
                    </a:lnTo>
                    <a:lnTo>
                      <a:pt x="4476" y="80"/>
                    </a:lnTo>
                    <a:lnTo>
                      <a:pt x="4489" y="88"/>
                    </a:lnTo>
                    <a:lnTo>
                      <a:pt x="4501" y="81"/>
                    </a:lnTo>
                    <a:lnTo>
                      <a:pt x="4514" y="77"/>
                    </a:lnTo>
                    <a:lnTo>
                      <a:pt x="4527" y="84"/>
                    </a:lnTo>
                    <a:lnTo>
                      <a:pt x="4540" y="81"/>
                    </a:lnTo>
                    <a:lnTo>
                      <a:pt x="4553" y="85"/>
                    </a:lnTo>
                    <a:lnTo>
                      <a:pt x="4566" y="91"/>
                    </a:lnTo>
                    <a:lnTo>
                      <a:pt x="4578" y="89"/>
                    </a:lnTo>
                    <a:lnTo>
                      <a:pt x="4591" y="84"/>
                    </a:lnTo>
                    <a:lnTo>
                      <a:pt x="4604" y="87"/>
                    </a:lnTo>
                    <a:lnTo>
                      <a:pt x="4617" y="89"/>
                    </a:lnTo>
                    <a:lnTo>
                      <a:pt x="4630" y="78"/>
                    </a:lnTo>
                    <a:lnTo>
                      <a:pt x="4642" y="83"/>
                    </a:lnTo>
                    <a:lnTo>
                      <a:pt x="4655" y="84"/>
                    </a:lnTo>
                    <a:lnTo>
                      <a:pt x="4668" y="83"/>
                    </a:lnTo>
                    <a:lnTo>
                      <a:pt x="4681" y="80"/>
                    </a:lnTo>
                    <a:lnTo>
                      <a:pt x="4694" y="75"/>
                    </a:lnTo>
                    <a:lnTo>
                      <a:pt x="4707" y="80"/>
                    </a:lnTo>
                    <a:lnTo>
                      <a:pt x="4719" y="75"/>
                    </a:lnTo>
                    <a:lnTo>
                      <a:pt x="4732" y="80"/>
                    </a:lnTo>
                    <a:lnTo>
                      <a:pt x="4745" y="83"/>
                    </a:lnTo>
                    <a:lnTo>
                      <a:pt x="4758" y="77"/>
                    </a:lnTo>
                    <a:lnTo>
                      <a:pt x="4771" y="81"/>
                    </a:lnTo>
                    <a:lnTo>
                      <a:pt x="4784" y="89"/>
                    </a:lnTo>
                    <a:lnTo>
                      <a:pt x="4796" y="83"/>
                    </a:lnTo>
                    <a:lnTo>
                      <a:pt x="4809" y="89"/>
                    </a:lnTo>
                    <a:lnTo>
                      <a:pt x="4822" y="90"/>
                    </a:lnTo>
                    <a:lnTo>
                      <a:pt x="4835" y="87"/>
                    </a:lnTo>
                    <a:lnTo>
                      <a:pt x="4848" y="99"/>
                    </a:lnTo>
                    <a:lnTo>
                      <a:pt x="4861" y="104"/>
                    </a:lnTo>
                    <a:lnTo>
                      <a:pt x="4873" y="101"/>
                    </a:lnTo>
                    <a:lnTo>
                      <a:pt x="4886" y="107"/>
                    </a:lnTo>
                    <a:lnTo>
                      <a:pt x="4899" y="109"/>
                    </a:lnTo>
                    <a:lnTo>
                      <a:pt x="4912" y="116"/>
                    </a:lnTo>
                    <a:lnTo>
                      <a:pt x="4925" y="117"/>
                    </a:lnTo>
                    <a:lnTo>
                      <a:pt x="4938" y="132"/>
                    </a:lnTo>
                    <a:lnTo>
                      <a:pt x="4950" y="120"/>
                    </a:lnTo>
                    <a:lnTo>
                      <a:pt x="4963" y="127"/>
                    </a:lnTo>
                    <a:lnTo>
                      <a:pt x="4976" y="124"/>
                    </a:lnTo>
                    <a:lnTo>
                      <a:pt x="4989" y="128"/>
                    </a:lnTo>
                    <a:lnTo>
                      <a:pt x="5002" y="120"/>
                    </a:lnTo>
                    <a:lnTo>
                      <a:pt x="5015" y="126"/>
                    </a:lnTo>
                    <a:lnTo>
                      <a:pt x="5027" y="124"/>
                    </a:lnTo>
                    <a:lnTo>
                      <a:pt x="5040" y="120"/>
                    </a:lnTo>
                    <a:lnTo>
                      <a:pt x="5053" y="116"/>
                    </a:lnTo>
                    <a:lnTo>
                      <a:pt x="5066" y="125"/>
                    </a:lnTo>
                    <a:lnTo>
                      <a:pt x="5079" y="118"/>
                    </a:lnTo>
                    <a:lnTo>
                      <a:pt x="5092" y="126"/>
                    </a:lnTo>
                    <a:lnTo>
                      <a:pt x="5104" y="126"/>
                    </a:lnTo>
                    <a:lnTo>
                      <a:pt x="5117" y="128"/>
                    </a:lnTo>
                    <a:lnTo>
                      <a:pt x="5130" y="138"/>
                    </a:lnTo>
                    <a:lnTo>
                      <a:pt x="5143" y="151"/>
                    </a:lnTo>
                    <a:lnTo>
                      <a:pt x="5156" y="171"/>
                    </a:lnTo>
                    <a:lnTo>
                      <a:pt x="5169" y="194"/>
                    </a:lnTo>
                    <a:lnTo>
                      <a:pt x="5181" y="236"/>
                    </a:lnTo>
                    <a:lnTo>
                      <a:pt x="5194" y="267"/>
                    </a:lnTo>
                    <a:lnTo>
                      <a:pt x="5207" y="280"/>
                    </a:lnTo>
                    <a:lnTo>
                      <a:pt x="5220" y="296"/>
                    </a:lnTo>
                    <a:lnTo>
                      <a:pt x="5233" y="307"/>
                    </a:lnTo>
                    <a:lnTo>
                      <a:pt x="5246" y="314"/>
                    </a:lnTo>
                    <a:lnTo>
                      <a:pt x="5258" y="300"/>
                    </a:lnTo>
                    <a:lnTo>
                      <a:pt x="5271" y="296"/>
                    </a:lnTo>
                    <a:lnTo>
                      <a:pt x="5284" y="292"/>
                    </a:lnTo>
                    <a:lnTo>
                      <a:pt x="5297" y="287"/>
                    </a:lnTo>
                    <a:lnTo>
                      <a:pt x="5310" y="278"/>
                    </a:lnTo>
                    <a:lnTo>
                      <a:pt x="5323" y="264"/>
                    </a:lnTo>
                    <a:lnTo>
                      <a:pt x="5335" y="265"/>
                    </a:lnTo>
                    <a:lnTo>
                      <a:pt x="5348" y="266"/>
                    </a:lnTo>
                    <a:lnTo>
                      <a:pt x="5361" y="263"/>
                    </a:lnTo>
                    <a:lnTo>
                      <a:pt x="5374" y="282"/>
                    </a:lnTo>
                    <a:lnTo>
                      <a:pt x="5387" y="289"/>
                    </a:lnTo>
                    <a:lnTo>
                      <a:pt x="5400" y="285"/>
                    </a:lnTo>
                    <a:lnTo>
                      <a:pt x="5412" y="283"/>
                    </a:lnTo>
                    <a:lnTo>
                      <a:pt x="5425" y="275"/>
                    </a:lnTo>
                    <a:lnTo>
                      <a:pt x="5438" y="256"/>
                    </a:lnTo>
                    <a:lnTo>
                      <a:pt x="5451" y="235"/>
                    </a:lnTo>
                    <a:lnTo>
                      <a:pt x="5464" y="224"/>
                    </a:lnTo>
                    <a:lnTo>
                      <a:pt x="5476" y="220"/>
                    </a:lnTo>
                    <a:lnTo>
                      <a:pt x="5489" y="212"/>
                    </a:lnTo>
                    <a:lnTo>
                      <a:pt x="5502" y="202"/>
                    </a:lnTo>
                    <a:lnTo>
                      <a:pt x="5515" y="196"/>
                    </a:lnTo>
                    <a:lnTo>
                      <a:pt x="5528" y="180"/>
                    </a:lnTo>
                    <a:lnTo>
                      <a:pt x="5541" y="175"/>
                    </a:lnTo>
                    <a:lnTo>
                      <a:pt x="5553" y="158"/>
                    </a:lnTo>
                    <a:lnTo>
                      <a:pt x="5566" y="156"/>
                    </a:lnTo>
                    <a:lnTo>
                      <a:pt x="5579" y="151"/>
                    </a:lnTo>
                    <a:lnTo>
                      <a:pt x="5592" y="145"/>
                    </a:lnTo>
                    <a:lnTo>
                      <a:pt x="5605" y="135"/>
                    </a:lnTo>
                    <a:lnTo>
                      <a:pt x="5618" y="138"/>
                    </a:lnTo>
                    <a:lnTo>
                      <a:pt x="5630" y="134"/>
                    </a:lnTo>
                    <a:lnTo>
                      <a:pt x="5643" y="131"/>
                    </a:lnTo>
                    <a:lnTo>
                      <a:pt x="5656" y="129"/>
                    </a:lnTo>
                    <a:lnTo>
                      <a:pt x="5669" y="139"/>
                    </a:lnTo>
                    <a:lnTo>
                      <a:pt x="5682" y="141"/>
                    </a:lnTo>
                    <a:lnTo>
                      <a:pt x="5695" y="143"/>
                    </a:lnTo>
                    <a:lnTo>
                      <a:pt x="5707" y="143"/>
                    </a:lnTo>
                    <a:lnTo>
                      <a:pt x="5720" y="145"/>
                    </a:lnTo>
                    <a:lnTo>
                      <a:pt x="5733" y="148"/>
                    </a:lnTo>
                    <a:lnTo>
                      <a:pt x="5746" y="143"/>
                    </a:lnTo>
                    <a:lnTo>
                      <a:pt x="5759" y="148"/>
                    </a:lnTo>
                    <a:lnTo>
                      <a:pt x="5772" y="145"/>
                    </a:lnTo>
                    <a:lnTo>
                      <a:pt x="5784" y="145"/>
                    </a:lnTo>
                    <a:lnTo>
                      <a:pt x="5797" y="136"/>
                    </a:lnTo>
                    <a:lnTo>
                      <a:pt x="5810" y="134"/>
                    </a:lnTo>
                    <a:lnTo>
                      <a:pt x="5823" y="134"/>
                    </a:lnTo>
                    <a:lnTo>
                      <a:pt x="5836" y="122"/>
                    </a:lnTo>
                    <a:lnTo>
                      <a:pt x="5849" y="130"/>
                    </a:lnTo>
                    <a:lnTo>
                      <a:pt x="5861" y="119"/>
                    </a:lnTo>
                    <a:lnTo>
                      <a:pt x="5874" y="120"/>
                    </a:lnTo>
                    <a:lnTo>
                      <a:pt x="5887" y="107"/>
                    </a:lnTo>
                    <a:lnTo>
                      <a:pt x="5900" y="118"/>
                    </a:lnTo>
                    <a:lnTo>
                      <a:pt x="5913" y="122"/>
                    </a:lnTo>
                    <a:lnTo>
                      <a:pt x="5926" y="117"/>
                    </a:lnTo>
                    <a:lnTo>
                      <a:pt x="5938" y="123"/>
                    </a:lnTo>
                    <a:lnTo>
                      <a:pt x="5951" y="121"/>
                    </a:lnTo>
                    <a:lnTo>
                      <a:pt x="5964" y="114"/>
                    </a:lnTo>
                    <a:lnTo>
                      <a:pt x="5977" y="124"/>
                    </a:lnTo>
                    <a:lnTo>
                      <a:pt x="5990" y="129"/>
                    </a:lnTo>
                    <a:lnTo>
                      <a:pt x="6003" y="140"/>
                    </a:lnTo>
                    <a:lnTo>
                      <a:pt x="6015" y="141"/>
                    </a:lnTo>
                    <a:lnTo>
                      <a:pt x="6028" y="155"/>
                    </a:lnTo>
                    <a:lnTo>
                      <a:pt x="6041" y="168"/>
                    </a:lnTo>
                    <a:lnTo>
                      <a:pt x="6054" y="177"/>
                    </a:lnTo>
                    <a:lnTo>
                      <a:pt x="6067" y="191"/>
                    </a:lnTo>
                    <a:lnTo>
                      <a:pt x="6080" y="217"/>
                    </a:lnTo>
                    <a:lnTo>
                      <a:pt x="6092" y="249"/>
                    </a:lnTo>
                    <a:lnTo>
                      <a:pt x="6105" y="264"/>
                    </a:lnTo>
                    <a:lnTo>
                      <a:pt x="6118" y="264"/>
                    </a:lnTo>
                    <a:lnTo>
                      <a:pt x="6131" y="276"/>
                    </a:lnTo>
                    <a:lnTo>
                      <a:pt x="6144" y="295"/>
                    </a:lnTo>
                    <a:lnTo>
                      <a:pt x="6157" y="313"/>
                    </a:lnTo>
                    <a:lnTo>
                      <a:pt x="6169" y="357"/>
                    </a:lnTo>
                    <a:lnTo>
                      <a:pt x="6182" y="391"/>
                    </a:lnTo>
                    <a:lnTo>
                      <a:pt x="6195" y="416"/>
                    </a:lnTo>
                    <a:lnTo>
                      <a:pt x="6208" y="403"/>
                    </a:lnTo>
                    <a:lnTo>
                      <a:pt x="6221" y="394"/>
                    </a:lnTo>
                    <a:lnTo>
                      <a:pt x="6234" y="373"/>
                    </a:lnTo>
                    <a:lnTo>
                      <a:pt x="6246" y="372"/>
                    </a:lnTo>
                    <a:lnTo>
                      <a:pt x="6259" y="370"/>
                    </a:lnTo>
                    <a:lnTo>
                      <a:pt x="6272" y="372"/>
                    </a:lnTo>
                    <a:lnTo>
                      <a:pt x="6285" y="350"/>
                    </a:lnTo>
                    <a:lnTo>
                      <a:pt x="6298" y="368"/>
                    </a:lnTo>
                    <a:lnTo>
                      <a:pt x="6310" y="373"/>
                    </a:lnTo>
                    <a:lnTo>
                      <a:pt x="6323" y="421"/>
                    </a:lnTo>
                    <a:lnTo>
                      <a:pt x="6336" y="488"/>
                    </a:lnTo>
                    <a:lnTo>
                      <a:pt x="6349" y="545"/>
                    </a:lnTo>
                    <a:lnTo>
                      <a:pt x="6362" y="618"/>
                    </a:lnTo>
                    <a:lnTo>
                      <a:pt x="6375" y="695"/>
                    </a:lnTo>
                    <a:lnTo>
                      <a:pt x="6387" y="771"/>
                    </a:lnTo>
                    <a:lnTo>
                      <a:pt x="6400" y="900"/>
                    </a:lnTo>
                    <a:lnTo>
                      <a:pt x="6413" y="1038"/>
                    </a:lnTo>
                    <a:lnTo>
                      <a:pt x="6426" y="1195"/>
                    </a:lnTo>
                    <a:lnTo>
                      <a:pt x="6439" y="1283"/>
                    </a:lnTo>
                    <a:lnTo>
                      <a:pt x="6452" y="1339"/>
                    </a:lnTo>
                    <a:lnTo>
                      <a:pt x="6464" y="1306"/>
                    </a:lnTo>
                    <a:lnTo>
                      <a:pt x="6477" y="1183"/>
                    </a:lnTo>
                    <a:lnTo>
                      <a:pt x="6490" y="1048"/>
                    </a:lnTo>
                    <a:lnTo>
                      <a:pt x="6503" y="902"/>
                    </a:lnTo>
                    <a:lnTo>
                      <a:pt x="6516" y="771"/>
                    </a:lnTo>
                    <a:lnTo>
                      <a:pt x="6529" y="663"/>
                    </a:lnTo>
                    <a:lnTo>
                      <a:pt x="6541" y="605"/>
                    </a:lnTo>
                    <a:lnTo>
                      <a:pt x="6554" y="545"/>
                    </a:lnTo>
                    <a:lnTo>
                      <a:pt x="6567" y="489"/>
                    </a:lnTo>
                    <a:lnTo>
                      <a:pt x="6580" y="457"/>
                    </a:lnTo>
                    <a:lnTo>
                      <a:pt x="6593" y="449"/>
                    </a:lnTo>
                    <a:lnTo>
                      <a:pt x="6606" y="442"/>
                    </a:lnTo>
                    <a:lnTo>
                      <a:pt x="6618" y="439"/>
                    </a:lnTo>
                    <a:lnTo>
                      <a:pt x="6631" y="429"/>
                    </a:lnTo>
                    <a:lnTo>
                      <a:pt x="6644" y="401"/>
                    </a:lnTo>
                    <a:lnTo>
                      <a:pt x="6657" y="401"/>
                    </a:lnTo>
                    <a:lnTo>
                      <a:pt x="6670" y="387"/>
                    </a:lnTo>
                    <a:lnTo>
                      <a:pt x="6683" y="370"/>
                    </a:lnTo>
                    <a:lnTo>
                      <a:pt x="6695" y="366"/>
                    </a:lnTo>
                    <a:lnTo>
                      <a:pt x="6708" y="370"/>
                    </a:lnTo>
                    <a:lnTo>
                      <a:pt x="6721" y="377"/>
                    </a:lnTo>
                    <a:lnTo>
                      <a:pt x="6734" y="378"/>
                    </a:lnTo>
                    <a:lnTo>
                      <a:pt x="6747" y="387"/>
                    </a:lnTo>
                    <a:lnTo>
                      <a:pt x="6760" y="373"/>
                    </a:lnTo>
                    <a:lnTo>
                      <a:pt x="6772" y="374"/>
                    </a:lnTo>
                    <a:lnTo>
                      <a:pt x="6785" y="363"/>
                    </a:lnTo>
                    <a:lnTo>
                      <a:pt x="6798" y="353"/>
                    </a:lnTo>
                    <a:lnTo>
                      <a:pt x="6811" y="359"/>
                    </a:lnTo>
                    <a:lnTo>
                      <a:pt x="6824" y="353"/>
                    </a:lnTo>
                    <a:lnTo>
                      <a:pt x="6837" y="358"/>
                    </a:lnTo>
                    <a:lnTo>
                      <a:pt x="6849" y="369"/>
                    </a:lnTo>
                    <a:lnTo>
                      <a:pt x="6862" y="360"/>
                    </a:lnTo>
                    <a:lnTo>
                      <a:pt x="6875" y="359"/>
                    </a:lnTo>
                    <a:lnTo>
                      <a:pt x="6888" y="343"/>
                    </a:lnTo>
                    <a:lnTo>
                      <a:pt x="6901" y="352"/>
                    </a:lnTo>
                    <a:lnTo>
                      <a:pt x="6914" y="333"/>
                    </a:lnTo>
                    <a:lnTo>
                      <a:pt x="6926" y="341"/>
                    </a:lnTo>
                    <a:lnTo>
                      <a:pt x="6939" y="323"/>
                    </a:lnTo>
                    <a:lnTo>
                      <a:pt x="6952" y="322"/>
                    </a:lnTo>
                    <a:lnTo>
                      <a:pt x="6965" y="317"/>
                    </a:lnTo>
                    <a:lnTo>
                      <a:pt x="6978" y="308"/>
                    </a:lnTo>
                    <a:lnTo>
                      <a:pt x="6991" y="297"/>
                    </a:lnTo>
                    <a:lnTo>
                      <a:pt x="7003" y="306"/>
                    </a:lnTo>
                    <a:lnTo>
                      <a:pt x="7016" y="303"/>
                    </a:lnTo>
                    <a:lnTo>
                      <a:pt x="7029" y="324"/>
                    </a:lnTo>
                    <a:lnTo>
                      <a:pt x="7042" y="355"/>
                    </a:lnTo>
                    <a:lnTo>
                      <a:pt x="7055" y="433"/>
                    </a:lnTo>
                    <a:lnTo>
                      <a:pt x="7067" y="503"/>
                    </a:lnTo>
                    <a:lnTo>
                      <a:pt x="7080" y="586"/>
                    </a:lnTo>
                    <a:lnTo>
                      <a:pt x="7093" y="650"/>
                    </a:lnTo>
                    <a:lnTo>
                      <a:pt x="7106" y="678"/>
                    </a:lnTo>
                    <a:lnTo>
                      <a:pt x="7119" y="668"/>
                    </a:lnTo>
                    <a:lnTo>
                      <a:pt x="7132" y="627"/>
                    </a:lnTo>
                    <a:lnTo>
                      <a:pt x="7144" y="578"/>
                    </a:lnTo>
                    <a:lnTo>
                      <a:pt x="7157" y="516"/>
                    </a:lnTo>
                    <a:lnTo>
                      <a:pt x="7170" y="454"/>
                    </a:lnTo>
                    <a:lnTo>
                      <a:pt x="7183" y="421"/>
                    </a:lnTo>
                    <a:lnTo>
                      <a:pt x="7196" y="372"/>
                    </a:lnTo>
                    <a:lnTo>
                      <a:pt x="7209" y="345"/>
                    </a:lnTo>
                    <a:lnTo>
                      <a:pt x="7221" y="317"/>
                    </a:lnTo>
                    <a:lnTo>
                      <a:pt x="7234" y="306"/>
                    </a:lnTo>
                    <a:lnTo>
                      <a:pt x="7247" y="294"/>
                    </a:lnTo>
                    <a:lnTo>
                      <a:pt x="7260" y="282"/>
                    </a:lnTo>
                    <a:lnTo>
                      <a:pt x="7273" y="282"/>
                    </a:lnTo>
                    <a:lnTo>
                      <a:pt x="7286" y="275"/>
                    </a:lnTo>
                    <a:lnTo>
                      <a:pt x="7298" y="280"/>
                    </a:lnTo>
                    <a:lnTo>
                      <a:pt x="7311" y="281"/>
                    </a:lnTo>
                    <a:lnTo>
                      <a:pt x="7324" y="284"/>
                    </a:lnTo>
                    <a:lnTo>
                      <a:pt x="7337" y="305"/>
                    </a:lnTo>
                    <a:lnTo>
                      <a:pt x="7350" y="319"/>
                    </a:lnTo>
                    <a:lnTo>
                      <a:pt x="7363" y="323"/>
                    </a:lnTo>
                    <a:lnTo>
                      <a:pt x="7375" y="338"/>
                    </a:lnTo>
                    <a:lnTo>
                      <a:pt x="7388" y="334"/>
                    </a:lnTo>
                    <a:lnTo>
                      <a:pt x="7401" y="356"/>
                    </a:lnTo>
                    <a:lnTo>
                      <a:pt x="7414" y="379"/>
                    </a:lnTo>
                    <a:lnTo>
                      <a:pt x="7427" y="411"/>
                    </a:lnTo>
                    <a:lnTo>
                      <a:pt x="7440" y="422"/>
                    </a:lnTo>
                    <a:lnTo>
                      <a:pt x="7452" y="411"/>
                    </a:lnTo>
                    <a:lnTo>
                      <a:pt x="7465" y="378"/>
                    </a:lnTo>
                    <a:lnTo>
                      <a:pt x="7478" y="350"/>
                    </a:lnTo>
                    <a:lnTo>
                      <a:pt x="7491" y="333"/>
                    </a:lnTo>
                    <a:lnTo>
                      <a:pt x="7504" y="304"/>
                    </a:lnTo>
                    <a:lnTo>
                      <a:pt x="7517" y="285"/>
                    </a:lnTo>
                    <a:lnTo>
                      <a:pt x="7529" y="269"/>
                    </a:lnTo>
                    <a:lnTo>
                      <a:pt x="7542" y="256"/>
                    </a:lnTo>
                    <a:lnTo>
                      <a:pt x="7555" y="234"/>
                    </a:lnTo>
                    <a:lnTo>
                      <a:pt x="7568" y="224"/>
                    </a:lnTo>
                    <a:lnTo>
                      <a:pt x="7581" y="222"/>
                    </a:lnTo>
                    <a:lnTo>
                      <a:pt x="7594" y="213"/>
                    </a:lnTo>
                    <a:lnTo>
                      <a:pt x="7606" y="205"/>
                    </a:lnTo>
                    <a:lnTo>
                      <a:pt x="7619" y="207"/>
                    </a:lnTo>
                    <a:lnTo>
                      <a:pt x="7632" y="217"/>
                    </a:lnTo>
                    <a:lnTo>
                      <a:pt x="7645" y="206"/>
                    </a:lnTo>
                    <a:lnTo>
                      <a:pt x="7658" y="211"/>
                    </a:lnTo>
                    <a:lnTo>
                      <a:pt x="7671" y="226"/>
                    </a:lnTo>
                    <a:lnTo>
                      <a:pt x="7683" y="244"/>
                    </a:lnTo>
                    <a:lnTo>
                      <a:pt x="7696" y="243"/>
                    </a:lnTo>
                    <a:lnTo>
                      <a:pt x="7709" y="244"/>
                    </a:lnTo>
                    <a:lnTo>
                      <a:pt x="7722" y="249"/>
                    </a:lnTo>
                    <a:lnTo>
                      <a:pt x="7735" y="254"/>
                    </a:lnTo>
                    <a:lnTo>
                      <a:pt x="7748" y="248"/>
                    </a:lnTo>
                    <a:lnTo>
                      <a:pt x="7760" y="261"/>
                    </a:lnTo>
                    <a:lnTo>
                      <a:pt x="7773" y="255"/>
                    </a:lnTo>
                    <a:lnTo>
                      <a:pt x="7786" y="252"/>
                    </a:lnTo>
                    <a:lnTo>
                      <a:pt x="7799" y="234"/>
                    </a:lnTo>
                    <a:lnTo>
                      <a:pt x="7812" y="237"/>
                    </a:lnTo>
                    <a:lnTo>
                      <a:pt x="7825" y="224"/>
                    </a:lnTo>
                    <a:lnTo>
                      <a:pt x="7837" y="223"/>
                    </a:lnTo>
                    <a:lnTo>
                      <a:pt x="7850" y="222"/>
                    </a:lnTo>
                    <a:lnTo>
                      <a:pt x="7863" y="234"/>
                    </a:lnTo>
                    <a:lnTo>
                      <a:pt x="7876" y="232"/>
                    </a:lnTo>
                    <a:lnTo>
                      <a:pt x="7889" y="227"/>
                    </a:lnTo>
                    <a:lnTo>
                      <a:pt x="7901" y="238"/>
                    </a:lnTo>
                    <a:lnTo>
                      <a:pt x="7914" y="238"/>
                    </a:lnTo>
                    <a:lnTo>
                      <a:pt x="7927" y="241"/>
                    </a:lnTo>
                    <a:lnTo>
                      <a:pt x="7940" y="252"/>
                    </a:lnTo>
                    <a:lnTo>
                      <a:pt x="7953" y="261"/>
                    </a:lnTo>
                    <a:lnTo>
                      <a:pt x="7966" y="272"/>
                    </a:lnTo>
                    <a:lnTo>
                      <a:pt x="7978" y="279"/>
                    </a:lnTo>
                    <a:lnTo>
                      <a:pt x="7991" y="275"/>
                    </a:lnTo>
                    <a:lnTo>
                      <a:pt x="8004" y="259"/>
                    </a:lnTo>
                    <a:lnTo>
                      <a:pt x="8017" y="261"/>
                    </a:lnTo>
                    <a:lnTo>
                      <a:pt x="8030" y="249"/>
                    </a:lnTo>
                    <a:lnTo>
                      <a:pt x="8043" y="263"/>
                    </a:lnTo>
                    <a:lnTo>
                      <a:pt x="8055" y="246"/>
                    </a:lnTo>
                    <a:lnTo>
                      <a:pt x="8068" y="249"/>
                    </a:lnTo>
                    <a:lnTo>
                      <a:pt x="8081" y="240"/>
                    </a:lnTo>
                    <a:lnTo>
                      <a:pt x="8094" y="243"/>
                    </a:lnTo>
                    <a:lnTo>
                      <a:pt x="8107" y="236"/>
                    </a:lnTo>
                    <a:lnTo>
                      <a:pt x="8120" y="218"/>
                    </a:lnTo>
                    <a:lnTo>
                      <a:pt x="8132" y="222"/>
                    </a:lnTo>
                    <a:lnTo>
                      <a:pt x="8145" y="213"/>
                    </a:lnTo>
                    <a:lnTo>
                      <a:pt x="8158" y="213"/>
                    </a:lnTo>
                    <a:lnTo>
                      <a:pt x="8171" y="208"/>
                    </a:lnTo>
                    <a:lnTo>
                      <a:pt x="8184" y="214"/>
                    </a:lnTo>
                    <a:lnTo>
                      <a:pt x="8197" y="218"/>
                    </a:lnTo>
                    <a:lnTo>
                      <a:pt x="8209" y="216"/>
                    </a:lnTo>
                    <a:lnTo>
                      <a:pt x="8222" y="224"/>
                    </a:lnTo>
                    <a:lnTo>
                      <a:pt x="8235" y="228"/>
                    </a:lnTo>
                    <a:lnTo>
                      <a:pt x="8248" y="238"/>
                    </a:lnTo>
                    <a:lnTo>
                      <a:pt x="8261" y="232"/>
                    </a:lnTo>
                    <a:lnTo>
                      <a:pt x="8274" y="231"/>
                    </a:lnTo>
                    <a:lnTo>
                      <a:pt x="8286" y="239"/>
                    </a:lnTo>
                    <a:lnTo>
                      <a:pt x="8299" y="227"/>
                    </a:lnTo>
                    <a:lnTo>
                      <a:pt x="8312" y="231"/>
                    </a:lnTo>
                    <a:lnTo>
                      <a:pt x="8325" y="236"/>
                    </a:lnTo>
                    <a:lnTo>
                      <a:pt x="8338" y="224"/>
                    </a:lnTo>
                    <a:lnTo>
                      <a:pt x="8351" y="211"/>
                    </a:lnTo>
                    <a:lnTo>
                      <a:pt x="8363" y="207"/>
                    </a:lnTo>
                    <a:lnTo>
                      <a:pt x="8376" y="215"/>
                    </a:lnTo>
                    <a:lnTo>
                      <a:pt x="8389" y="206"/>
                    </a:lnTo>
                    <a:lnTo>
                      <a:pt x="8402" y="205"/>
                    </a:lnTo>
                    <a:lnTo>
                      <a:pt x="8415" y="208"/>
                    </a:lnTo>
                    <a:lnTo>
                      <a:pt x="8428" y="201"/>
                    </a:lnTo>
                    <a:lnTo>
                      <a:pt x="8440" y="195"/>
                    </a:lnTo>
                    <a:lnTo>
                      <a:pt x="8453" y="195"/>
                    </a:lnTo>
                    <a:lnTo>
                      <a:pt x="8466" y="202"/>
                    </a:lnTo>
                    <a:lnTo>
                      <a:pt x="8479" y="194"/>
                    </a:lnTo>
                    <a:lnTo>
                      <a:pt x="8492" y="194"/>
                    </a:lnTo>
                    <a:lnTo>
                      <a:pt x="8505" y="184"/>
                    </a:lnTo>
                    <a:lnTo>
                      <a:pt x="8517" y="175"/>
                    </a:lnTo>
                    <a:lnTo>
                      <a:pt x="8530" y="178"/>
                    </a:lnTo>
                    <a:lnTo>
                      <a:pt x="8543" y="183"/>
                    </a:lnTo>
                    <a:lnTo>
                      <a:pt x="8556" y="183"/>
                    </a:lnTo>
                    <a:lnTo>
                      <a:pt x="8569" y="185"/>
                    </a:lnTo>
                    <a:lnTo>
                      <a:pt x="8582" y="194"/>
                    </a:lnTo>
                    <a:lnTo>
                      <a:pt x="8594" y="197"/>
                    </a:lnTo>
                    <a:lnTo>
                      <a:pt x="8607" y="195"/>
                    </a:lnTo>
                    <a:lnTo>
                      <a:pt x="8620" y="193"/>
                    </a:lnTo>
                    <a:lnTo>
                      <a:pt x="8633" y="196"/>
                    </a:lnTo>
                    <a:lnTo>
                      <a:pt x="8646" y="186"/>
                    </a:lnTo>
                    <a:lnTo>
                      <a:pt x="8659" y="181"/>
                    </a:lnTo>
                    <a:lnTo>
                      <a:pt x="8671" y="179"/>
                    </a:lnTo>
                    <a:lnTo>
                      <a:pt x="8684" y="178"/>
                    </a:lnTo>
                    <a:lnTo>
                      <a:pt x="8697" y="176"/>
                    </a:lnTo>
                    <a:lnTo>
                      <a:pt x="8710" y="185"/>
                    </a:lnTo>
                    <a:lnTo>
                      <a:pt x="8723" y="183"/>
                    </a:lnTo>
                    <a:lnTo>
                      <a:pt x="8735" y="180"/>
                    </a:lnTo>
                    <a:lnTo>
                      <a:pt x="8748" y="188"/>
                    </a:lnTo>
                    <a:lnTo>
                      <a:pt x="8761" y="187"/>
                    </a:lnTo>
                    <a:lnTo>
                      <a:pt x="8774" y="182"/>
                    </a:lnTo>
                    <a:lnTo>
                      <a:pt x="8787" y="175"/>
                    </a:lnTo>
                    <a:lnTo>
                      <a:pt x="8800" y="178"/>
                    </a:lnTo>
                    <a:lnTo>
                      <a:pt x="8812" y="168"/>
                    </a:lnTo>
                    <a:lnTo>
                      <a:pt x="8825" y="181"/>
                    </a:lnTo>
                    <a:lnTo>
                      <a:pt x="8838" y="182"/>
                    </a:lnTo>
                    <a:lnTo>
                      <a:pt x="8851" y="183"/>
                    </a:lnTo>
                    <a:lnTo>
                      <a:pt x="8864" y="177"/>
                    </a:lnTo>
                    <a:lnTo>
                      <a:pt x="8877" y="182"/>
                    </a:lnTo>
                    <a:lnTo>
                      <a:pt x="8889" y="189"/>
                    </a:lnTo>
                    <a:lnTo>
                      <a:pt x="8902" y="191"/>
                    </a:lnTo>
                    <a:lnTo>
                      <a:pt x="8915" y="188"/>
                    </a:lnTo>
                    <a:lnTo>
                      <a:pt x="8928" y="199"/>
                    </a:lnTo>
                    <a:lnTo>
                      <a:pt x="8941" y="208"/>
                    </a:lnTo>
                    <a:lnTo>
                      <a:pt x="8954" y="222"/>
                    </a:lnTo>
                    <a:lnTo>
                      <a:pt x="8966" y="228"/>
                    </a:lnTo>
                    <a:lnTo>
                      <a:pt x="8979" y="229"/>
                    </a:lnTo>
                    <a:lnTo>
                      <a:pt x="8992" y="241"/>
                    </a:lnTo>
                    <a:lnTo>
                      <a:pt x="9005" y="263"/>
                    </a:lnTo>
                    <a:lnTo>
                      <a:pt x="9018" y="277"/>
                    </a:lnTo>
                    <a:lnTo>
                      <a:pt x="9031" y="303"/>
                    </a:lnTo>
                    <a:lnTo>
                      <a:pt x="9043" y="307"/>
                    </a:lnTo>
                    <a:lnTo>
                      <a:pt x="9056" y="317"/>
                    </a:lnTo>
                    <a:lnTo>
                      <a:pt x="9069" y="321"/>
                    </a:lnTo>
                    <a:lnTo>
                      <a:pt x="9082" y="324"/>
                    </a:lnTo>
                    <a:lnTo>
                      <a:pt x="9095" y="316"/>
                    </a:lnTo>
                    <a:lnTo>
                      <a:pt x="9108" y="310"/>
                    </a:lnTo>
                    <a:lnTo>
                      <a:pt x="9120" y="316"/>
                    </a:lnTo>
                    <a:lnTo>
                      <a:pt x="9133" y="313"/>
                    </a:lnTo>
                    <a:lnTo>
                      <a:pt x="9146" y="302"/>
                    </a:lnTo>
                    <a:lnTo>
                      <a:pt x="9159" y="307"/>
                    </a:lnTo>
                    <a:lnTo>
                      <a:pt x="9172" y="312"/>
                    </a:lnTo>
                    <a:lnTo>
                      <a:pt x="9185" y="303"/>
                    </a:lnTo>
                    <a:lnTo>
                      <a:pt x="9197" y="301"/>
                    </a:lnTo>
                    <a:lnTo>
                      <a:pt x="9210" y="297"/>
                    </a:lnTo>
                    <a:lnTo>
                      <a:pt x="9223" y="290"/>
                    </a:lnTo>
                    <a:lnTo>
                      <a:pt x="9236" y="280"/>
                    </a:lnTo>
                    <a:lnTo>
                      <a:pt x="9249" y="278"/>
                    </a:lnTo>
                    <a:lnTo>
                      <a:pt x="9262" y="264"/>
                    </a:lnTo>
                    <a:lnTo>
                      <a:pt x="9274" y="258"/>
                    </a:lnTo>
                    <a:lnTo>
                      <a:pt x="9287" y="252"/>
                    </a:lnTo>
                    <a:lnTo>
                      <a:pt x="9300" y="249"/>
                    </a:lnTo>
                    <a:lnTo>
                      <a:pt x="9313" y="240"/>
                    </a:lnTo>
                    <a:lnTo>
                      <a:pt x="9326" y="233"/>
                    </a:lnTo>
                    <a:lnTo>
                      <a:pt x="9339" y="230"/>
                    </a:lnTo>
                    <a:lnTo>
                      <a:pt x="9351" y="222"/>
                    </a:lnTo>
                    <a:lnTo>
                      <a:pt x="9364" y="220"/>
                    </a:lnTo>
                    <a:lnTo>
                      <a:pt x="9377" y="230"/>
                    </a:lnTo>
                    <a:lnTo>
                      <a:pt x="9390" y="212"/>
                    </a:lnTo>
                    <a:lnTo>
                      <a:pt x="9403" y="207"/>
                    </a:lnTo>
                    <a:lnTo>
                      <a:pt x="9416" y="208"/>
                    </a:lnTo>
                    <a:lnTo>
                      <a:pt x="9428" y="208"/>
                    </a:lnTo>
                    <a:lnTo>
                      <a:pt x="9441" y="203"/>
                    </a:lnTo>
                    <a:lnTo>
                      <a:pt x="9454" y="198"/>
                    </a:lnTo>
                    <a:lnTo>
                      <a:pt x="9467" y="187"/>
                    </a:lnTo>
                    <a:lnTo>
                      <a:pt x="9480" y="188"/>
                    </a:lnTo>
                    <a:lnTo>
                      <a:pt x="9492" y="183"/>
                    </a:lnTo>
                    <a:lnTo>
                      <a:pt x="9505" y="184"/>
                    </a:lnTo>
                    <a:lnTo>
                      <a:pt x="9518" y="187"/>
                    </a:lnTo>
                    <a:lnTo>
                      <a:pt x="9531" y="184"/>
                    </a:lnTo>
                    <a:lnTo>
                      <a:pt x="9544" y="179"/>
                    </a:lnTo>
                    <a:lnTo>
                      <a:pt x="9557" y="191"/>
                    </a:lnTo>
                    <a:lnTo>
                      <a:pt x="9569" y="186"/>
                    </a:lnTo>
                    <a:lnTo>
                      <a:pt x="9582" y="187"/>
                    </a:lnTo>
                    <a:lnTo>
                      <a:pt x="9595" y="181"/>
                    </a:lnTo>
                    <a:lnTo>
                      <a:pt x="9608" y="182"/>
                    </a:lnTo>
                    <a:lnTo>
                      <a:pt x="9621" y="186"/>
                    </a:lnTo>
                    <a:lnTo>
                      <a:pt x="9634" y="177"/>
                    </a:lnTo>
                    <a:lnTo>
                      <a:pt x="9646" y="178"/>
                    </a:lnTo>
                    <a:lnTo>
                      <a:pt x="9659" y="184"/>
                    </a:lnTo>
                    <a:lnTo>
                      <a:pt x="9672" y="186"/>
                    </a:lnTo>
                    <a:lnTo>
                      <a:pt x="9685" y="182"/>
                    </a:lnTo>
                    <a:lnTo>
                      <a:pt x="9698" y="180"/>
                    </a:lnTo>
                    <a:lnTo>
                      <a:pt x="9711" y="186"/>
                    </a:lnTo>
                    <a:lnTo>
                      <a:pt x="9723" y="175"/>
                    </a:lnTo>
                    <a:lnTo>
                      <a:pt x="9736" y="174"/>
                    </a:lnTo>
                    <a:lnTo>
                      <a:pt x="9749" y="176"/>
                    </a:lnTo>
                    <a:lnTo>
                      <a:pt x="9762" y="170"/>
                    </a:lnTo>
                    <a:lnTo>
                      <a:pt x="9775" y="164"/>
                    </a:lnTo>
                    <a:lnTo>
                      <a:pt x="9788" y="168"/>
                    </a:lnTo>
                    <a:lnTo>
                      <a:pt x="9800" y="178"/>
                    </a:lnTo>
                    <a:lnTo>
                      <a:pt x="9813" y="184"/>
                    </a:lnTo>
                    <a:lnTo>
                      <a:pt x="9826" y="181"/>
                    </a:lnTo>
                    <a:lnTo>
                      <a:pt x="9839" y="193"/>
                    </a:lnTo>
                    <a:lnTo>
                      <a:pt x="9852" y="197"/>
                    </a:lnTo>
                    <a:lnTo>
                      <a:pt x="9865" y="196"/>
                    </a:lnTo>
                    <a:lnTo>
                      <a:pt x="9877" y="192"/>
                    </a:lnTo>
                    <a:lnTo>
                      <a:pt x="9890" y="185"/>
                    </a:lnTo>
                    <a:lnTo>
                      <a:pt x="9903" y="194"/>
                    </a:lnTo>
                    <a:lnTo>
                      <a:pt x="9916" y="180"/>
                    </a:lnTo>
                    <a:lnTo>
                      <a:pt x="9929" y="185"/>
                    </a:lnTo>
                    <a:lnTo>
                      <a:pt x="9942" y="172"/>
                    </a:lnTo>
                    <a:lnTo>
                      <a:pt x="9954" y="185"/>
                    </a:lnTo>
                    <a:lnTo>
                      <a:pt x="9967" y="181"/>
                    </a:lnTo>
                    <a:lnTo>
                      <a:pt x="9980" y="171"/>
                    </a:lnTo>
                    <a:lnTo>
                      <a:pt x="9993" y="167"/>
                    </a:lnTo>
                    <a:lnTo>
                      <a:pt x="10006" y="168"/>
                    </a:lnTo>
                    <a:lnTo>
                      <a:pt x="10019" y="166"/>
                    </a:lnTo>
                    <a:lnTo>
                      <a:pt x="10031" y="167"/>
                    </a:lnTo>
                    <a:lnTo>
                      <a:pt x="10044" y="152"/>
                    </a:lnTo>
                    <a:lnTo>
                      <a:pt x="10057" y="158"/>
                    </a:lnTo>
                    <a:lnTo>
                      <a:pt x="10070" y="145"/>
                    </a:lnTo>
                    <a:lnTo>
                      <a:pt x="10083" y="138"/>
                    </a:lnTo>
                    <a:lnTo>
                      <a:pt x="10096" y="139"/>
                    </a:lnTo>
                    <a:lnTo>
                      <a:pt x="10099" y="14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</p:grpSp>
        <p:cxnSp>
          <p:nvCxnSpPr>
            <p:cNvPr id="11" name="Straight Connector 10"/>
            <p:cNvCxnSpPr/>
            <p:nvPr/>
          </p:nvCxnSpPr>
          <p:spPr>
            <a:xfrm>
              <a:off x="1844980" y="1024041"/>
              <a:ext cx="3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1844980" y="1172969"/>
              <a:ext cx="300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Rectangle 232"/>
            <p:cNvSpPr>
              <a:spLocks noChangeArrowheads="1"/>
            </p:cNvSpPr>
            <p:nvPr/>
          </p:nvSpPr>
          <p:spPr bwMode="auto">
            <a:xfrm rot="16200000">
              <a:off x="-85132" y="1707126"/>
              <a:ext cx="96821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800" b="1" dirty="0" smtClean="0"/>
                <a:t>Relative</a:t>
              </a: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effectLst/>
                </a:rPr>
                <a:t> </a:t>
              </a:r>
              <a:r>
                <a:rPr lang="en-US" altLang="en-US" sz="800" b="1" dirty="0"/>
                <a:t>a</a:t>
              </a: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effectLst/>
                </a:rPr>
                <a:t>bundance</a:t>
              </a:r>
            </a:p>
          </p:txBody>
        </p:sp>
        <p:sp>
          <p:nvSpPr>
            <p:cNvPr id="14" name="Rectangle 232"/>
            <p:cNvSpPr>
              <a:spLocks noChangeArrowheads="1"/>
            </p:cNvSpPr>
            <p:nvPr/>
          </p:nvSpPr>
          <p:spPr bwMode="auto">
            <a:xfrm>
              <a:off x="1409218" y="2772839"/>
              <a:ext cx="99225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effectLst/>
                </a:rPr>
                <a:t>Retention time (min)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72661" y="823244"/>
              <a:ext cx="4876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x100,000)</a:t>
              </a:r>
              <a:endParaRPr lang="en-SG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Picture 3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68931" y="1067258"/>
              <a:ext cx="1440000" cy="9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5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60400" y="1056060"/>
              <a:ext cx="1440000" cy="9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Rectangle 235"/>
            <p:cNvSpPr>
              <a:spLocks noChangeArrowheads="1"/>
            </p:cNvSpPr>
            <p:nvPr/>
          </p:nvSpPr>
          <p:spPr bwMode="auto">
            <a:xfrm>
              <a:off x="3493910" y="1008532"/>
              <a:ext cx="24526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600" b="1" dirty="0" smtClean="0"/>
                <a:t>P</a:t>
              </a:r>
              <a:r>
                <a:rPr kumimoji="0" lang="en-US" altLang="en-US" sz="600" b="1" i="0" u="none" strike="noStrike" cap="none" normalizeH="0" dirty="0" smtClean="0">
                  <a:ln>
                    <a:noFill/>
                  </a:ln>
                  <a:effectLst/>
                </a:rPr>
                <a:t>eak 1</a:t>
              </a:r>
              <a:endParaRPr kumimoji="0" lang="en-US" altLang="en-US" sz="600" b="1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19" name="Rectangle 232"/>
            <p:cNvSpPr>
              <a:spLocks noChangeArrowheads="1"/>
            </p:cNvSpPr>
            <p:nvPr/>
          </p:nvSpPr>
          <p:spPr bwMode="auto">
            <a:xfrm rot="16200000">
              <a:off x="3079202" y="1428549"/>
              <a:ext cx="5530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effectLst/>
                </a:rPr>
                <a:t>Ion Abundance</a:t>
              </a:r>
            </a:p>
          </p:txBody>
        </p:sp>
        <p:sp>
          <p:nvSpPr>
            <p:cNvPr id="20" name="Rectangle 232"/>
            <p:cNvSpPr>
              <a:spLocks noChangeArrowheads="1"/>
            </p:cNvSpPr>
            <p:nvPr/>
          </p:nvSpPr>
          <p:spPr bwMode="auto">
            <a:xfrm rot="16200000">
              <a:off x="4577331" y="1421567"/>
              <a:ext cx="5530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effectLst/>
                </a:rPr>
                <a:t>Ion Abundance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4882596" y="944250"/>
              <a:ext cx="1048685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SG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ryophyllene</a:t>
              </a:r>
              <a:r>
                <a:rPr lang="en-SG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33.5%</a:t>
              </a:r>
              <a:endParaRPr lang="en-SG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Arrow Connector 21"/>
            <p:cNvCxnSpPr/>
            <p:nvPr/>
          </p:nvCxnSpPr>
          <p:spPr>
            <a:xfrm>
              <a:off x="2948616" y="2266197"/>
              <a:ext cx="0" cy="216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2786846" y="2045853"/>
              <a:ext cx="3113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1000" b="1" dirty="0" smtClean="0">
                  <a:latin typeface="Arial" panose="020B0604020202020204" pitchFamily="34" charset="0"/>
                  <a:ea typeface="굴림"/>
                  <a:cs typeface="Arial" panose="020B0604020202020204" pitchFamily="34" charset="0"/>
                </a:rPr>
                <a:t>③</a:t>
              </a:r>
              <a:endParaRPr lang="en-SG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Picture 3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64640" y="2101972"/>
              <a:ext cx="1440000" cy="9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" name="Rectangle 235"/>
            <p:cNvSpPr>
              <a:spLocks noChangeArrowheads="1"/>
            </p:cNvSpPr>
            <p:nvPr/>
          </p:nvSpPr>
          <p:spPr bwMode="auto">
            <a:xfrm>
              <a:off x="3493910" y="2038340"/>
              <a:ext cx="24526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600" b="1" dirty="0" smtClean="0"/>
                <a:t>P</a:t>
              </a:r>
              <a:r>
                <a:rPr kumimoji="0" lang="en-US" altLang="en-US" sz="600" b="1" i="0" u="none" strike="noStrike" cap="none" normalizeH="0" dirty="0" smtClean="0">
                  <a:ln>
                    <a:noFill/>
                  </a:ln>
                  <a:effectLst/>
                </a:rPr>
                <a:t>eak 2</a:t>
              </a:r>
              <a:endParaRPr kumimoji="0" lang="en-US" altLang="en-US" sz="600" b="1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26" name="Rectangle 232"/>
            <p:cNvSpPr>
              <a:spLocks noChangeArrowheads="1"/>
            </p:cNvSpPr>
            <p:nvPr/>
          </p:nvSpPr>
          <p:spPr bwMode="auto">
            <a:xfrm rot="16200000">
              <a:off x="3079202" y="2455051"/>
              <a:ext cx="5530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effectLst/>
                </a:rPr>
                <a:t>Ion Abundance</a:t>
              </a:r>
            </a:p>
          </p:txBody>
        </p:sp>
        <p:pic>
          <p:nvPicPr>
            <p:cNvPr id="27" name="Picture 5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69320" y="2101428"/>
              <a:ext cx="1440000" cy="9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Rectangle 232"/>
            <p:cNvSpPr>
              <a:spLocks noChangeArrowheads="1"/>
            </p:cNvSpPr>
            <p:nvPr/>
          </p:nvSpPr>
          <p:spPr bwMode="auto">
            <a:xfrm rot="16200000">
              <a:off x="4579421" y="2455051"/>
              <a:ext cx="5530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effectLst/>
                </a:rPr>
                <a:t>Ion Abundance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887008" y="1993092"/>
              <a:ext cx="1494320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umulene</a:t>
              </a: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l-G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SG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ryophyllene</a:t>
              </a:r>
              <a:r>
                <a:rPr lang="en-SG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, 30.9%</a:t>
              </a:r>
              <a:endParaRPr lang="en-SG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" name="Picture 7"/>
            <p:cNvPicPr preferRelativeResize="0"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62926" y="3109540"/>
              <a:ext cx="1440000" cy="9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" name="Rectangle 235"/>
            <p:cNvSpPr>
              <a:spLocks noChangeArrowheads="1"/>
            </p:cNvSpPr>
            <p:nvPr/>
          </p:nvSpPr>
          <p:spPr bwMode="auto">
            <a:xfrm>
              <a:off x="3493910" y="3050912"/>
              <a:ext cx="24526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600" b="1" dirty="0" smtClean="0"/>
                <a:t>P</a:t>
              </a:r>
              <a:r>
                <a:rPr kumimoji="0" lang="en-US" altLang="en-US" sz="600" b="1" i="0" u="none" strike="noStrike" cap="none" normalizeH="0" dirty="0" smtClean="0">
                  <a:ln>
                    <a:noFill/>
                  </a:ln>
                  <a:effectLst/>
                </a:rPr>
                <a:t>eak 3</a:t>
              </a:r>
              <a:endParaRPr kumimoji="0" lang="en-US" altLang="en-US" sz="600" b="1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32" name="Rectangle 232"/>
            <p:cNvSpPr>
              <a:spLocks noChangeArrowheads="1"/>
            </p:cNvSpPr>
            <p:nvPr/>
          </p:nvSpPr>
          <p:spPr bwMode="auto">
            <a:xfrm rot="16200000">
              <a:off x="3079202" y="3506935"/>
              <a:ext cx="5530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effectLst/>
                </a:rPr>
                <a:t>Ion Abundance</a:t>
              </a:r>
            </a:p>
          </p:txBody>
        </p:sp>
        <p:pic>
          <p:nvPicPr>
            <p:cNvPr id="33" name="Picture 9"/>
            <p:cNvPicPr preferRelativeResize="0">
              <a:picLocks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69160" y="3103021"/>
              <a:ext cx="1440000" cy="9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4" name="Rectangle 232"/>
            <p:cNvSpPr>
              <a:spLocks noChangeArrowheads="1"/>
            </p:cNvSpPr>
            <p:nvPr/>
          </p:nvSpPr>
          <p:spPr bwMode="auto">
            <a:xfrm rot="16200000">
              <a:off x="4579421" y="3511395"/>
              <a:ext cx="55303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effectLst/>
                </a:rPr>
                <a:t>Ion Abundance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4882025" y="2996882"/>
              <a:ext cx="1269899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SG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ryophyllene</a:t>
              </a:r>
              <a:r>
                <a:rPr lang="en-SG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SG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ide, 40.6%</a:t>
              </a:r>
              <a:endParaRPr lang="en-SG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232"/>
            <p:cNvSpPr>
              <a:spLocks noChangeArrowheads="1"/>
            </p:cNvSpPr>
            <p:nvPr/>
          </p:nvSpPr>
          <p:spPr bwMode="auto">
            <a:xfrm>
              <a:off x="3952266" y="3998788"/>
              <a:ext cx="2132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</a:rPr>
                <a:t>m/z</a:t>
              </a:r>
            </a:p>
          </p:txBody>
        </p:sp>
        <p:sp>
          <p:nvSpPr>
            <p:cNvPr id="37" name="Rectangle 232"/>
            <p:cNvSpPr>
              <a:spLocks noChangeArrowheads="1"/>
            </p:cNvSpPr>
            <p:nvPr/>
          </p:nvSpPr>
          <p:spPr bwMode="auto">
            <a:xfrm>
              <a:off x="5497004" y="3998788"/>
              <a:ext cx="2132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</a:rPr>
                <a:t>m/z</a:t>
              </a:r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507758" y="3007184"/>
              <a:ext cx="2638961" cy="1800848"/>
              <a:chOff x="578519" y="1086650"/>
              <a:chExt cx="4058150" cy="2769315"/>
            </a:xfrm>
          </p:grpSpPr>
          <p:sp>
            <p:nvSpPr>
              <p:cNvPr id="43" name="Line 327"/>
              <p:cNvSpPr>
                <a:spLocks noChangeShapeType="1"/>
              </p:cNvSpPr>
              <p:nvPr/>
            </p:nvSpPr>
            <p:spPr bwMode="auto">
              <a:xfrm>
                <a:off x="695791" y="3675879"/>
                <a:ext cx="394087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44" name="Line 328"/>
              <p:cNvSpPr>
                <a:spLocks noChangeShapeType="1"/>
              </p:cNvSpPr>
              <p:nvPr/>
            </p:nvSpPr>
            <p:spPr bwMode="auto">
              <a:xfrm flipV="1">
                <a:off x="759857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45" name="Line 329"/>
              <p:cNvSpPr>
                <a:spLocks noChangeShapeType="1"/>
              </p:cNvSpPr>
              <p:nvPr/>
            </p:nvSpPr>
            <p:spPr bwMode="auto">
              <a:xfrm flipV="1">
                <a:off x="833300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46" name="Line 330"/>
              <p:cNvSpPr>
                <a:spLocks noChangeShapeType="1"/>
              </p:cNvSpPr>
              <p:nvPr/>
            </p:nvSpPr>
            <p:spPr bwMode="auto">
              <a:xfrm flipV="1">
                <a:off x="906741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47" name="Line 331"/>
              <p:cNvSpPr>
                <a:spLocks noChangeShapeType="1"/>
              </p:cNvSpPr>
              <p:nvPr/>
            </p:nvSpPr>
            <p:spPr bwMode="auto">
              <a:xfrm flipV="1">
                <a:off x="978621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48" name="Line 332"/>
              <p:cNvSpPr>
                <a:spLocks noChangeShapeType="1"/>
              </p:cNvSpPr>
              <p:nvPr/>
            </p:nvSpPr>
            <p:spPr bwMode="auto">
              <a:xfrm flipV="1">
                <a:off x="1052064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49" name="Line 333"/>
              <p:cNvSpPr>
                <a:spLocks noChangeShapeType="1"/>
              </p:cNvSpPr>
              <p:nvPr/>
            </p:nvSpPr>
            <p:spPr bwMode="auto">
              <a:xfrm flipV="1">
                <a:off x="1125505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0" name="Line 334"/>
              <p:cNvSpPr>
                <a:spLocks noChangeShapeType="1"/>
              </p:cNvSpPr>
              <p:nvPr/>
            </p:nvSpPr>
            <p:spPr bwMode="auto">
              <a:xfrm flipV="1">
                <a:off x="119894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1" name="Line 335"/>
              <p:cNvSpPr>
                <a:spLocks noChangeShapeType="1"/>
              </p:cNvSpPr>
              <p:nvPr/>
            </p:nvSpPr>
            <p:spPr bwMode="auto">
              <a:xfrm flipV="1">
                <a:off x="1272390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2" name="Line 336"/>
              <p:cNvSpPr>
                <a:spLocks noChangeShapeType="1"/>
              </p:cNvSpPr>
              <p:nvPr/>
            </p:nvSpPr>
            <p:spPr bwMode="auto">
              <a:xfrm flipV="1">
                <a:off x="1344269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3" name="Line 337"/>
              <p:cNvSpPr>
                <a:spLocks noChangeShapeType="1"/>
              </p:cNvSpPr>
              <p:nvPr/>
            </p:nvSpPr>
            <p:spPr bwMode="auto">
              <a:xfrm flipV="1">
                <a:off x="1417712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4" name="Line 338"/>
              <p:cNvSpPr>
                <a:spLocks noChangeShapeType="1"/>
              </p:cNvSpPr>
              <p:nvPr/>
            </p:nvSpPr>
            <p:spPr bwMode="auto">
              <a:xfrm flipV="1">
                <a:off x="1491154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5" name="Line 339"/>
              <p:cNvSpPr>
                <a:spLocks noChangeShapeType="1"/>
              </p:cNvSpPr>
              <p:nvPr/>
            </p:nvSpPr>
            <p:spPr bwMode="auto">
              <a:xfrm flipV="1">
                <a:off x="1564597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6" name="Line 340"/>
              <p:cNvSpPr>
                <a:spLocks noChangeShapeType="1"/>
              </p:cNvSpPr>
              <p:nvPr/>
            </p:nvSpPr>
            <p:spPr bwMode="auto">
              <a:xfrm flipV="1">
                <a:off x="163803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7" name="Line 341"/>
              <p:cNvSpPr>
                <a:spLocks noChangeShapeType="1"/>
              </p:cNvSpPr>
              <p:nvPr/>
            </p:nvSpPr>
            <p:spPr bwMode="auto">
              <a:xfrm flipV="1">
                <a:off x="170991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8" name="Line 342"/>
              <p:cNvSpPr>
                <a:spLocks noChangeShapeType="1"/>
              </p:cNvSpPr>
              <p:nvPr/>
            </p:nvSpPr>
            <p:spPr bwMode="auto">
              <a:xfrm flipV="1">
                <a:off x="1783361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59" name="Line 343"/>
              <p:cNvSpPr>
                <a:spLocks noChangeShapeType="1"/>
              </p:cNvSpPr>
              <p:nvPr/>
            </p:nvSpPr>
            <p:spPr bwMode="auto">
              <a:xfrm flipV="1">
                <a:off x="1856802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0" name="Line 344"/>
              <p:cNvSpPr>
                <a:spLocks noChangeShapeType="1"/>
              </p:cNvSpPr>
              <p:nvPr/>
            </p:nvSpPr>
            <p:spPr bwMode="auto">
              <a:xfrm flipV="1">
                <a:off x="1930245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1" name="Line 345"/>
              <p:cNvSpPr>
                <a:spLocks noChangeShapeType="1"/>
              </p:cNvSpPr>
              <p:nvPr/>
            </p:nvSpPr>
            <p:spPr bwMode="auto">
              <a:xfrm flipV="1">
                <a:off x="2003687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2" name="Line 346"/>
              <p:cNvSpPr>
                <a:spLocks noChangeShapeType="1"/>
              </p:cNvSpPr>
              <p:nvPr/>
            </p:nvSpPr>
            <p:spPr bwMode="auto">
              <a:xfrm flipV="1">
                <a:off x="2077130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3" name="Line 347"/>
              <p:cNvSpPr>
                <a:spLocks noChangeShapeType="1"/>
              </p:cNvSpPr>
              <p:nvPr/>
            </p:nvSpPr>
            <p:spPr bwMode="auto">
              <a:xfrm flipV="1">
                <a:off x="2149009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4" name="Line 348"/>
              <p:cNvSpPr>
                <a:spLocks noChangeShapeType="1"/>
              </p:cNvSpPr>
              <p:nvPr/>
            </p:nvSpPr>
            <p:spPr bwMode="auto">
              <a:xfrm flipV="1">
                <a:off x="2222451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5" name="Line 349"/>
              <p:cNvSpPr>
                <a:spLocks noChangeShapeType="1"/>
              </p:cNvSpPr>
              <p:nvPr/>
            </p:nvSpPr>
            <p:spPr bwMode="auto">
              <a:xfrm flipV="1">
                <a:off x="2295894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6" name="Line 350"/>
              <p:cNvSpPr>
                <a:spLocks noChangeShapeType="1"/>
              </p:cNvSpPr>
              <p:nvPr/>
            </p:nvSpPr>
            <p:spPr bwMode="auto">
              <a:xfrm flipV="1">
                <a:off x="2369335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7" name="Line 351"/>
              <p:cNvSpPr>
                <a:spLocks noChangeShapeType="1"/>
              </p:cNvSpPr>
              <p:nvPr/>
            </p:nvSpPr>
            <p:spPr bwMode="auto">
              <a:xfrm flipV="1">
                <a:off x="244277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8" name="Line 352"/>
              <p:cNvSpPr>
                <a:spLocks noChangeShapeType="1"/>
              </p:cNvSpPr>
              <p:nvPr/>
            </p:nvSpPr>
            <p:spPr bwMode="auto">
              <a:xfrm flipV="1">
                <a:off x="2516220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69" name="Line 353"/>
              <p:cNvSpPr>
                <a:spLocks noChangeShapeType="1"/>
              </p:cNvSpPr>
              <p:nvPr/>
            </p:nvSpPr>
            <p:spPr bwMode="auto">
              <a:xfrm flipV="1">
                <a:off x="2588099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0" name="Line 354"/>
              <p:cNvSpPr>
                <a:spLocks noChangeShapeType="1"/>
              </p:cNvSpPr>
              <p:nvPr/>
            </p:nvSpPr>
            <p:spPr bwMode="auto">
              <a:xfrm flipV="1">
                <a:off x="2661542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1" name="Line 355"/>
              <p:cNvSpPr>
                <a:spLocks noChangeShapeType="1"/>
              </p:cNvSpPr>
              <p:nvPr/>
            </p:nvSpPr>
            <p:spPr bwMode="auto">
              <a:xfrm flipV="1">
                <a:off x="2734984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2" name="Line 356"/>
              <p:cNvSpPr>
                <a:spLocks noChangeShapeType="1"/>
              </p:cNvSpPr>
              <p:nvPr/>
            </p:nvSpPr>
            <p:spPr bwMode="auto">
              <a:xfrm flipV="1">
                <a:off x="2808427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3" name="Line 357"/>
              <p:cNvSpPr>
                <a:spLocks noChangeShapeType="1"/>
              </p:cNvSpPr>
              <p:nvPr/>
            </p:nvSpPr>
            <p:spPr bwMode="auto">
              <a:xfrm flipV="1">
                <a:off x="2880306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4" name="Line 358"/>
              <p:cNvSpPr>
                <a:spLocks noChangeShapeType="1"/>
              </p:cNvSpPr>
              <p:nvPr/>
            </p:nvSpPr>
            <p:spPr bwMode="auto">
              <a:xfrm flipV="1">
                <a:off x="295374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5" name="Line 359"/>
              <p:cNvSpPr>
                <a:spLocks noChangeShapeType="1"/>
              </p:cNvSpPr>
              <p:nvPr/>
            </p:nvSpPr>
            <p:spPr bwMode="auto">
              <a:xfrm flipV="1">
                <a:off x="3027191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6" name="Line 360"/>
              <p:cNvSpPr>
                <a:spLocks noChangeShapeType="1"/>
              </p:cNvSpPr>
              <p:nvPr/>
            </p:nvSpPr>
            <p:spPr bwMode="auto">
              <a:xfrm flipV="1">
                <a:off x="3100632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7" name="Line 361"/>
              <p:cNvSpPr>
                <a:spLocks noChangeShapeType="1"/>
              </p:cNvSpPr>
              <p:nvPr/>
            </p:nvSpPr>
            <p:spPr bwMode="auto">
              <a:xfrm flipV="1">
                <a:off x="3174075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8" name="Line 362"/>
              <p:cNvSpPr>
                <a:spLocks noChangeShapeType="1"/>
              </p:cNvSpPr>
              <p:nvPr/>
            </p:nvSpPr>
            <p:spPr bwMode="auto">
              <a:xfrm flipV="1">
                <a:off x="3247517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79" name="Line 363"/>
              <p:cNvSpPr>
                <a:spLocks noChangeShapeType="1"/>
              </p:cNvSpPr>
              <p:nvPr/>
            </p:nvSpPr>
            <p:spPr bwMode="auto">
              <a:xfrm flipV="1">
                <a:off x="3319396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0" name="Line 364"/>
              <p:cNvSpPr>
                <a:spLocks noChangeShapeType="1"/>
              </p:cNvSpPr>
              <p:nvPr/>
            </p:nvSpPr>
            <p:spPr bwMode="auto">
              <a:xfrm flipV="1">
                <a:off x="3392839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1" name="Line 365"/>
              <p:cNvSpPr>
                <a:spLocks noChangeShapeType="1"/>
              </p:cNvSpPr>
              <p:nvPr/>
            </p:nvSpPr>
            <p:spPr bwMode="auto">
              <a:xfrm flipV="1">
                <a:off x="3466281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2" name="Line 366"/>
              <p:cNvSpPr>
                <a:spLocks noChangeShapeType="1"/>
              </p:cNvSpPr>
              <p:nvPr/>
            </p:nvSpPr>
            <p:spPr bwMode="auto">
              <a:xfrm flipV="1">
                <a:off x="3539724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3" name="Line 367"/>
              <p:cNvSpPr>
                <a:spLocks noChangeShapeType="1"/>
              </p:cNvSpPr>
              <p:nvPr/>
            </p:nvSpPr>
            <p:spPr bwMode="auto">
              <a:xfrm flipV="1">
                <a:off x="3613165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4" name="Line 368"/>
              <p:cNvSpPr>
                <a:spLocks noChangeShapeType="1"/>
              </p:cNvSpPr>
              <p:nvPr/>
            </p:nvSpPr>
            <p:spPr bwMode="auto">
              <a:xfrm flipV="1">
                <a:off x="368660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5" name="Line 369"/>
              <p:cNvSpPr>
                <a:spLocks noChangeShapeType="1"/>
              </p:cNvSpPr>
              <p:nvPr/>
            </p:nvSpPr>
            <p:spPr bwMode="auto">
              <a:xfrm flipV="1">
                <a:off x="375848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6" name="Line 370"/>
              <p:cNvSpPr>
                <a:spLocks noChangeShapeType="1"/>
              </p:cNvSpPr>
              <p:nvPr/>
            </p:nvSpPr>
            <p:spPr bwMode="auto">
              <a:xfrm flipV="1">
                <a:off x="3831929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7" name="Line 371"/>
              <p:cNvSpPr>
                <a:spLocks noChangeShapeType="1"/>
              </p:cNvSpPr>
              <p:nvPr/>
            </p:nvSpPr>
            <p:spPr bwMode="auto">
              <a:xfrm flipV="1">
                <a:off x="3905372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8" name="Line 372"/>
              <p:cNvSpPr>
                <a:spLocks noChangeShapeType="1"/>
              </p:cNvSpPr>
              <p:nvPr/>
            </p:nvSpPr>
            <p:spPr bwMode="auto">
              <a:xfrm flipV="1">
                <a:off x="3978814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89" name="Line 373"/>
              <p:cNvSpPr>
                <a:spLocks noChangeShapeType="1"/>
              </p:cNvSpPr>
              <p:nvPr/>
            </p:nvSpPr>
            <p:spPr bwMode="auto">
              <a:xfrm flipV="1">
                <a:off x="4052256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0" name="Line 374"/>
              <p:cNvSpPr>
                <a:spLocks noChangeShapeType="1"/>
              </p:cNvSpPr>
              <p:nvPr/>
            </p:nvSpPr>
            <p:spPr bwMode="auto">
              <a:xfrm flipV="1">
                <a:off x="4124136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1" name="Line 375"/>
              <p:cNvSpPr>
                <a:spLocks noChangeShapeType="1"/>
              </p:cNvSpPr>
              <p:nvPr/>
            </p:nvSpPr>
            <p:spPr bwMode="auto">
              <a:xfrm flipV="1">
                <a:off x="4197578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2" name="Line 376"/>
              <p:cNvSpPr>
                <a:spLocks noChangeShapeType="1"/>
              </p:cNvSpPr>
              <p:nvPr/>
            </p:nvSpPr>
            <p:spPr bwMode="auto">
              <a:xfrm flipV="1">
                <a:off x="4271021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3" name="Line 377"/>
              <p:cNvSpPr>
                <a:spLocks noChangeShapeType="1"/>
              </p:cNvSpPr>
              <p:nvPr/>
            </p:nvSpPr>
            <p:spPr bwMode="auto">
              <a:xfrm flipV="1">
                <a:off x="4344462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4" name="Line 378"/>
              <p:cNvSpPr>
                <a:spLocks noChangeShapeType="1"/>
              </p:cNvSpPr>
              <p:nvPr/>
            </p:nvSpPr>
            <p:spPr bwMode="auto">
              <a:xfrm flipV="1">
                <a:off x="4417905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5" name="Line 379"/>
              <p:cNvSpPr>
                <a:spLocks noChangeShapeType="1"/>
              </p:cNvSpPr>
              <p:nvPr/>
            </p:nvSpPr>
            <p:spPr bwMode="auto">
              <a:xfrm flipV="1">
                <a:off x="4489785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6" name="Line 380"/>
              <p:cNvSpPr>
                <a:spLocks noChangeShapeType="1"/>
              </p:cNvSpPr>
              <p:nvPr/>
            </p:nvSpPr>
            <p:spPr bwMode="auto">
              <a:xfrm flipV="1">
                <a:off x="4563226" y="3675879"/>
                <a:ext cx="0" cy="281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97" name="Rectangle 381"/>
              <p:cNvSpPr>
                <a:spLocks noChangeArrowheads="1"/>
              </p:cNvSpPr>
              <p:nvPr/>
            </p:nvSpPr>
            <p:spPr bwMode="auto">
              <a:xfrm>
                <a:off x="714562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5.00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8" name="Rectangle 382"/>
              <p:cNvSpPr>
                <a:spLocks noChangeArrowheads="1"/>
              </p:cNvSpPr>
              <p:nvPr/>
            </p:nvSpPr>
            <p:spPr bwMode="auto">
              <a:xfrm>
                <a:off x="1080210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5.5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9" name="Rectangle 383"/>
              <p:cNvSpPr>
                <a:spLocks noChangeArrowheads="1"/>
              </p:cNvSpPr>
              <p:nvPr/>
            </p:nvSpPr>
            <p:spPr bwMode="auto">
              <a:xfrm>
                <a:off x="1445858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6.0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0" name="Rectangle 384"/>
              <p:cNvSpPr>
                <a:spLocks noChangeArrowheads="1"/>
              </p:cNvSpPr>
              <p:nvPr/>
            </p:nvSpPr>
            <p:spPr bwMode="auto">
              <a:xfrm>
                <a:off x="1811507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6.5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1" name="Rectangle 385"/>
              <p:cNvSpPr>
                <a:spLocks noChangeArrowheads="1"/>
              </p:cNvSpPr>
              <p:nvPr/>
            </p:nvSpPr>
            <p:spPr bwMode="auto">
              <a:xfrm>
                <a:off x="2177155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7.0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2" name="Rectangle 386"/>
              <p:cNvSpPr>
                <a:spLocks noChangeArrowheads="1"/>
              </p:cNvSpPr>
              <p:nvPr/>
            </p:nvSpPr>
            <p:spPr bwMode="auto">
              <a:xfrm>
                <a:off x="2542805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7.5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3" name="Rectangle 387"/>
              <p:cNvSpPr>
                <a:spLocks noChangeArrowheads="1"/>
              </p:cNvSpPr>
              <p:nvPr/>
            </p:nvSpPr>
            <p:spPr bwMode="auto">
              <a:xfrm>
                <a:off x="2908453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8.0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4" name="Rectangle 388"/>
              <p:cNvSpPr>
                <a:spLocks noChangeArrowheads="1"/>
              </p:cNvSpPr>
              <p:nvPr/>
            </p:nvSpPr>
            <p:spPr bwMode="auto">
              <a:xfrm>
                <a:off x="3274101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8.5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5" name="Rectangle 389"/>
              <p:cNvSpPr>
                <a:spLocks noChangeArrowheads="1"/>
              </p:cNvSpPr>
              <p:nvPr/>
            </p:nvSpPr>
            <p:spPr bwMode="auto">
              <a:xfrm>
                <a:off x="3639749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9.0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6" name="Rectangle 390"/>
              <p:cNvSpPr>
                <a:spLocks noChangeArrowheads="1"/>
              </p:cNvSpPr>
              <p:nvPr/>
            </p:nvSpPr>
            <p:spPr bwMode="auto">
              <a:xfrm>
                <a:off x="4005398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9.5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7" name="Rectangle 391"/>
              <p:cNvSpPr>
                <a:spLocks noChangeArrowheads="1"/>
              </p:cNvSpPr>
              <p:nvPr/>
            </p:nvSpPr>
            <p:spPr bwMode="auto">
              <a:xfrm>
                <a:off x="4371046" y="3737642"/>
                <a:ext cx="244043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0.00</a:t>
                </a:r>
                <a:endParaRPr kumimoji="0" lang="en-US" altLang="en-US" sz="5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08" name="Line 392"/>
              <p:cNvSpPr>
                <a:spLocks noChangeShapeType="1"/>
              </p:cNvSpPr>
              <p:nvPr/>
            </p:nvSpPr>
            <p:spPr bwMode="auto">
              <a:xfrm flipV="1">
                <a:off x="833300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09" name="Line 393"/>
              <p:cNvSpPr>
                <a:spLocks noChangeShapeType="1"/>
              </p:cNvSpPr>
              <p:nvPr/>
            </p:nvSpPr>
            <p:spPr bwMode="auto">
              <a:xfrm flipV="1">
                <a:off x="1198948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0" name="Line 394"/>
              <p:cNvSpPr>
                <a:spLocks noChangeShapeType="1"/>
              </p:cNvSpPr>
              <p:nvPr/>
            </p:nvSpPr>
            <p:spPr bwMode="auto">
              <a:xfrm flipV="1">
                <a:off x="1564597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1" name="Line 395"/>
              <p:cNvSpPr>
                <a:spLocks noChangeShapeType="1"/>
              </p:cNvSpPr>
              <p:nvPr/>
            </p:nvSpPr>
            <p:spPr bwMode="auto">
              <a:xfrm flipV="1">
                <a:off x="1930245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2" name="Line 396"/>
              <p:cNvSpPr>
                <a:spLocks noChangeShapeType="1"/>
              </p:cNvSpPr>
              <p:nvPr/>
            </p:nvSpPr>
            <p:spPr bwMode="auto">
              <a:xfrm flipV="1">
                <a:off x="2295894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3" name="Line 397"/>
              <p:cNvSpPr>
                <a:spLocks noChangeShapeType="1"/>
              </p:cNvSpPr>
              <p:nvPr/>
            </p:nvSpPr>
            <p:spPr bwMode="auto">
              <a:xfrm flipV="1">
                <a:off x="2661542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4" name="Line 398"/>
              <p:cNvSpPr>
                <a:spLocks noChangeShapeType="1"/>
              </p:cNvSpPr>
              <p:nvPr/>
            </p:nvSpPr>
            <p:spPr bwMode="auto">
              <a:xfrm flipV="1">
                <a:off x="3027191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5" name="Line 399"/>
              <p:cNvSpPr>
                <a:spLocks noChangeShapeType="1"/>
              </p:cNvSpPr>
              <p:nvPr/>
            </p:nvSpPr>
            <p:spPr bwMode="auto">
              <a:xfrm flipV="1">
                <a:off x="3392839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6" name="Line 400"/>
              <p:cNvSpPr>
                <a:spLocks noChangeShapeType="1"/>
              </p:cNvSpPr>
              <p:nvPr/>
            </p:nvSpPr>
            <p:spPr bwMode="auto">
              <a:xfrm flipV="1">
                <a:off x="3758488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7" name="Line 401"/>
              <p:cNvSpPr>
                <a:spLocks noChangeShapeType="1"/>
              </p:cNvSpPr>
              <p:nvPr/>
            </p:nvSpPr>
            <p:spPr bwMode="auto">
              <a:xfrm flipV="1">
                <a:off x="4124136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8" name="Line 402"/>
              <p:cNvSpPr>
                <a:spLocks noChangeShapeType="1"/>
              </p:cNvSpPr>
              <p:nvPr/>
            </p:nvSpPr>
            <p:spPr bwMode="auto">
              <a:xfrm flipV="1">
                <a:off x="4489785" y="3675879"/>
                <a:ext cx="0" cy="5469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19" name="Line 403"/>
              <p:cNvSpPr>
                <a:spLocks noChangeShapeType="1"/>
              </p:cNvSpPr>
              <p:nvPr/>
            </p:nvSpPr>
            <p:spPr bwMode="auto">
              <a:xfrm flipV="1">
                <a:off x="695791" y="1086650"/>
                <a:ext cx="0" cy="258922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0" name="Line 404"/>
              <p:cNvSpPr>
                <a:spLocks noChangeShapeType="1"/>
              </p:cNvSpPr>
              <p:nvPr/>
            </p:nvSpPr>
            <p:spPr bwMode="auto">
              <a:xfrm>
                <a:off x="689540" y="3641502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1" name="Line 405"/>
              <p:cNvSpPr>
                <a:spLocks noChangeShapeType="1"/>
              </p:cNvSpPr>
              <p:nvPr/>
            </p:nvSpPr>
            <p:spPr bwMode="auto">
              <a:xfrm>
                <a:off x="689540" y="3582123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2" name="Line 406"/>
              <p:cNvSpPr>
                <a:spLocks noChangeShapeType="1"/>
              </p:cNvSpPr>
              <p:nvPr/>
            </p:nvSpPr>
            <p:spPr bwMode="auto">
              <a:xfrm>
                <a:off x="689540" y="3524306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3" name="Line 407"/>
              <p:cNvSpPr>
                <a:spLocks noChangeShapeType="1"/>
              </p:cNvSpPr>
              <p:nvPr/>
            </p:nvSpPr>
            <p:spPr bwMode="auto">
              <a:xfrm>
                <a:off x="689540" y="3464927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4" name="Line 408"/>
              <p:cNvSpPr>
                <a:spLocks noChangeShapeType="1"/>
              </p:cNvSpPr>
              <p:nvPr/>
            </p:nvSpPr>
            <p:spPr bwMode="auto">
              <a:xfrm>
                <a:off x="689540" y="3407112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5" name="Line 409"/>
              <p:cNvSpPr>
                <a:spLocks noChangeShapeType="1"/>
              </p:cNvSpPr>
              <p:nvPr/>
            </p:nvSpPr>
            <p:spPr bwMode="auto">
              <a:xfrm>
                <a:off x="689540" y="3349295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6" name="Line 410"/>
              <p:cNvSpPr>
                <a:spLocks noChangeShapeType="1"/>
              </p:cNvSpPr>
              <p:nvPr/>
            </p:nvSpPr>
            <p:spPr bwMode="auto">
              <a:xfrm>
                <a:off x="689540" y="3289916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7" name="Line 411"/>
              <p:cNvSpPr>
                <a:spLocks noChangeShapeType="1"/>
              </p:cNvSpPr>
              <p:nvPr/>
            </p:nvSpPr>
            <p:spPr bwMode="auto">
              <a:xfrm>
                <a:off x="689540" y="3232100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8" name="Line 412"/>
              <p:cNvSpPr>
                <a:spLocks noChangeShapeType="1"/>
              </p:cNvSpPr>
              <p:nvPr/>
            </p:nvSpPr>
            <p:spPr bwMode="auto">
              <a:xfrm>
                <a:off x="689540" y="3174284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29" name="Line 413"/>
              <p:cNvSpPr>
                <a:spLocks noChangeShapeType="1"/>
              </p:cNvSpPr>
              <p:nvPr/>
            </p:nvSpPr>
            <p:spPr bwMode="auto">
              <a:xfrm>
                <a:off x="689540" y="3114905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0" name="Line 414"/>
              <p:cNvSpPr>
                <a:spLocks noChangeShapeType="1"/>
              </p:cNvSpPr>
              <p:nvPr/>
            </p:nvSpPr>
            <p:spPr bwMode="auto">
              <a:xfrm>
                <a:off x="689540" y="3057089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1" name="Line 415"/>
              <p:cNvSpPr>
                <a:spLocks noChangeShapeType="1"/>
              </p:cNvSpPr>
              <p:nvPr/>
            </p:nvSpPr>
            <p:spPr bwMode="auto">
              <a:xfrm>
                <a:off x="689540" y="2997710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2" name="Line 416"/>
              <p:cNvSpPr>
                <a:spLocks noChangeShapeType="1"/>
              </p:cNvSpPr>
              <p:nvPr/>
            </p:nvSpPr>
            <p:spPr bwMode="auto">
              <a:xfrm>
                <a:off x="689540" y="2939894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3" name="Line 417"/>
              <p:cNvSpPr>
                <a:spLocks noChangeShapeType="1"/>
              </p:cNvSpPr>
              <p:nvPr/>
            </p:nvSpPr>
            <p:spPr bwMode="auto">
              <a:xfrm>
                <a:off x="689540" y="2882078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4" name="Line 418"/>
              <p:cNvSpPr>
                <a:spLocks noChangeShapeType="1"/>
              </p:cNvSpPr>
              <p:nvPr/>
            </p:nvSpPr>
            <p:spPr bwMode="auto">
              <a:xfrm>
                <a:off x="689540" y="2822699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5" name="Line 419"/>
              <p:cNvSpPr>
                <a:spLocks noChangeShapeType="1"/>
              </p:cNvSpPr>
              <p:nvPr/>
            </p:nvSpPr>
            <p:spPr bwMode="auto">
              <a:xfrm>
                <a:off x="689540" y="2764883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6" name="Line 420"/>
              <p:cNvSpPr>
                <a:spLocks noChangeShapeType="1"/>
              </p:cNvSpPr>
              <p:nvPr/>
            </p:nvSpPr>
            <p:spPr bwMode="auto">
              <a:xfrm>
                <a:off x="689540" y="2707067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7" name="Line 421"/>
              <p:cNvSpPr>
                <a:spLocks noChangeShapeType="1"/>
              </p:cNvSpPr>
              <p:nvPr/>
            </p:nvSpPr>
            <p:spPr bwMode="auto">
              <a:xfrm>
                <a:off x="689540" y="2647688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8" name="Line 422"/>
              <p:cNvSpPr>
                <a:spLocks noChangeShapeType="1"/>
              </p:cNvSpPr>
              <p:nvPr/>
            </p:nvSpPr>
            <p:spPr bwMode="auto">
              <a:xfrm>
                <a:off x="689540" y="2589871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39" name="Line 423"/>
              <p:cNvSpPr>
                <a:spLocks noChangeShapeType="1"/>
              </p:cNvSpPr>
              <p:nvPr/>
            </p:nvSpPr>
            <p:spPr bwMode="auto">
              <a:xfrm>
                <a:off x="689540" y="2530493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0" name="Line 424"/>
              <p:cNvSpPr>
                <a:spLocks noChangeShapeType="1"/>
              </p:cNvSpPr>
              <p:nvPr/>
            </p:nvSpPr>
            <p:spPr bwMode="auto">
              <a:xfrm>
                <a:off x="689540" y="2472677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1" name="Line 425"/>
              <p:cNvSpPr>
                <a:spLocks noChangeShapeType="1"/>
              </p:cNvSpPr>
              <p:nvPr/>
            </p:nvSpPr>
            <p:spPr bwMode="auto">
              <a:xfrm>
                <a:off x="689540" y="2414860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2" name="Line 426"/>
              <p:cNvSpPr>
                <a:spLocks noChangeShapeType="1"/>
              </p:cNvSpPr>
              <p:nvPr/>
            </p:nvSpPr>
            <p:spPr bwMode="auto">
              <a:xfrm>
                <a:off x="689540" y="2355481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3" name="Line 427"/>
              <p:cNvSpPr>
                <a:spLocks noChangeShapeType="1"/>
              </p:cNvSpPr>
              <p:nvPr/>
            </p:nvSpPr>
            <p:spPr bwMode="auto">
              <a:xfrm>
                <a:off x="689540" y="2297666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4" name="Line 428"/>
              <p:cNvSpPr>
                <a:spLocks noChangeShapeType="1"/>
              </p:cNvSpPr>
              <p:nvPr/>
            </p:nvSpPr>
            <p:spPr bwMode="auto">
              <a:xfrm>
                <a:off x="689540" y="2239849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5" name="Line 429"/>
              <p:cNvSpPr>
                <a:spLocks noChangeShapeType="1"/>
              </p:cNvSpPr>
              <p:nvPr/>
            </p:nvSpPr>
            <p:spPr bwMode="auto">
              <a:xfrm>
                <a:off x="689540" y="2180470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6" name="Line 430"/>
              <p:cNvSpPr>
                <a:spLocks noChangeShapeType="1"/>
              </p:cNvSpPr>
              <p:nvPr/>
            </p:nvSpPr>
            <p:spPr bwMode="auto">
              <a:xfrm>
                <a:off x="689540" y="2122654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7" name="Line 431"/>
              <p:cNvSpPr>
                <a:spLocks noChangeShapeType="1"/>
              </p:cNvSpPr>
              <p:nvPr/>
            </p:nvSpPr>
            <p:spPr bwMode="auto">
              <a:xfrm>
                <a:off x="689540" y="2063276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8" name="Line 432"/>
              <p:cNvSpPr>
                <a:spLocks noChangeShapeType="1"/>
              </p:cNvSpPr>
              <p:nvPr/>
            </p:nvSpPr>
            <p:spPr bwMode="auto">
              <a:xfrm>
                <a:off x="689540" y="2005459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49" name="Line 433"/>
              <p:cNvSpPr>
                <a:spLocks noChangeShapeType="1"/>
              </p:cNvSpPr>
              <p:nvPr/>
            </p:nvSpPr>
            <p:spPr bwMode="auto">
              <a:xfrm>
                <a:off x="689540" y="1947643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0" name="Line 434"/>
              <p:cNvSpPr>
                <a:spLocks noChangeShapeType="1"/>
              </p:cNvSpPr>
              <p:nvPr/>
            </p:nvSpPr>
            <p:spPr bwMode="auto">
              <a:xfrm>
                <a:off x="689540" y="1888264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1" name="Line 435"/>
              <p:cNvSpPr>
                <a:spLocks noChangeShapeType="1"/>
              </p:cNvSpPr>
              <p:nvPr/>
            </p:nvSpPr>
            <p:spPr bwMode="auto">
              <a:xfrm>
                <a:off x="689540" y="1830448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2" name="Line 436"/>
              <p:cNvSpPr>
                <a:spLocks noChangeShapeType="1"/>
              </p:cNvSpPr>
              <p:nvPr/>
            </p:nvSpPr>
            <p:spPr bwMode="auto">
              <a:xfrm>
                <a:off x="689540" y="1772632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3" name="Line 437"/>
              <p:cNvSpPr>
                <a:spLocks noChangeShapeType="1"/>
              </p:cNvSpPr>
              <p:nvPr/>
            </p:nvSpPr>
            <p:spPr bwMode="auto">
              <a:xfrm>
                <a:off x="689540" y="1713253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4" name="Line 438"/>
              <p:cNvSpPr>
                <a:spLocks noChangeShapeType="1"/>
              </p:cNvSpPr>
              <p:nvPr/>
            </p:nvSpPr>
            <p:spPr bwMode="auto">
              <a:xfrm>
                <a:off x="689540" y="1655436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5" name="Line 439"/>
              <p:cNvSpPr>
                <a:spLocks noChangeShapeType="1"/>
              </p:cNvSpPr>
              <p:nvPr/>
            </p:nvSpPr>
            <p:spPr bwMode="auto">
              <a:xfrm>
                <a:off x="689540" y="1596058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6" name="Line 440"/>
              <p:cNvSpPr>
                <a:spLocks noChangeShapeType="1"/>
              </p:cNvSpPr>
              <p:nvPr/>
            </p:nvSpPr>
            <p:spPr bwMode="auto">
              <a:xfrm>
                <a:off x="689540" y="1538242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7" name="Line 441"/>
              <p:cNvSpPr>
                <a:spLocks noChangeShapeType="1"/>
              </p:cNvSpPr>
              <p:nvPr/>
            </p:nvSpPr>
            <p:spPr bwMode="auto">
              <a:xfrm>
                <a:off x="689540" y="1480425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8" name="Line 442"/>
              <p:cNvSpPr>
                <a:spLocks noChangeShapeType="1"/>
              </p:cNvSpPr>
              <p:nvPr/>
            </p:nvSpPr>
            <p:spPr bwMode="auto">
              <a:xfrm>
                <a:off x="689540" y="1421046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59" name="Line 443"/>
              <p:cNvSpPr>
                <a:spLocks noChangeShapeType="1"/>
              </p:cNvSpPr>
              <p:nvPr/>
            </p:nvSpPr>
            <p:spPr bwMode="auto">
              <a:xfrm>
                <a:off x="689540" y="1363231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0" name="Line 444"/>
              <p:cNvSpPr>
                <a:spLocks noChangeShapeType="1"/>
              </p:cNvSpPr>
              <p:nvPr/>
            </p:nvSpPr>
            <p:spPr bwMode="auto">
              <a:xfrm>
                <a:off x="689540" y="1305414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1" name="Line 445"/>
              <p:cNvSpPr>
                <a:spLocks noChangeShapeType="1"/>
              </p:cNvSpPr>
              <p:nvPr/>
            </p:nvSpPr>
            <p:spPr bwMode="auto">
              <a:xfrm>
                <a:off x="689540" y="1246035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2" name="Line 446"/>
              <p:cNvSpPr>
                <a:spLocks noChangeShapeType="1"/>
              </p:cNvSpPr>
              <p:nvPr/>
            </p:nvSpPr>
            <p:spPr bwMode="auto">
              <a:xfrm>
                <a:off x="689540" y="1188219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3" name="Line 447"/>
              <p:cNvSpPr>
                <a:spLocks noChangeShapeType="1"/>
              </p:cNvSpPr>
              <p:nvPr/>
            </p:nvSpPr>
            <p:spPr bwMode="auto">
              <a:xfrm>
                <a:off x="689540" y="1128841"/>
                <a:ext cx="62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4" name="Line 448"/>
              <p:cNvSpPr>
                <a:spLocks noChangeShapeType="1"/>
              </p:cNvSpPr>
              <p:nvPr/>
            </p:nvSpPr>
            <p:spPr bwMode="auto">
              <a:xfrm>
                <a:off x="683290" y="3407112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5" name="Rectangle 449"/>
              <p:cNvSpPr>
                <a:spLocks noChangeArrowheads="1"/>
              </p:cNvSpPr>
              <p:nvPr/>
            </p:nvSpPr>
            <p:spPr bwMode="auto">
              <a:xfrm>
                <a:off x="579625" y="3347804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66" name="Line 450"/>
              <p:cNvSpPr>
                <a:spLocks noChangeShapeType="1"/>
              </p:cNvSpPr>
              <p:nvPr/>
            </p:nvSpPr>
            <p:spPr bwMode="auto">
              <a:xfrm>
                <a:off x="683290" y="3114905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7" name="Rectangle 451"/>
              <p:cNvSpPr>
                <a:spLocks noChangeArrowheads="1"/>
              </p:cNvSpPr>
              <p:nvPr/>
            </p:nvSpPr>
            <p:spPr bwMode="auto">
              <a:xfrm>
                <a:off x="579625" y="3055598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68" name="Line 452"/>
              <p:cNvSpPr>
                <a:spLocks noChangeShapeType="1"/>
              </p:cNvSpPr>
              <p:nvPr/>
            </p:nvSpPr>
            <p:spPr bwMode="auto">
              <a:xfrm>
                <a:off x="683290" y="2822699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69" name="Rectangle 453"/>
              <p:cNvSpPr>
                <a:spLocks noChangeArrowheads="1"/>
              </p:cNvSpPr>
              <p:nvPr/>
            </p:nvSpPr>
            <p:spPr bwMode="auto">
              <a:xfrm>
                <a:off x="579625" y="2763392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0" name="Line 454"/>
              <p:cNvSpPr>
                <a:spLocks noChangeShapeType="1"/>
              </p:cNvSpPr>
              <p:nvPr/>
            </p:nvSpPr>
            <p:spPr bwMode="auto">
              <a:xfrm>
                <a:off x="683290" y="2530493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71" name="Rectangle 455"/>
              <p:cNvSpPr>
                <a:spLocks noChangeArrowheads="1"/>
              </p:cNvSpPr>
              <p:nvPr/>
            </p:nvSpPr>
            <p:spPr bwMode="auto">
              <a:xfrm>
                <a:off x="579625" y="2471185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2" name="Line 456"/>
              <p:cNvSpPr>
                <a:spLocks noChangeShapeType="1"/>
              </p:cNvSpPr>
              <p:nvPr/>
            </p:nvSpPr>
            <p:spPr bwMode="auto">
              <a:xfrm>
                <a:off x="683290" y="2239849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73" name="Rectangle 457"/>
              <p:cNvSpPr>
                <a:spLocks noChangeArrowheads="1"/>
              </p:cNvSpPr>
              <p:nvPr/>
            </p:nvSpPr>
            <p:spPr bwMode="auto">
              <a:xfrm>
                <a:off x="579625" y="2178980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4" name="Line 458"/>
              <p:cNvSpPr>
                <a:spLocks noChangeShapeType="1"/>
              </p:cNvSpPr>
              <p:nvPr/>
            </p:nvSpPr>
            <p:spPr bwMode="auto">
              <a:xfrm>
                <a:off x="683290" y="1947643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75" name="Rectangle 459"/>
              <p:cNvSpPr>
                <a:spLocks noChangeArrowheads="1"/>
              </p:cNvSpPr>
              <p:nvPr/>
            </p:nvSpPr>
            <p:spPr bwMode="auto">
              <a:xfrm>
                <a:off x="579625" y="1886773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6" name="Line 460"/>
              <p:cNvSpPr>
                <a:spLocks noChangeShapeType="1"/>
              </p:cNvSpPr>
              <p:nvPr/>
            </p:nvSpPr>
            <p:spPr bwMode="auto">
              <a:xfrm>
                <a:off x="683290" y="1655436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77" name="Rectangle 461"/>
              <p:cNvSpPr>
                <a:spLocks noChangeArrowheads="1"/>
              </p:cNvSpPr>
              <p:nvPr/>
            </p:nvSpPr>
            <p:spPr bwMode="auto">
              <a:xfrm>
                <a:off x="579625" y="1594566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8" name="Line 462"/>
              <p:cNvSpPr>
                <a:spLocks noChangeShapeType="1"/>
              </p:cNvSpPr>
              <p:nvPr/>
            </p:nvSpPr>
            <p:spPr bwMode="auto">
              <a:xfrm>
                <a:off x="683290" y="1363231"/>
                <a:ext cx="1250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179" name="Rectangle 463"/>
              <p:cNvSpPr>
                <a:spLocks noChangeArrowheads="1"/>
              </p:cNvSpPr>
              <p:nvPr/>
            </p:nvSpPr>
            <p:spPr bwMode="auto">
              <a:xfrm>
                <a:off x="579625" y="1303922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80" name="Rectangle 449"/>
              <p:cNvSpPr>
                <a:spLocks noChangeArrowheads="1"/>
              </p:cNvSpPr>
              <p:nvPr/>
            </p:nvSpPr>
            <p:spPr bwMode="auto">
              <a:xfrm>
                <a:off x="578519" y="3613170"/>
                <a:ext cx="54231" cy="118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</p:grpSp>
        <p:sp>
          <p:nvSpPr>
            <p:cNvPr id="39" name="Freeform 471"/>
            <p:cNvSpPr>
              <a:spLocks/>
            </p:cNvSpPr>
            <p:nvPr/>
          </p:nvSpPr>
          <p:spPr bwMode="auto">
            <a:xfrm flipV="1">
              <a:off x="584018" y="4575084"/>
              <a:ext cx="2562701" cy="94501"/>
            </a:xfrm>
            <a:custGeom>
              <a:avLst/>
              <a:gdLst>
                <a:gd name="T0" fmla="*/ 153 w 10100"/>
                <a:gd name="T1" fmla="*/ 152 h 388"/>
                <a:gd name="T2" fmla="*/ 320 w 10100"/>
                <a:gd name="T3" fmla="*/ 230 h 388"/>
                <a:gd name="T4" fmla="*/ 487 w 10100"/>
                <a:gd name="T5" fmla="*/ 239 h 388"/>
                <a:gd name="T6" fmla="*/ 653 w 10100"/>
                <a:gd name="T7" fmla="*/ 171 h 388"/>
                <a:gd name="T8" fmla="*/ 820 w 10100"/>
                <a:gd name="T9" fmla="*/ 161 h 388"/>
                <a:gd name="T10" fmla="*/ 987 w 10100"/>
                <a:gd name="T11" fmla="*/ 245 h 388"/>
                <a:gd name="T12" fmla="*/ 1154 w 10100"/>
                <a:gd name="T13" fmla="*/ 279 h 388"/>
                <a:gd name="T14" fmla="*/ 1321 w 10100"/>
                <a:gd name="T15" fmla="*/ 161 h 388"/>
                <a:gd name="T16" fmla="*/ 1487 w 10100"/>
                <a:gd name="T17" fmla="*/ 181 h 388"/>
                <a:gd name="T18" fmla="*/ 1654 w 10100"/>
                <a:gd name="T19" fmla="*/ 192 h 388"/>
                <a:gd name="T20" fmla="*/ 1821 w 10100"/>
                <a:gd name="T21" fmla="*/ 139 h 388"/>
                <a:gd name="T22" fmla="*/ 1988 w 10100"/>
                <a:gd name="T23" fmla="*/ 88 h 388"/>
                <a:gd name="T24" fmla="*/ 2155 w 10100"/>
                <a:gd name="T25" fmla="*/ 55 h 388"/>
                <a:gd name="T26" fmla="*/ 2321 w 10100"/>
                <a:gd name="T27" fmla="*/ 43 h 388"/>
                <a:gd name="T28" fmla="*/ 2488 w 10100"/>
                <a:gd name="T29" fmla="*/ 48 h 388"/>
                <a:gd name="T30" fmla="*/ 2655 w 10100"/>
                <a:gd name="T31" fmla="*/ 91 h 388"/>
                <a:gd name="T32" fmla="*/ 2822 w 10100"/>
                <a:gd name="T33" fmla="*/ 41 h 388"/>
                <a:gd name="T34" fmla="*/ 2989 w 10100"/>
                <a:gd name="T35" fmla="*/ 36 h 388"/>
                <a:gd name="T36" fmla="*/ 3155 w 10100"/>
                <a:gd name="T37" fmla="*/ 41 h 388"/>
                <a:gd name="T38" fmla="*/ 3322 w 10100"/>
                <a:gd name="T39" fmla="*/ 106 h 388"/>
                <a:gd name="T40" fmla="*/ 3489 w 10100"/>
                <a:gd name="T41" fmla="*/ 92 h 388"/>
                <a:gd name="T42" fmla="*/ 3656 w 10100"/>
                <a:gd name="T43" fmla="*/ 57 h 388"/>
                <a:gd name="T44" fmla="*/ 3823 w 10100"/>
                <a:gd name="T45" fmla="*/ 15 h 388"/>
                <a:gd name="T46" fmla="*/ 3989 w 10100"/>
                <a:gd name="T47" fmla="*/ 25 h 388"/>
                <a:gd name="T48" fmla="*/ 4156 w 10100"/>
                <a:gd name="T49" fmla="*/ 19 h 388"/>
                <a:gd name="T50" fmla="*/ 4323 w 10100"/>
                <a:gd name="T51" fmla="*/ 8 h 388"/>
                <a:gd name="T52" fmla="*/ 4490 w 10100"/>
                <a:gd name="T53" fmla="*/ 56 h 388"/>
                <a:gd name="T54" fmla="*/ 4656 w 10100"/>
                <a:gd name="T55" fmla="*/ 68 h 388"/>
                <a:gd name="T56" fmla="*/ 4823 w 10100"/>
                <a:gd name="T57" fmla="*/ 94 h 388"/>
                <a:gd name="T58" fmla="*/ 4990 w 10100"/>
                <a:gd name="T59" fmla="*/ 104 h 388"/>
                <a:gd name="T60" fmla="*/ 5157 w 10100"/>
                <a:gd name="T61" fmla="*/ 122 h 388"/>
                <a:gd name="T62" fmla="*/ 5324 w 10100"/>
                <a:gd name="T63" fmla="*/ 75 h 388"/>
                <a:gd name="T64" fmla="*/ 5490 w 10100"/>
                <a:gd name="T65" fmla="*/ 47 h 388"/>
                <a:gd name="T66" fmla="*/ 5657 w 10100"/>
                <a:gd name="T67" fmla="*/ 24 h 388"/>
                <a:gd name="T68" fmla="*/ 5824 w 10100"/>
                <a:gd name="T69" fmla="*/ 53 h 388"/>
                <a:gd name="T70" fmla="*/ 5991 w 10100"/>
                <a:gd name="T71" fmla="*/ 153 h 388"/>
                <a:gd name="T72" fmla="*/ 6158 w 10100"/>
                <a:gd name="T73" fmla="*/ 306 h 388"/>
                <a:gd name="T74" fmla="*/ 6324 w 10100"/>
                <a:gd name="T75" fmla="*/ 219 h 388"/>
                <a:gd name="T76" fmla="*/ 6491 w 10100"/>
                <a:gd name="T77" fmla="*/ 150 h 388"/>
                <a:gd name="T78" fmla="*/ 6658 w 10100"/>
                <a:gd name="T79" fmla="*/ 200 h 388"/>
                <a:gd name="T80" fmla="*/ 6825 w 10100"/>
                <a:gd name="T81" fmla="*/ 282 h 388"/>
                <a:gd name="T82" fmla="*/ 6992 w 10100"/>
                <a:gd name="T83" fmla="*/ 221 h 388"/>
                <a:gd name="T84" fmla="*/ 7158 w 10100"/>
                <a:gd name="T85" fmla="*/ 263 h 388"/>
                <a:gd name="T86" fmla="*/ 7325 w 10100"/>
                <a:gd name="T87" fmla="*/ 364 h 388"/>
                <a:gd name="T88" fmla="*/ 7492 w 10100"/>
                <a:gd name="T89" fmla="*/ 272 h 388"/>
                <a:gd name="T90" fmla="*/ 7659 w 10100"/>
                <a:gd name="T91" fmla="*/ 221 h 388"/>
                <a:gd name="T92" fmla="*/ 7826 w 10100"/>
                <a:gd name="T93" fmla="*/ 297 h 388"/>
                <a:gd name="T94" fmla="*/ 7992 w 10100"/>
                <a:gd name="T95" fmla="*/ 259 h 388"/>
                <a:gd name="T96" fmla="*/ 8159 w 10100"/>
                <a:gd name="T97" fmla="*/ 236 h 388"/>
                <a:gd name="T98" fmla="*/ 8326 w 10100"/>
                <a:gd name="T99" fmla="*/ 238 h 388"/>
                <a:gd name="T100" fmla="*/ 8493 w 10100"/>
                <a:gd name="T101" fmla="*/ 201 h 388"/>
                <a:gd name="T102" fmla="*/ 8660 w 10100"/>
                <a:gd name="T103" fmla="*/ 155 h 388"/>
                <a:gd name="T104" fmla="*/ 8826 w 10100"/>
                <a:gd name="T105" fmla="*/ 163 h 388"/>
                <a:gd name="T106" fmla="*/ 8993 w 10100"/>
                <a:gd name="T107" fmla="*/ 272 h 388"/>
                <a:gd name="T108" fmla="*/ 9160 w 10100"/>
                <a:gd name="T109" fmla="*/ 269 h 388"/>
                <a:gd name="T110" fmla="*/ 9327 w 10100"/>
                <a:gd name="T111" fmla="*/ 210 h 388"/>
                <a:gd name="T112" fmla="*/ 9494 w 10100"/>
                <a:gd name="T113" fmla="*/ 181 h 388"/>
                <a:gd name="T114" fmla="*/ 9660 w 10100"/>
                <a:gd name="T115" fmla="*/ 138 h 388"/>
                <a:gd name="T116" fmla="*/ 9827 w 10100"/>
                <a:gd name="T117" fmla="*/ 117 h 388"/>
                <a:gd name="T118" fmla="*/ 9994 w 10100"/>
                <a:gd name="T119" fmla="*/ 171 h 3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10100" h="388">
                  <a:moveTo>
                    <a:pt x="0" y="142"/>
                  </a:moveTo>
                  <a:lnTo>
                    <a:pt x="12" y="134"/>
                  </a:lnTo>
                  <a:lnTo>
                    <a:pt x="25" y="139"/>
                  </a:lnTo>
                  <a:lnTo>
                    <a:pt x="37" y="137"/>
                  </a:lnTo>
                  <a:lnTo>
                    <a:pt x="50" y="141"/>
                  </a:lnTo>
                  <a:lnTo>
                    <a:pt x="63" y="138"/>
                  </a:lnTo>
                  <a:lnTo>
                    <a:pt x="76" y="144"/>
                  </a:lnTo>
                  <a:lnTo>
                    <a:pt x="89" y="149"/>
                  </a:lnTo>
                  <a:lnTo>
                    <a:pt x="102" y="151"/>
                  </a:lnTo>
                  <a:lnTo>
                    <a:pt x="114" y="157"/>
                  </a:lnTo>
                  <a:lnTo>
                    <a:pt x="127" y="149"/>
                  </a:lnTo>
                  <a:lnTo>
                    <a:pt x="140" y="161"/>
                  </a:lnTo>
                  <a:lnTo>
                    <a:pt x="153" y="152"/>
                  </a:lnTo>
                  <a:lnTo>
                    <a:pt x="166" y="161"/>
                  </a:lnTo>
                  <a:lnTo>
                    <a:pt x="179" y="160"/>
                  </a:lnTo>
                  <a:lnTo>
                    <a:pt x="191" y="154"/>
                  </a:lnTo>
                  <a:lnTo>
                    <a:pt x="204" y="156"/>
                  </a:lnTo>
                  <a:lnTo>
                    <a:pt x="217" y="165"/>
                  </a:lnTo>
                  <a:lnTo>
                    <a:pt x="230" y="174"/>
                  </a:lnTo>
                  <a:lnTo>
                    <a:pt x="243" y="187"/>
                  </a:lnTo>
                  <a:lnTo>
                    <a:pt x="256" y="206"/>
                  </a:lnTo>
                  <a:lnTo>
                    <a:pt x="268" y="213"/>
                  </a:lnTo>
                  <a:lnTo>
                    <a:pt x="281" y="229"/>
                  </a:lnTo>
                  <a:lnTo>
                    <a:pt x="294" y="234"/>
                  </a:lnTo>
                  <a:lnTo>
                    <a:pt x="307" y="223"/>
                  </a:lnTo>
                  <a:lnTo>
                    <a:pt x="320" y="230"/>
                  </a:lnTo>
                  <a:lnTo>
                    <a:pt x="333" y="216"/>
                  </a:lnTo>
                  <a:lnTo>
                    <a:pt x="345" y="216"/>
                  </a:lnTo>
                  <a:lnTo>
                    <a:pt x="358" y="216"/>
                  </a:lnTo>
                  <a:lnTo>
                    <a:pt x="371" y="219"/>
                  </a:lnTo>
                  <a:lnTo>
                    <a:pt x="384" y="214"/>
                  </a:lnTo>
                  <a:lnTo>
                    <a:pt x="397" y="213"/>
                  </a:lnTo>
                  <a:lnTo>
                    <a:pt x="410" y="221"/>
                  </a:lnTo>
                  <a:lnTo>
                    <a:pt x="422" y="227"/>
                  </a:lnTo>
                  <a:lnTo>
                    <a:pt x="435" y="218"/>
                  </a:lnTo>
                  <a:lnTo>
                    <a:pt x="448" y="223"/>
                  </a:lnTo>
                  <a:lnTo>
                    <a:pt x="461" y="227"/>
                  </a:lnTo>
                  <a:lnTo>
                    <a:pt x="474" y="230"/>
                  </a:lnTo>
                  <a:lnTo>
                    <a:pt x="487" y="239"/>
                  </a:lnTo>
                  <a:lnTo>
                    <a:pt x="499" y="247"/>
                  </a:lnTo>
                  <a:lnTo>
                    <a:pt x="512" y="246"/>
                  </a:lnTo>
                  <a:lnTo>
                    <a:pt x="525" y="248"/>
                  </a:lnTo>
                  <a:lnTo>
                    <a:pt x="538" y="242"/>
                  </a:lnTo>
                  <a:lnTo>
                    <a:pt x="551" y="219"/>
                  </a:lnTo>
                  <a:lnTo>
                    <a:pt x="564" y="209"/>
                  </a:lnTo>
                  <a:lnTo>
                    <a:pt x="576" y="195"/>
                  </a:lnTo>
                  <a:lnTo>
                    <a:pt x="589" y="190"/>
                  </a:lnTo>
                  <a:lnTo>
                    <a:pt x="602" y="175"/>
                  </a:lnTo>
                  <a:lnTo>
                    <a:pt x="615" y="176"/>
                  </a:lnTo>
                  <a:lnTo>
                    <a:pt x="628" y="165"/>
                  </a:lnTo>
                  <a:lnTo>
                    <a:pt x="640" y="176"/>
                  </a:lnTo>
                  <a:lnTo>
                    <a:pt x="653" y="171"/>
                  </a:lnTo>
                  <a:lnTo>
                    <a:pt x="666" y="172"/>
                  </a:lnTo>
                  <a:lnTo>
                    <a:pt x="679" y="163"/>
                  </a:lnTo>
                  <a:lnTo>
                    <a:pt x="692" y="165"/>
                  </a:lnTo>
                  <a:lnTo>
                    <a:pt x="705" y="160"/>
                  </a:lnTo>
                  <a:lnTo>
                    <a:pt x="717" y="167"/>
                  </a:lnTo>
                  <a:lnTo>
                    <a:pt x="730" y="163"/>
                  </a:lnTo>
                  <a:lnTo>
                    <a:pt x="743" y="173"/>
                  </a:lnTo>
                  <a:lnTo>
                    <a:pt x="756" y="176"/>
                  </a:lnTo>
                  <a:lnTo>
                    <a:pt x="769" y="173"/>
                  </a:lnTo>
                  <a:lnTo>
                    <a:pt x="782" y="177"/>
                  </a:lnTo>
                  <a:lnTo>
                    <a:pt x="794" y="181"/>
                  </a:lnTo>
                  <a:lnTo>
                    <a:pt x="807" y="166"/>
                  </a:lnTo>
                  <a:lnTo>
                    <a:pt x="820" y="161"/>
                  </a:lnTo>
                  <a:lnTo>
                    <a:pt x="833" y="155"/>
                  </a:lnTo>
                  <a:lnTo>
                    <a:pt x="846" y="151"/>
                  </a:lnTo>
                  <a:lnTo>
                    <a:pt x="859" y="149"/>
                  </a:lnTo>
                  <a:lnTo>
                    <a:pt x="871" y="160"/>
                  </a:lnTo>
                  <a:lnTo>
                    <a:pt x="884" y="162"/>
                  </a:lnTo>
                  <a:lnTo>
                    <a:pt x="897" y="165"/>
                  </a:lnTo>
                  <a:lnTo>
                    <a:pt x="910" y="189"/>
                  </a:lnTo>
                  <a:lnTo>
                    <a:pt x="923" y="196"/>
                  </a:lnTo>
                  <a:lnTo>
                    <a:pt x="936" y="199"/>
                  </a:lnTo>
                  <a:lnTo>
                    <a:pt x="948" y="211"/>
                  </a:lnTo>
                  <a:lnTo>
                    <a:pt x="961" y="223"/>
                  </a:lnTo>
                  <a:lnTo>
                    <a:pt x="974" y="242"/>
                  </a:lnTo>
                  <a:lnTo>
                    <a:pt x="987" y="245"/>
                  </a:lnTo>
                  <a:lnTo>
                    <a:pt x="1000" y="262"/>
                  </a:lnTo>
                  <a:lnTo>
                    <a:pt x="1013" y="279"/>
                  </a:lnTo>
                  <a:lnTo>
                    <a:pt x="1025" y="301"/>
                  </a:lnTo>
                  <a:lnTo>
                    <a:pt x="1038" y="325"/>
                  </a:lnTo>
                  <a:lnTo>
                    <a:pt x="1051" y="360"/>
                  </a:lnTo>
                  <a:lnTo>
                    <a:pt x="1064" y="378"/>
                  </a:lnTo>
                  <a:lnTo>
                    <a:pt x="1077" y="388"/>
                  </a:lnTo>
                  <a:lnTo>
                    <a:pt x="1090" y="378"/>
                  </a:lnTo>
                  <a:lnTo>
                    <a:pt x="1102" y="366"/>
                  </a:lnTo>
                  <a:lnTo>
                    <a:pt x="1115" y="338"/>
                  </a:lnTo>
                  <a:lnTo>
                    <a:pt x="1128" y="317"/>
                  </a:lnTo>
                  <a:lnTo>
                    <a:pt x="1141" y="302"/>
                  </a:lnTo>
                  <a:lnTo>
                    <a:pt x="1154" y="279"/>
                  </a:lnTo>
                  <a:lnTo>
                    <a:pt x="1167" y="266"/>
                  </a:lnTo>
                  <a:lnTo>
                    <a:pt x="1179" y="257"/>
                  </a:lnTo>
                  <a:lnTo>
                    <a:pt x="1192" y="247"/>
                  </a:lnTo>
                  <a:lnTo>
                    <a:pt x="1205" y="241"/>
                  </a:lnTo>
                  <a:lnTo>
                    <a:pt x="1218" y="245"/>
                  </a:lnTo>
                  <a:lnTo>
                    <a:pt x="1231" y="234"/>
                  </a:lnTo>
                  <a:lnTo>
                    <a:pt x="1244" y="204"/>
                  </a:lnTo>
                  <a:lnTo>
                    <a:pt x="1256" y="192"/>
                  </a:lnTo>
                  <a:lnTo>
                    <a:pt x="1269" y="185"/>
                  </a:lnTo>
                  <a:lnTo>
                    <a:pt x="1282" y="181"/>
                  </a:lnTo>
                  <a:lnTo>
                    <a:pt x="1295" y="170"/>
                  </a:lnTo>
                  <a:lnTo>
                    <a:pt x="1308" y="172"/>
                  </a:lnTo>
                  <a:lnTo>
                    <a:pt x="1321" y="161"/>
                  </a:lnTo>
                  <a:lnTo>
                    <a:pt x="1333" y="174"/>
                  </a:lnTo>
                  <a:lnTo>
                    <a:pt x="1346" y="181"/>
                  </a:lnTo>
                  <a:lnTo>
                    <a:pt x="1359" y="192"/>
                  </a:lnTo>
                  <a:lnTo>
                    <a:pt x="1372" y="188"/>
                  </a:lnTo>
                  <a:lnTo>
                    <a:pt x="1385" y="184"/>
                  </a:lnTo>
                  <a:lnTo>
                    <a:pt x="1397" y="193"/>
                  </a:lnTo>
                  <a:lnTo>
                    <a:pt x="1410" y="193"/>
                  </a:lnTo>
                  <a:lnTo>
                    <a:pt x="1423" y="194"/>
                  </a:lnTo>
                  <a:lnTo>
                    <a:pt x="1436" y="183"/>
                  </a:lnTo>
                  <a:lnTo>
                    <a:pt x="1449" y="190"/>
                  </a:lnTo>
                  <a:lnTo>
                    <a:pt x="1462" y="182"/>
                  </a:lnTo>
                  <a:lnTo>
                    <a:pt x="1474" y="184"/>
                  </a:lnTo>
                  <a:lnTo>
                    <a:pt x="1487" y="181"/>
                  </a:lnTo>
                  <a:lnTo>
                    <a:pt x="1500" y="187"/>
                  </a:lnTo>
                  <a:lnTo>
                    <a:pt x="1513" y="181"/>
                  </a:lnTo>
                  <a:lnTo>
                    <a:pt x="1526" y="184"/>
                  </a:lnTo>
                  <a:lnTo>
                    <a:pt x="1539" y="182"/>
                  </a:lnTo>
                  <a:lnTo>
                    <a:pt x="1551" y="192"/>
                  </a:lnTo>
                  <a:lnTo>
                    <a:pt x="1564" y="205"/>
                  </a:lnTo>
                  <a:lnTo>
                    <a:pt x="1577" y="208"/>
                  </a:lnTo>
                  <a:lnTo>
                    <a:pt x="1590" y="210"/>
                  </a:lnTo>
                  <a:lnTo>
                    <a:pt x="1603" y="208"/>
                  </a:lnTo>
                  <a:lnTo>
                    <a:pt x="1616" y="212"/>
                  </a:lnTo>
                  <a:lnTo>
                    <a:pt x="1628" y="203"/>
                  </a:lnTo>
                  <a:lnTo>
                    <a:pt x="1641" y="203"/>
                  </a:lnTo>
                  <a:lnTo>
                    <a:pt x="1654" y="192"/>
                  </a:lnTo>
                  <a:lnTo>
                    <a:pt x="1667" y="199"/>
                  </a:lnTo>
                  <a:lnTo>
                    <a:pt x="1680" y="190"/>
                  </a:lnTo>
                  <a:lnTo>
                    <a:pt x="1693" y="192"/>
                  </a:lnTo>
                  <a:lnTo>
                    <a:pt x="1705" y="177"/>
                  </a:lnTo>
                  <a:lnTo>
                    <a:pt x="1718" y="177"/>
                  </a:lnTo>
                  <a:lnTo>
                    <a:pt x="1731" y="175"/>
                  </a:lnTo>
                  <a:lnTo>
                    <a:pt x="1744" y="163"/>
                  </a:lnTo>
                  <a:lnTo>
                    <a:pt x="1757" y="163"/>
                  </a:lnTo>
                  <a:lnTo>
                    <a:pt x="1770" y="156"/>
                  </a:lnTo>
                  <a:lnTo>
                    <a:pt x="1782" y="161"/>
                  </a:lnTo>
                  <a:lnTo>
                    <a:pt x="1795" y="153"/>
                  </a:lnTo>
                  <a:lnTo>
                    <a:pt x="1808" y="149"/>
                  </a:lnTo>
                  <a:lnTo>
                    <a:pt x="1821" y="139"/>
                  </a:lnTo>
                  <a:lnTo>
                    <a:pt x="1834" y="134"/>
                  </a:lnTo>
                  <a:lnTo>
                    <a:pt x="1847" y="144"/>
                  </a:lnTo>
                  <a:lnTo>
                    <a:pt x="1859" y="132"/>
                  </a:lnTo>
                  <a:lnTo>
                    <a:pt x="1872" y="130"/>
                  </a:lnTo>
                  <a:lnTo>
                    <a:pt x="1885" y="130"/>
                  </a:lnTo>
                  <a:lnTo>
                    <a:pt x="1898" y="132"/>
                  </a:lnTo>
                  <a:lnTo>
                    <a:pt x="1911" y="132"/>
                  </a:lnTo>
                  <a:lnTo>
                    <a:pt x="1924" y="112"/>
                  </a:lnTo>
                  <a:lnTo>
                    <a:pt x="1936" y="117"/>
                  </a:lnTo>
                  <a:lnTo>
                    <a:pt x="1949" y="104"/>
                  </a:lnTo>
                  <a:lnTo>
                    <a:pt x="1962" y="96"/>
                  </a:lnTo>
                  <a:lnTo>
                    <a:pt x="1975" y="90"/>
                  </a:lnTo>
                  <a:lnTo>
                    <a:pt x="1988" y="88"/>
                  </a:lnTo>
                  <a:lnTo>
                    <a:pt x="2001" y="91"/>
                  </a:lnTo>
                  <a:lnTo>
                    <a:pt x="2013" y="90"/>
                  </a:lnTo>
                  <a:lnTo>
                    <a:pt x="2026" y="82"/>
                  </a:lnTo>
                  <a:lnTo>
                    <a:pt x="2039" y="91"/>
                  </a:lnTo>
                  <a:lnTo>
                    <a:pt x="2052" y="85"/>
                  </a:lnTo>
                  <a:lnTo>
                    <a:pt x="2065" y="72"/>
                  </a:lnTo>
                  <a:lnTo>
                    <a:pt x="2078" y="62"/>
                  </a:lnTo>
                  <a:lnTo>
                    <a:pt x="2090" y="67"/>
                  </a:lnTo>
                  <a:lnTo>
                    <a:pt x="2103" y="63"/>
                  </a:lnTo>
                  <a:lnTo>
                    <a:pt x="2116" y="57"/>
                  </a:lnTo>
                  <a:lnTo>
                    <a:pt x="2129" y="53"/>
                  </a:lnTo>
                  <a:lnTo>
                    <a:pt x="2142" y="53"/>
                  </a:lnTo>
                  <a:lnTo>
                    <a:pt x="2155" y="55"/>
                  </a:lnTo>
                  <a:lnTo>
                    <a:pt x="2167" y="58"/>
                  </a:lnTo>
                  <a:lnTo>
                    <a:pt x="2180" y="41"/>
                  </a:lnTo>
                  <a:lnTo>
                    <a:pt x="2193" y="48"/>
                  </a:lnTo>
                  <a:lnTo>
                    <a:pt x="2206" y="54"/>
                  </a:lnTo>
                  <a:lnTo>
                    <a:pt x="2219" y="48"/>
                  </a:lnTo>
                  <a:lnTo>
                    <a:pt x="2231" y="38"/>
                  </a:lnTo>
                  <a:lnTo>
                    <a:pt x="2244" y="52"/>
                  </a:lnTo>
                  <a:lnTo>
                    <a:pt x="2257" y="45"/>
                  </a:lnTo>
                  <a:lnTo>
                    <a:pt x="2270" y="43"/>
                  </a:lnTo>
                  <a:lnTo>
                    <a:pt x="2283" y="38"/>
                  </a:lnTo>
                  <a:lnTo>
                    <a:pt x="2296" y="42"/>
                  </a:lnTo>
                  <a:lnTo>
                    <a:pt x="2308" y="38"/>
                  </a:lnTo>
                  <a:lnTo>
                    <a:pt x="2321" y="43"/>
                  </a:lnTo>
                  <a:lnTo>
                    <a:pt x="2334" y="37"/>
                  </a:lnTo>
                  <a:lnTo>
                    <a:pt x="2347" y="47"/>
                  </a:lnTo>
                  <a:lnTo>
                    <a:pt x="2360" y="45"/>
                  </a:lnTo>
                  <a:lnTo>
                    <a:pt x="2373" y="48"/>
                  </a:lnTo>
                  <a:lnTo>
                    <a:pt x="2385" y="54"/>
                  </a:lnTo>
                  <a:lnTo>
                    <a:pt x="2398" y="44"/>
                  </a:lnTo>
                  <a:lnTo>
                    <a:pt x="2411" y="50"/>
                  </a:lnTo>
                  <a:lnTo>
                    <a:pt x="2424" y="47"/>
                  </a:lnTo>
                  <a:lnTo>
                    <a:pt x="2437" y="50"/>
                  </a:lnTo>
                  <a:lnTo>
                    <a:pt x="2450" y="43"/>
                  </a:lnTo>
                  <a:lnTo>
                    <a:pt x="2462" y="38"/>
                  </a:lnTo>
                  <a:lnTo>
                    <a:pt x="2475" y="47"/>
                  </a:lnTo>
                  <a:lnTo>
                    <a:pt x="2488" y="48"/>
                  </a:lnTo>
                  <a:lnTo>
                    <a:pt x="2501" y="48"/>
                  </a:lnTo>
                  <a:lnTo>
                    <a:pt x="2514" y="53"/>
                  </a:lnTo>
                  <a:lnTo>
                    <a:pt x="2527" y="61"/>
                  </a:lnTo>
                  <a:lnTo>
                    <a:pt x="2539" y="63"/>
                  </a:lnTo>
                  <a:lnTo>
                    <a:pt x="2552" y="69"/>
                  </a:lnTo>
                  <a:lnTo>
                    <a:pt x="2565" y="72"/>
                  </a:lnTo>
                  <a:lnTo>
                    <a:pt x="2578" y="74"/>
                  </a:lnTo>
                  <a:lnTo>
                    <a:pt x="2591" y="78"/>
                  </a:lnTo>
                  <a:lnTo>
                    <a:pt x="2604" y="87"/>
                  </a:lnTo>
                  <a:lnTo>
                    <a:pt x="2616" y="79"/>
                  </a:lnTo>
                  <a:lnTo>
                    <a:pt x="2629" y="93"/>
                  </a:lnTo>
                  <a:lnTo>
                    <a:pt x="2642" y="92"/>
                  </a:lnTo>
                  <a:lnTo>
                    <a:pt x="2655" y="91"/>
                  </a:lnTo>
                  <a:lnTo>
                    <a:pt x="2668" y="88"/>
                  </a:lnTo>
                  <a:lnTo>
                    <a:pt x="2681" y="94"/>
                  </a:lnTo>
                  <a:lnTo>
                    <a:pt x="2693" y="84"/>
                  </a:lnTo>
                  <a:lnTo>
                    <a:pt x="2706" y="87"/>
                  </a:lnTo>
                  <a:lnTo>
                    <a:pt x="2719" y="80"/>
                  </a:lnTo>
                  <a:lnTo>
                    <a:pt x="2732" y="72"/>
                  </a:lnTo>
                  <a:lnTo>
                    <a:pt x="2745" y="63"/>
                  </a:lnTo>
                  <a:lnTo>
                    <a:pt x="2758" y="71"/>
                  </a:lnTo>
                  <a:lnTo>
                    <a:pt x="2770" y="65"/>
                  </a:lnTo>
                  <a:lnTo>
                    <a:pt x="2783" y="49"/>
                  </a:lnTo>
                  <a:lnTo>
                    <a:pt x="2796" y="43"/>
                  </a:lnTo>
                  <a:lnTo>
                    <a:pt x="2809" y="42"/>
                  </a:lnTo>
                  <a:lnTo>
                    <a:pt x="2822" y="41"/>
                  </a:lnTo>
                  <a:lnTo>
                    <a:pt x="2835" y="31"/>
                  </a:lnTo>
                  <a:lnTo>
                    <a:pt x="2847" y="36"/>
                  </a:lnTo>
                  <a:lnTo>
                    <a:pt x="2860" y="39"/>
                  </a:lnTo>
                  <a:lnTo>
                    <a:pt x="2873" y="37"/>
                  </a:lnTo>
                  <a:lnTo>
                    <a:pt x="2886" y="34"/>
                  </a:lnTo>
                  <a:lnTo>
                    <a:pt x="2899" y="32"/>
                  </a:lnTo>
                  <a:lnTo>
                    <a:pt x="2912" y="32"/>
                  </a:lnTo>
                  <a:lnTo>
                    <a:pt x="2924" y="34"/>
                  </a:lnTo>
                  <a:lnTo>
                    <a:pt x="2937" y="32"/>
                  </a:lnTo>
                  <a:lnTo>
                    <a:pt x="2950" y="33"/>
                  </a:lnTo>
                  <a:lnTo>
                    <a:pt x="2963" y="32"/>
                  </a:lnTo>
                  <a:lnTo>
                    <a:pt x="2976" y="28"/>
                  </a:lnTo>
                  <a:lnTo>
                    <a:pt x="2989" y="36"/>
                  </a:lnTo>
                  <a:lnTo>
                    <a:pt x="3001" y="28"/>
                  </a:lnTo>
                  <a:lnTo>
                    <a:pt x="3014" y="32"/>
                  </a:lnTo>
                  <a:lnTo>
                    <a:pt x="3027" y="29"/>
                  </a:lnTo>
                  <a:lnTo>
                    <a:pt x="3040" y="30"/>
                  </a:lnTo>
                  <a:lnTo>
                    <a:pt x="3053" y="38"/>
                  </a:lnTo>
                  <a:lnTo>
                    <a:pt x="3065" y="34"/>
                  </a:lnTo>
                  <a:lnTo>
                    <a:pt x="3078" y="33"/>
                  </a:lnTo>
                  <a:lnTo>
                    <a:pt x="3091" y="40"/>
                  </a:lnTo>
                  <a:lnTo>
                    <a:pt x="3104" y="37"/>
                  </a:lnTo>
                  <a:lnTo>
                    <a:pt x="3117" y="42"/>
                  </a:lnTo>
                  <a:lnTo>
                    <a:pt x="3130" y="36"/>
                  </a:lnTo>
                  <a:lnTo>
                    <a:pt x="3142" y="43"/>
                  </a:lnTo>
                  <a:lnTo>
                    <a:pt x="3155" y="41"/>
                  </a:lnTo>
                  <a:lnTo>
                    <a:pt x="3168" y="43"/>
                  </a:lnTo>
                  <a:lnTo>
                    <a:pt x="3181" y="57"/>
                  </a:lnTo>
                  <a:lnTo>
                    <a:pt x="3194" y="52"/>
                  </a:lnTo>
                  <a:lnTo>
                    <a:pt x="3207" y="61"/>
                  </a:lnTo>
                  <a:lnTo>
                    <a:pt x="3219" y="79"/>
                  </a:lnTo>
                  <a:lnTo>
                    <a:pt x="3232" y="102"/>
                  </a:lnTo>
                  <a:lnTo>
                    <a:pt x="3245" y="103"/>
                  </a:lnTo>
                  <a:lnTo>
                    <a:pt x="3258" y="114"/>
                  </a:lnTo>
                  <a:lnTo>
                    <a:pt x="3271" y="124"/>
                  </a:lnTo>
                  <a:lnTo>
                    <a:pt x="3284" y="132"/>
                  </a:lnTo>
                  <a:lnTo>
                    <a:pt x="3296" y="122"/>
                  </a:lnTo>
                  <a:lnTo>
                    <a:pt x="3309" y="112"/>
                  </a:lnTo>
                  <a:lnTo>
                    <a:pt x="3322" y="106"/>
                  </a:lnTo>
                  <a:lnTo>
                    <a:pt x="3335" y="87"/>
                  </a:lnTo>
                  <a:lnTo>
                    <a:pt x="3348" y="87"/>
                  </a:lnTo>
                  <a:lnTo>
                    <a:pt x="3361" y="85"/>
                  </a:lnTo>
                  <a:lnTo>
                    <a:pt x="3373" y="81"/>
                  </a:lnTo>
                  <a:lnTo>
                    <a:pt x="3386" y="111"/>
                  </a:lnTo>
                  <a:lnTo>
                    <a:pt x="3399" y="115"/>
                  </a:lnTo>
                  <a:lnTo>
                    <a:pt x="3412" y="109"/>
                  </a:lnTo>
                  <a:lnTo>
                    <a:pt x="3425" y="93"/>
                  </a:lnTo>
                  <a:lnTo>
                    <a:pt x="3438" y="95"/>
                  </a:lnTo>
                  <a:lnTo>
                    <a:pt x="3450" y="94"/>
                  </a:lnTo>
                  <a:lnTo>
                    <a:pt x="3463" y="101"/>
                  </a:lnTo>
                  <a:lnTo>
                    <a:pt x="3476" y="96"/>
                  </a:lnTo>
                  <a:lnTo>
                    <a:pt x="3489" y="92"/>
                  </a:lnTo>
                  <a:lnTo>
                    <a:pt x="3502" y="83"/>
                  </a:lnTo>
                  <a:lnTo>
                    <a:pt x="3515" y="72"/>
                  </a:lnTo>
                  <a:lnTo>
                    <a:pt x="3527" y="68"/>
                  </a:lnTo>
                  <a:lnTo>
                    <a:pt x="3540" y="77"/>
                  </a:lnTo>
                  <a:lnTo>
                    <a:pt x="3553" y="72"/>
                  </a:lnTo>
                  <a:lnTo>
                    <a:pt x="3566" y="57"/>
                  </a:lnTo>
                  <a:lnTo>
                    <a:pt x="3579" y="50"/>
                  </a:lnTo>
                  <a:lnTo>
                    <a:pt x="3592" y="50"/>
                  </a:lnTo>
                  <a:lnTo>
                    <a:pt x="3604" y="51"/>
                  </a:lnTo>
                  <a:lnTo>
                    <a:pt x="3617" y="49"/>
                  </a:lnTo>
                  <a:lnTo>
                    <a:pt x="3630" y="38"/>
                  </a:lnTo>
                  <a:lnTo>
                    <a:pt x="3643" y="37"/>
                  </a:lnTo>
                  <a:lnTo>
                    <a:pt x="3656" y="57"/>
                  </a:lnTo>
                  <a:lnTo>
                    <a:pt x="3669" y="57"/>
                  </a:lnTo>
                  <a:lnTo>
                    <a:pt x="3681" y="47"/>
                  </a:lnTo>
                  <a:lnTo>
                    <a:pt x="3694" y="47"/>
                  </a:lnTo>
                  <a:lnTo>
                    <a:pt x="3707" y="36"/>
                  </a:lnTo>
                  <a:lnTo>
                    <a:pt x="3720" y="33"/>
                  </a:lnTo>
                  <a:lnTo>
                    <a:pt x="3733" y="32"/>
                  </a:lnTo>
                  <a:lnTo>
                    <a:pt x="3746" y="34"/>
                  </a:lnTo>
                  <a:lnTo>
                    <a:pt x="3758" y="28"/>
                  </a:lnTo>
                  <a:lnTo>
                    <a:pt x="3771" y="33"/>
                  </a:lnTo>
                  <a:lnTo>
                    <a:pt x="3784" y="21"/>
                  </a:lnTo>
                  <a:lnTo>
                    <a:pt x="3797" y="20"/>
                  </a:lnTo>
                  <a:lnTo>
                    <a:pt x="3810" y="18"/>
                  </a:lnTo>
                  <a:lnTo>
                    <a:pt x="3823" y="15"/>
                  </a:lnTo>
                  <a:lnTo>
                    <a:pt x="3835" y="23"/>
                  </a:lnTo>
                  <a:lnTo>
                    <a:pt x="3848" y="18"/>
                  </a:lnTo>
                  <a:lnTo>
                    <a:pt x="3861" y="17"/>
                  </a:lnTo>
                  <a:lnTo>
                    <a:pt x="3874" y="17"/>
                  </a:lnTo>
                  <a:lnTo>
                    <a:pt x="3887" y="12"/>
                  </a:lnTo>
                  <a:lnTo>
                    <a:pt x="3899" y="40"/>
                  </a:lnTo>
                  <a:lnTo>
                    <a:pt x="3912" y="51"/>
                  </a:lnTo>
                  <a:lnTo>
                    <a:pt x="3925" y="48"/>
                  </a:lnTo>
                  <a:lnTo>
                    <a:pt x="3938" y="32"/>
                  </a:lnTo>
                  <a:lnTo>
                    <a:pt x="3951" y="39"/>
                  </a:lnTo>
                  <a:lnTo>
                    <a:pt x="3964" y="33"/>
                  </a:lnTo>
                  <a:lnTo>
                    <a:pt x="3976" y="30"/>
                  </a:lnTo>
                  <a:lnTo>
                    <a:pt x="3989" y="25"/>
                  </a:lnTo>
                  <a:lnTo>
                    <a:pt x="4002" y="20"/>
                  </a:lnTo>
                  <a:lnTo>
                    <a:pt x="4015" y="20"/>
                  </a:lnTo>
                  <a:lnTo>
                    <a:pt x="4028" y="29"/>
                  </a:lnTo>
                  <a:lnTo>
                    <a:pt x="4041" y="22"/>
                  </a:lnTo>
                  <a:lnTo>
                    <a:pt x="4053" y="10"/>
                  </a:lnTo>
                  <a:lnTo>
                    <a:pt x="4066" y="13"/>
                  </a:lnTo>
                  <a:lnTo>
                    <a:pt x="4079" y="12"/>
                  </a:lnTo>
                  <a:lnTo>
                    <a:pt x="4092" y="14"/>
                  </a:lnTo>
                  <a:lnTo>
                    <a:pt x="4105" y="24"/>
                  </a:lnTo>
                  <a:lnTo>
                    <a:pt x="4118" y="29"/>
                  </a:lnTo>
                  <a:lnTo>
                    <a:pt x="4130" y="27"/>
                  </a:lnTo>
                  <a:lnTo>
                    <a:pt x="4143" y="23"/>
                  </a:lnTo>
                  <a:lnTo>
                    <a:pt x="4156" y="19"/>
                  </a:lnTo>
                  <a:lnTo>
                    <a:pt x="4169" y="19"/>
                  </a:lnTo>
                  <a:lnTo>
                    <a:pt x="4182" y="23"/>
                  </a:lnTo>
                  <a:lnTo>
                    <a:pt x="4195" y="20"/>
                  </a:lnTo>
                  <a:lnTo>
                    <a:pt x="4207" y="20"/>
                  </a:lnTo>
                  <a:lnTo>
                    <a:pt x="4220" y="11"/>
                  </a:lnTo>
                  <a:lnTo>
                    <a:pt x="4233" y="0"/>
                  </a:lnTo>
                  <a:lnTo>
                    <a:pt x="4246" y="2"/>
                  </a:lnTo>
                  <a:lnTo>
                    <a:pt x="4259" y="3"/>
                  </a:lnTo>
                  <a:lnTo>
                    <a:pt x="4272" y="7"/>
                  </a:lnTo>
                  <a:lnTo>
                    <a:pt x="4284" y="3"/>
                  </a:lnTo>
                  <a:lnTo>
                    <a:pt x="4297" y="1"/>
                  </a:lnTo>
                  <a:lnTo>
                    <a:pt x="4310" y="5"/>
                  </a:lnTo>
                  <a:lnTo>
                    <a:pt x="4323" y="8"/>
                  </a:lnTo>
                  <a:lnTo>
                    <a:pt x="4336" y="6"/>
                  </a:lnTo>
                  <a:lnTo>
                    <a:pt x="4349" y="9"/>
                  </a:lnTo>
                  <a:lnTo>
                    <a:pt x="4361" y="10"/>
                  </a:lnTo>
                  <a:lnTo>
                    <a:pt x="4374" y="13"/>
                  </a:lnTo>
                  <a:lnTo>
                    <a:pt x="4387" y="20"/>
                  </a:lnTo>
                  <a:lnTo>
                    <a:pt x="4400" y="37"/>
                  </a:lnTo>
                  <a:lnTo>
                    <a:pt x="4413" y="27"/>
                  </a:lnTo>
                  <a:lnTo>
                    <a:pt x="4426" y="25"/>
                  </a:lnTo>
                  <a:lnTo>
                    <a:pt x="4438" y="36"/>
                  </a:lnTo>
                  <a:lnTo>
                    <a:pt x="4451" y="43"/>
                  </a:lnTo>
                  <a:lnTo>
                    <a:pt x="4464" y="46"/>
                  </a:lnTo>
                  <a:lnTo>
                    <a:pt x="4477" y="51"/>
                  </a:lnTo>
                  <a:lnTo>
                    <a:pt x="4490" y="56"/>
                  </a:lnTo>
                  <a:lnTo>
                    <a:pt x="4503" y="50"/>
                  </a:lnTo>
                  <a:lnTo>
                    <a:pt x="4515" y="48"/>
                  </a:lnTo>
                  <a:lnTo>
                    <a:pt x="4528" y="47"/>
                  </a:lnTo>
                  <a:lnTo>
                    <a:pt x="4541" y="43"/>
                  </a:lnTo>
                  <a:lnTo>
                    <a:pt x="4554" y="49"/>
                  </a:lnTo>
                  <a:lnTo>
                    <a:pt x="4567" y="54"/>
                  </a:lnTo>
                  <a:lnTo>
                    <a:pt x="4580" y="52"/>
                  </a:lnTo>
                  <a:lnTo>
                    <a:pt x="4592" y="49"/>
                  </a:lnTo>
                  <a:lnTo>
                    <a:pt x="4605" y="41"/>
                  </a:lnTo>
                  <a:lnTo>
                    <a:pt x="4618" y="60"/>
                  </a:lnTo>
                  <a:lnTo>
                    <a:pt x="4631" y="38"/>
                  </a:lnTo>
                  <a:lnTo>
                    <a:pt x="4644" y="76"/>
                  </a:lnTo>
                  <a:lnTo>
                    <a:pt x="4656" y="68"/>
                  </a:lnTo>
                  <a:lnTo>
                    <a:pt x="4669" y="65"/>
                  </a:lnTo>
                  <a:lnTo>
                    <a:pt x="4682" y="64"/>
                  </a:lnTo>
                  <a:lnTo>
                    <a:pt x="4695" y="62"/>
                  </a:lnTo>
                  <a:lnTo>
                    <a:pt x="4708" y="63"/>
                  </a:lnTo>
                  <a:lnTo>
                    <a:pt x="4721" y="56"/>
                  </a:lnTo>
                  <a:lnTo>
                    <a:pt x="4733" y="65"/>
                  </a:lnTo>
                  <a:lnTo>
                    <a:pt x="4746" y="70"/>
                  </a:lnTo>
                  <a:lnTo>
                    <a:pt x="4759" y="72"/>
                  </a:lnTo>
                  <a:lnTo>
                    <a:pt x="4772" y="77"/>
                  </a:lnTo>
                  <a:lnTo>
                    <a:pt x="4785" y="81"/>
                  </a:lnTo>
                  <a:lnTo>
                    <a:pt x="4798" y="94"/>
                  </a:lnTo>
                  <a:lnTo>
                    <a:pt x="4810" y="94"/>
                  </a:lnTo>
                  <a:lnTo>
                    <a:pt x="4823" y="94"/>
                  </a:lnTo>
                  <a:lnTo>
                    <a:pt x="4836" y="89"/>
                  </a:lnTo>
                  <a:lnTo>
                    <a:pt x="4849" y="93"/>
                  </a:lnTo>
                  <a:lnTo>
                    <a:pt x="4862" y="101"/>
                  </a:lnTo>
                  <a:lnTo>
                    <a:pt x="4875" y="92"/>
                  </a:lnTo>
                  <a:lnTo>
                    <a:pt x="4887" y="89"/>
                  </a:lnTo>
                  <a:lnTo>
                    <a:pt x="4900" y="90"/>
                  </a:lnTo>
                  <a:lnTo>
                    <a:pt x="4913" y="92"/>
                  </a:lnTo>
                  <a:lnTo>
                    <a:pt x="4926" y="95"/>
                  </a:lnTo>
                  <a:lnTo>
                    <a:pt x="4939" y="94"/>
                  </a:lnTo>
                  <a:lnTo>
                    <a:pt x="4952" y="96"/>
                  </a:lnTo>
                  <a:lnTo>
                    <a:pt x="4964" y="97"/>
                  </a:lnTo>
                  <a:lnTo>
                    <a:pt x="4977" y="93"/>
                  </a:lnTo>
                  <a:lnTo>
                    <a:pt x="4990" y="104"/>
                  </a:lnTo>
                  <a:lnTo>
                    <a:pt x="5003" y="105"/>
                  </a:lnTo>
                  <a:lnTo>
                    <a:pt x="5016" y="93"/>
                  </a:lnTo>
                  <a:lnTo>
                    <a:pt x="5029" y="112"/>
                  </a:lnTo>
                  <a:lnTo>
                    <a:pt x="5041" y="120"/>
                  </a:lnTo>
                  <a:lnTo>
                    <a:pt x="5054" y="117"/>
                  </a:lnTo>
                  <a:lnTo>
                    <a:pt x="5067" y="120"/>
                  </a:lnTo>
                  <a:lnTo>
                    <a:pt x="5080" y="128"/>
                  </a:lnTo>
                  <a:lnTo>
                    <a:pt x="5093" y="118"/>
                  </a:lnTo>
                  <a:lnTo>
                    <a:pt x="5106" y="116"/>
                  </a:lnTo>
                  <a:lnTo>
                    <a:pt x="5118" y="116"/>
                  </a:lnTo>
                  <a:lnTo>
                    <a:pt x="5131" y="123"/>
                  </a:lnTo>
                  <a:lnTo>
                    <a:pt x="5144" y="116"/>
                  </a:lnTo>
                  <a:lnTo>
                    <a:pt x="5157" y="122"/>
                  </a:lnTo>
                  <a:lnTo>
                    <a:pt x="5170" y="135"/>
                  </a:lnTo>
                  <a:lnTo>
                    <a:pt x="5183" y="141"/>
                  </a:lnTo>
                  <a:lnTo>
                    <a:pt x="5195" y="144"/>
                  </a:lnTo>
                  <a:lnTo>
                    <a:pt x="5208" y="151"/>
                  </a:lnTo>
                  <a:lnTo>
                    <a:pt x="5221" y="131"/>
                  </a:lnTo>
                  <a:lnTo>
                    <a:pt x="5234" y="119"/>
                  </a:lnTo>
                  <a:lnTo>
                    <a:pt x="5247" y="104"/>
                  </a:lnTo>
                  <a:lnTo>
                    <a:pt x="5260" y="91"/>
                  </a:lnTo>
                  <a:lnTo>
                    <a:pt x="5272" y="94"/>
                  </a:lnTo>
                  <a:lnTo>
                    <a:pt x="5285" y="82"/>
                  </a:lnTo>
                  <a:lnTo>
                    <a:pt x="5298" y="77"/>
                  </a:lnTo>
                  <a:lnTo>
                    <a:pt x="5311" y="64"/>
                  </a:lnTo>
                  <a:lnTo>
                    <a:pt x="5324" y="75"/>
                  </a:lnTo>
                  <a:lnTo>
                    <a:pt x="5337" y="70"/>
                  </a:lnTo>
                  <a:lnTo>
                    <a:pt x="5349" y="53"/>
                  </a:lnTo>
                  <a:lnTo>
                    <a:pt x="5362" y="48"/>
                  </a:lnTo>
                  <a:lnTo>
                    <a:pt x="5375" y="44"/>
                  </a:lnTo>
                  <a:lnTo>
                    <a:pt x="5388" y="40"/>
                  </a:lnTo>
                  <a:lnTo>
                    <a:pt x="5401" y="42"/>
                  </a:lnTo>
                  <a:lnTo>
                    <a:pt x="5414" y="34"/>
                  </a:lnTo>
                  <a:lnTo>
                    <a:pt x="5426" y="61"/>
                  </a:lnTo>
                  <a:lnTo>
                    <a:pt x="5439" y="62"/>
                  </a:lnTo>
                  <a:lnTo>
                    <a:pt x="5452" y="53"/>
                  </a:lnTo>
                  <a:lnTo>
                    <a:pt x="5465" y="66"/>
                  </a:lnTo>
                  <a:lnTo>
                    <a:pt x="5478" y="54"/>
                  </a:lnTo>
                  <a:lnTo>
                    <a:pt x="5490" y="47"/>
                  </a:lnTo>
                  <a:lnTo>
                    <a:pt x="5503" y="50"/>
                  </a:lnTo>
                  <a:lnTo>
                    <a:pt x="5516" y="42"/>
                  </a:lnTo>
                  <a:lnTo>
                    <a:pt x="5529" y="39"/>
                  </a:lnTo>
                  <a:lnTo>
                    <a:pt x="5542" y="30"/>
                  </a:lnTo>
                  <a:lnTo>
                    <a:pt x="5555" y="26"/>
                  </a:lnTo>
                  <a:lnTo>
                    <a:pt x="5567" y="33"/>
                  </a:lnTo>
                  <a:lnTo>
                    <a:pt x="5580" y="43"/>
                  </a:lnTo>
                  <a:lnTo>
                    <a:pt x="5593" y="28"/>
                  </a:lnTo>
                  <a:lnTo>
                    <a:pt x="5606" y="24"/>
                  </a:lnTo>
                  <a:lnTo>
                    <a:pt x="5619" y="27"/>
                  </a:lnTo>
                  <a:lnTo>
                    <a:pt x="5632" y="23"/>
                  </a:lnTo>
                  <a:lnTo>
                    <a:pt x="5644" y="25"/>
                  </a:lnTo>
                  <a:lnTo>
                    <a:pt x="5657" y="24"/>
                  </a:lnTo>
                  <a:lnTo>
                    <a:pt x="5670" y="33"/>
                  </a:lnTo>
                  <a:lnTo>
                    <a:pt x="5683" y="32"/>
                  </a:lnTo>
                  <a:lnTo>
                    <a:pt x="5696" y="31"/>
                  </a:lnTo>
                  <a:lnTo>
                    <a:pt x="5709" y="47"/>
                  </a:lnTo>
                  <a:lnTo>
                    <a:pt x="5721" y="43"/>
                  </a:lnTo>
                  <a:lnTo>
                    <a:pt x="5734" y="60"/>
                  </a:lnTo>
                  <a:lnTo>
                    <a:pt x="5747" y="45"/>
                  </a:lnTo>
                  <a:lnTo>
                    <a:pt x="5760" y="48"/>
                  </a:lnTo>
                  <a:lnTo>
                    <a:pt x="5773" y="43"/>
                  </a:lnTo>
                  <a:lnTo>
                    <a:pt x="5786" y="61"/>
                  </a:lnTo>
                  <a:lnTo>
                    <a:pt x="5798" y="44"/>
                  </a:lnTo>
                  <a:lnTo>
                    <a:pt x="5811" y="48"/>
                  </a:lnTo>
                  <a:lnTo>
                    <a:pt x="5824" y="53"/>
                  </a:lnTo>
                  <a:lnTo>
                    <a:pt x="5837" y="51"/>
                  </a:lnTo>
                  <a:lnTo>
                    <a:pt x="5850" y="56"/>
                  </a:lnTo>
                  <a:lnTo>
                    <a:pt x="5863" y="73"/>
                  </a:lnTo>
                  <a:lnTo>
                    <a:pt x="5875" y="89"/>
                  </a:lnTo>
                  <a:lnTo>
                    <a:pt x="5888" y="84"/>
                  </a:lnTo>
                  <a:lnTo>
                    <a:pt x="5901" y="99"/>
                  </a:lnTo>
                  <a:lnTo>
                    <a:pt x="5914" y="97"/>
                  </a:lnTo>
                  <a:lnTo>
                    <a:pt x="5927" y="113"/>
                  </a:lnTo>
                  <a:lnTo>
                    <a:pt x="5940" y="116"/>
                  </a:lnTo>
                  <a:lnTo>
                    <a:pt x="5952" y="137"/>
                  </a:lnTo>
                  <a:lnTo>
                    <a:pt x="5965" y="130"/>
                  </a:lnTo>
                  <a:lnTo>
                    <a:pt x="5978" y="144"/>
                  </a:lnTo>
                  <a:lnTo>
                    <a:pt x="5991" y="153"/>
                  </a:lnTo>
                  <a:lnTo>
                    <a:pt x="6004" y="160"/>
                  </a:lnTo>
                  <a:lnTo>
                    <a:pt x="6017" y="216"/>
                  </a:lnTo>
                  <a:lnTo>
                    <a:pt x="6029" y="224"/>
                  </a:lnTo>
                  <a:lnTo>
                    <a:pt x="6042" y="239"/>
                  </a:lnTo>
                  <a:lnTo>
                    <a:pt x="6055" y="258"/>
                  </a:lnTo>
                  <a:lnTo>
                    <a:pt x="6068" y="261"/>
                  </a:lnTo>
                  <a:lnTo>
                    <a:pt x="6081" y="297"/>
                  </a:lnTo>
                  <a:lnTo>
                    <a:pt x="6094" y="313"/>
                  </a:lnTo>
                  <a:lnTo>
                    <a:pt x="6106" y="304"/>
                  </a:lnTo>
                  <a:lnTo>
                    <a:pt x="6119" y="294"/>
                  </a:lnTo>
                  <a:lnTo>
                    <a:pt x="6132" y="275"/>
                  </a:lnTo>
                  <a:lnTo>
                    <a:pt x="6145" y="328"/>
                  </a:lnTo>
                  <a:lnTo>
                    <a:pt x="6158" y="306"/>
                  </a:lnTo>
                  <a:lnTo>
                    <a:pt x="6171" y="366"/>
                  </a:lnTo>
                  <a:lnTo>
                    <a:pt x="6183" y="369"/>
                  </a:lnTo>
                  <a:lnTo>
                    <a:pt x="6196" y="339"/>
                  </a:lnTo>
                  <a:lnTo>
                    <a:pt x="6209" y="357"/>
                  </a:lnTo>
                  <a:lnTo>
                    <a:pt x="6222" y="328"/>
                  </a:lnTo>
                  <a:lnTo>
                    <a:pt x="6235" y="278"/>
                  </a:lnTo>
                  <a:lnTo>
                    <a:pt x="6248" y="290"/>
                  </a:lnTo>
                  <a:lnTo>
                    <a:pt x="6260" y="276"/>
                  </a:lnTo>
                  <a:lnTo>
                    <a:pt x="6273" y="257"/>
                  </a:lnTo>
                  <a:lnTo>
                    <a:pt x="6286" y="231"/>
                  </a:lnTo>
                  <a:lnTo>
                    <a:pt x="6299" y="221"/>
                  </a:lnTo>
                  <a:lnTo>
                    <a:pt x="6312" y="208"/>
                  </a:lnTo>
                  <a:lnTo>
                    <a:pt x="6324" y="219"/>
                  </a:lnTo>
                  <a:lnTo>
                    <a:pt x="6337" y="206"/>
                  </a:lnTo>
                  <a:lnTo>
                    <a:pt x="6350" y="183"/>
                  </a:lnTo>
                  <a:lnTo>
                    <a:pt x="6363" y="179"/>
                  </a:lnTo>
                  <a:lnTo>
                    <a:pt x="6376" y="182"/>
                  </a:lnTo>
                  <a:lnTo>
                    <a:pt x="6389" y="163"/>
                  </a:lnTo>
                  <a:lnTo>
                    <a:pt x="6401" y="153"/>
                  </a:lnTo>
                  <a:lnTo>
                    <a:pt x="6414" y="159"/>
                  </a:lnTo>
                  <a:lnTo>
                    <a:pt x="6427" y="139"/>
                  </a:lnTo>
                  <a:lnTo>
                    <a:pt x="6440" y="142"/>
                  </a:lnTo>
                  <a:lnTo>
                    <a:pt x="6453" y="163"/>
                  </a:lnTo>
                  <a:lnTo>
                    <a:pt x="6466" y="141"/>
                  </a:lnTo>
                  <a:lnTo>
                    <a:pt x="6478" y="146"/>
                  </a:lnTo>
                  <a:lnTo>
                    <a:pt x="6491" y="150"/>
                  </a:lnTo>
                  <a:lnTo>
                    <a:pt x="6504" y="180"/>
                  </a:lnTo>
                  <a:lnTo>
                    <a:pt x="6517" y="150"/>
                  </a:lnTo>
                  <a:lnTo>
                    <a:pt x="6530" y="170"/>
                  </a:lnTo>
                  <a:lnTo>
                    <a:pt x="6543" y="185"/>
                  </a:lnTo>
                  <a:lnTo>
                    <a:pt x="6555" y="206"/>
                  </a:lnTo>
                  <a:lnTo>
                    <a:pt x="6568" y="208"/>
                  </a:lnTo>
                  <a:lnTo>
                    <a:pt x="6581" y="202"/>
                  </a:lnTo>
                  <a:lnTo>
                    <a:pt x="6594" y="223"/>
                  </a:lnTo>
                  <a:lnTo>
                    <a:pt x="6607" y="208"/>
                  </a:lnTo>
                  <a:lnTo>
                    <a:pt x="6620" y="199"/>
                  </a:lnTo>
                  <a:lnTo>
                    <a:pt x="6632" y="206"/>
                  </a:lnTo>
                  <a:lnTo>
                    <a:pt x="6645" y="200"/>
                  </a:lnTo>
                  <a:lnTo>
                    <a:pt x="6658" y="200"/>
                  </a:lnTo>
                  <a:lnTo>
                    <a:pt x="6671" y="189"/>
                  </a:lnTo>
                  <a:lnTo>
                    <a:pt x="6684" y="184"/>
                  </a:lnTo>
                  <a:lnTo>
                    <a:pt x="6697" y="180"/>
                  </a:lnTo>
                  <a:lnTo>
                    <a:pt x="6709" y="216"/>
                  </a:lnTo>
                  <a:lnTo>
                    <a:pt x="6722" y="227"/>
                  </a:lnTo>
                  <a:lnTo>
                    <a:pt x="6735" y="226"/>
                  </a:lnTo>
                  <a:lnTo>
                    <a:pt x="6748" y="202"/>
                  </a:lnTo>
                  <a:lnTo>
                    <a:pt x="6761" y="184"/>
                  </a:lnTo>
                  <a:lnTo>
                    <a:pt x="6774" y="186"/>
                  </a:lnTo>
                  <a:lnTo>
                    <a:pt x="6786" y="273"/>
                  </a:lnTo>
                  <a:lnTo>
                    <a:pt x="6799" y="281"/>
                  </a:lnTo>
                  <a:lnTo>
                    <a:pt x="6812" y="280"/>
                  </a:lnTo>
                  <a:lnTo>
                    <a:pt x="6825" y="282"/>
                  </a:lnTo>
                  <a:lnTo>
                    <a:pt x="6838" y="288"/>
                  </a:lnTo>
                  <a:lnTo>
                    <a:pt x="6851" y="285"/>
                  </a:lnTo>
                  <a:lnTo>
                    <a:pt x="6863" y="284"/>
                  </a:lnTo>
                  <a:lnTo>
                    <a:pt x="6876" y="279"/>
                  </a:lnTo>
                  <a:lnTo>
                    <a:pt x="6889" y="272"/>
                  </a:lnTo>
                  <a:lnTo>
                    <a:pt x="6902" y="260"/>
                  </a:lnTo>
                  <a:lnTo>
                    <a:pt x="6915" y="255"/>
                  </a:lnTo>
                  <a:lnTo>
                    <a:pt x="6928" y="251"/>
                  </a:lnTo>
                  <a:lnTo>
                    <a:pt x="6940" y="237"/>
                  </a:lnTo>
                  <a:lnTo>
                    <a:pt x="6953" y="227"/>
                  </a:lnTo>
                  <a:lnTo>
                    <a:pt x="6966" y="229"/>
                  </a:lnTo>
                  <a:lnTo>
                    <a:pt x="6979" y="224"/>
                  </a:lnTo>
                  <a:lnTo>
                    <a:pt x="6992" y="221"/>
                  </a:lnTo>
                  <a:lnTo>
                    <a:pt x="7005" y="222"/>
                  </a:lnTo>
                  <a:lnTo>
                    <a:pt x="7017" y="214"/>
                  </a:lnTo>
                  <a:lnTo>
                    <a:pt x="7030" y="227"/>
                  </a:lnTo>
                  <a:lnTo>
                    <a:pt x="7043" y="223"/>
                  </a:lnTo>
                  <a:lnTo>
                    <a:pt x="7056" y="213"/>
                  </a:lnTo>
                  <a:lnTo>
                    <a:pt x="7069" y="211"/>
                  </a:lnTo>
                  <a:lnTo>
                    <a:pt x="7081" y="226"/>
                  </a:lnTo>
                  <a:lnTo>
                    <a:pt x="7094" y="235"/>
                  </a:lnTo>
                  <a:lnTo>
                    <a:pt x="7107" y="243"/>
                  </a:lnTo>
                  <a:lnTo>
                    <a:pt x="7120" y="241"/>
                  </a:lnTo>
                  <a:lnTo>
                    <a:pt x="7133" y="256"/>
                  </a:lnTo>
                  <a:lnTo>
                    <a:pt x="7146" y="251"/>
                  </a:lnTo>
                  <a:lnTo>
                    <a:pt x="7158" y="263"/>
                  </a:lnTo>
                  <a:lnTo>
                    <a:pt x="7171" y="243"/>
                  </a:lnTo>
                  <a:lnTo>
                    <a:pt x="7184" y="258"/>
                  </a:lnTo>
                  <a:lnTo>
                    <a:pt x="7197" y="261"/>
                  </a:lnTo>
                  <a:lnTo>
                    <a:pt x="7210" y="254"/>
                  </a:lnTo>
                  <a:lnTo>
                    <a:pt x="7223" y="252"/>
                  </a:lnTo>
                  <a:lnTo>
                    <a:pt x="7235" y="269"/>
                  </a:lnTo>
                  <a:lnTo>
                    <a:pt x="7248" y="281"/>
                  </a:lnTo>
                  <a:lnTo>
                    <a:pt x="7261" y="311"/>
                  </a:lnTo>
                  <a:lnTo>
                    <a:pt x="7274" y="328"/>
                  </a:lnTo>
                  <a:lnTo>
                    <a:pt x="7287" y="359"/>
                  </a:lnTo>
                  <a:lnTo>
                    <a:pt x="7300" y="374"/>
                  </a:lnTo>
                  <a:lnTo>
                    <a:pt x="7312" y="371"/>
                  </a:lnTo>
                  <a:lnTo>
                    <a:pt x="7325" y="364"/>
                  </a:lnTo>
                  <a:lnTo>
                    <a:pt x="7338" y="351"/>
                  </a:lnTo>
                  <a:lnTo>
                    <a:pt x="7351" y="354"/>
                  </a:lnTo>
                  <a:lnTo>
                    <a:pt x="7364" y="344"/>
                  </a:lnTo>
                  <a:lnTo>
                    <a:pt x="7377" y="316"/>
                  </a:lnTo>
                  <a:lnTo>
                    <a:pt x="7389" y="294"/>
                  </a:lnTo>
                  <a:lnTo>
                    <a:pt x="7402" y="311"/>
                  </a:lnTo>
                  <a:lnTo>
                    <a:pt x="7415" y="348"/>
                  </a:lnTo>
                  <a:lnTo>
                    <a:pt x="7428" y="346"/>
                  </a:lnTo>
                  <a:lnTo>
                    <a:pt x="7441" y="354"/>
                  </a:lnTo>
                  <a:lnTo>
                    <a:pt x="7454" y="366"/>
                  </a:lnTo>
                  <a:lnTo>
                    <a:pt x="7466" y="353"/>
                  </a:lnTo>
                  <a:lnTo>
                    <a:pt x="7479" y="298"/>
                  </a:lnTo>
                  <a:lnTo>
                    <a:pt x="7492" y="272"/>
                  </a:lnTo>
                  <a:lnTo>
                    <a:pt x="7505" y="259"/>
                  </a:lnTo>
                  <a:lnTo>
                    <a:pt x="7518" y="245"/>
                  </a:lnTo>
                  <a:lnTo>
                    <a:pt x="7531" y="264"/>
                  </a:lnTo>
                  <a:lnTo>
                    <a:pt x="7543" y="255"/>
                  </a:lnTo>
                  <a:lnTo>
                    <a:pt x="7556" y="246"/>
                  </a:lnTo>
                  <a:lnTo>
                    <a:pt x="7569" y="227"/>
                  </a:lnTo>
                  <a:lnTo>
                    <a:pt x="7582" y="225"/>
                  </a:lnTo>
                  <a:lnTo>
                    <a:pt x="7595" y="215"/>
                  </a:lnTo>
                  <a:lnTo>
                    <a:pt x="7608" y="203"/>
                  </a:lnTo>
                  <a:lnTo>
                    <a:pt x="7620" y="203"/>
                  </a:lnTo>
                  <a:lnTo>
                    <a:pt x="7633" y="221"/>
                  </a:lnTo>
                  <a:lnTo>
                    <a:pt x="7646" y="231"/>
                  </a:lnTo>
                  <a:lnTo>
                    <a:pt x="7659" y="221"/>
                  </a:lnTo>
                  <a:lnTo>
                    <a:pt x="7672" y="207"/>
                  </a:lnTo>
                  <a:lnTo>
                    <a:pt x="7685" y="210"/>
                  </a:lnTo>
                  <a:lnTo>
                    <a:pt x="7697" y="231"/>
                  </a:lnTo>
                  <a:lnTo>
                    <a:pt x="7710" y="234"/>
                  </a:lnTo>
                  <a:lnTo>
                    <a:pt x="7723" y="232"/>
                  </a:lnTo>
                  <a:lnTo>
                    <a:pt x="7736" y="231"/>
                  </a:lnTo>
                  <a:lnTo>
                    <a:pt x="7749" y="226"/>
                  </a:lnTo>
                  <a:lnTo>
                    <a:pt x="7762" y="233"/>
                  </a:lnTo>
                  <a:lnTo>
                    <a:pt x="7774" y="236"/>
                  </a:lnTo>
                  <a:lnTo>
                    <a:pt x="7787" y="247"/>
                  </a:lnTo>
                  <a:lnTo>
                    <a:pt x="7800" y="239"/>
                  </a:lnTo>
                  <a:lnTo>
                    <a:pt x="7813" y="232"/>
                  </a:lnTo>
                  <a:lnTo>
                    <a:pt x="7826" y="297"/>
                  </a:lnTo>
                  <a:lnTo>
                    <a:pt x="7839" y="292"/>
                  </a:lnTo>
                  <a:lnTo>
                    <a:pt x="7851" y="304"/>
                  </a:lnTo>
                  <a:lnTo>
                    <a:pt x="7864" y="291"/>
                  </a:lnTo>
                  <a:lnTo>
                    <a:pt x="7877" y="258"/>
                  </a:lnTo>
                  <a:lnTo>
                    <a:pt x="7890" y="241"/>
                  </a:lnTo>
                  <a:lnTo>
                    <a:pt x="7903" y="289"/>
                  </a:lnTo>
                  <a:lnTo>
                    <a:pt x="7915" y="273"/>
                  </a:lnTo>
                  <a:lnTo>
                    <a:pt x="7928" y="254"/>
                  </a:lnTo>
                  <a:lnTo>
                    <a:pt x="7941" y="283"/>
                  </a:lnTo>
                  <a:lnTo>
                    <a:pt x="7954" y="270"/>
                  </a:lnTo>
                  <a:lnTo>
                    <a:pt x="7967" y="261"/>
                  </a:lnTo>
                  <a:lnTo>
                    <a:pt x="7980" y="275"/>
                  </a:lnTo>
                  <a:lnTo>
                    <a:pt x="7992" y="259"/>
                  </a:lnTo>
                  <a:lnTo>
                    <a:pt x="8005" y="226"/>
                  </a:lnTo>
                  <a:lnTo>
                    <a:pt x="8018" y="213"/>
                  </a:lnTo>
                  <a:lnTo>
                    <a:pt x="8031" y="230"/>
                  </a:lnTo>
                  <a:lnTo>
                    <a:pt x="8044" y="218"/>
                  </a:lnTo>
                  <a:lnTo>
                    <a:pt x="8057" y="191"/>
                  </a:lnTo>
                  <a:lnTo>
                    <a:pt x="8069" y="264"/>
                  </a:lnTo>
                  <a:lnTo>
                    <a:pt x="8082" y="233"/>
                  </a:lnTo>
                  <a:lnTo>
                    <a:pt x="8095" y="231"/>
                  </a:lnTo>
                  <a:lnTo>
                    <a:pt x="8108" y="274"/>
                  </a:lnTo>
                  <a:lnTo>
                    <a:pt x="8121" y="274"/>
                  </a:lnTo>
                  <a:lnTo>
                    <a:pt x="8134" y="253"/>
                  </a:lnTo>
                  <a:lnTo>
                    <a:pt x="8146" y="254"/>
                  </a:lnTo>
                  <a:lnTo>
                    <a:pt x="8159" y="236"/>
                  </a:lnTo>
                  <a:lnTo>
                    <a:pt x="8172" y="220"/>
                  </a:lnTo>
                  <a:lnTo>
                    <a:pt x="8185" y="200"/>
                  </a:lnTo>
                  <a:lnTo>
                    <a:pt x="8198" y="211"/>
                  </a:lnTo>
                  <a:lnTo>
                    <a:pt x="8211" y="212"/>
                  </a:lnTo>
                  <a:lnTo>
                    <a:pt x="8223" y="199"/>
                  </a:lnTo>
                  <a:lnTo>
                    <a:pt x="8236" y="195"/>
                  </a:lnTo>
                  <a:lnTo>
                    <a:pt x="8249" y="220"/>
                  </a:lnTo>
                  <a:lnTo>
                    <a:pt x="8262" y="195"/>
                  </a:lnTo>
                  <a:lnTo>
                    <a:pt x="8275" y="218"/>
                  </a:lnTo>
                  <a:lnTo>
                    <a:pt x="8288" y="193"/>
                  </a:lnTo>
                  <a:lnTo>
                    <a:pt x="8300" y="196"/>
                  </a:lnTo>
                  <a:lnTo>
                    <a:pt x="8313" y="178"/>
                  </a:lnTo>
                  <a:lnTo>
                    <a:pt x="8326" y="238"/>
                  </a:lnTo>
                  <a:lnTo>
                    <a:pt x="8339" y="227"/>
                  </a:lnTo>
                  <a:lnTo>
                    <a:pt x="8352" y="224"/>
                  </a:lnTo>
                  <a:lnTo>
                    <a:pt x="8365" y="207"/>
                  </a:lnTo>
                  <a:lnTo>
                    <a:pt x="8377" y="188"/>
                  </a:lnTo>
                  <a:lnTo>
                    <a:pt x="8390" y="167"/>
                  </a:lnTo>
                  <a:lnTo>
                    <a:pt x="8403" y="168"/>
                  </a:lnTo>
                  <a:lnTo>
                    <a:pt x="8416" y="148"/>
                  </a:lnTo>
                  <a:lnTo>
                    <a:pt x="8429" y="155"/>
                  </a:lnTo>
                  <a:lnTo>
                    <a:pt x="8442" y="143"/>
                  </a:lnTo>
                  <a:lnTo>
                    <a:pt x="8454" y="165"/>
                  </a:lnTo>
                  <a:lnTo>
                    <a:pt x="8467" y="165"/>
                  </a:lnTo>
                  <a:lnTo>
                    <a:pt x="8480" y="158"/>
                  </a:lnTo>
                  <a:lnTo>
                    <a:pt x="8493" y="201"/>
                  </a:lnTo>
                  <a:lnTo>
                    <a:pt x="8506" y="188"/>
                  </a:lnTo>
                  <a:lnTo>
                    <a:pt x="8519" y="181"/>
                  </a:lnTo>
                  <a:lnTo>
                    <a:pt x="8531" y="171"/>
                  </a:lnTo>
                  <a:lnTo>
                    <a:pt x="8544" y="173"/>
                  </a:lnTo>
                  <a:lnTo>
                    <a:pt x="8557" y="151"/>
                  </a:lnTo>
                  <a:lnTo>
                    <a:pt x="8570" y="154"/>
                  </a:lnTo>
                  <a:lnTo>
                    <a:pt x="8583" y="146"/>
                  </a:lnTo>
                  <a:lnTo>
                    <a:pt x="8596" y="153"/>
                  </a:lnTo>
                  <a:lnTo>
                    <a:pt x="8608" y="152"/>
                  </a:lnTo>
                  <a:lnTo>
                    <a:pt x="8621" y="177"/>
                  </a:lnTo>
                  <a:lnTo>
                    <a:pt x="8634" y="160"/>
                  </a:lnTo>
                  <a:lnTo>
                    <a:pt x="8647" y="142"/>
                  </a:lnTo>
                  <a:lnTo>
                    <a:pt x="8660" y="155"/>
                  </a:lnTo>
                  <a:lnTo>
                    <a:pt x="8673" y="136"/>
                  </a:lnTo>
                  <a:lnTo>
                    <a:pt x="8685" y="148"/>
                  </a:lnTo>
                  <a:lnTo>
                    <a:pt x="8698" y="125"/>
                  </a:lnTo>
                  <a:lnTo>
                    <a:pt x="8711" y="176"/>
                  </a:lnTo>
                  <a:lnTo>
                    <a:pt x="8724" y="187"/>
                  </a:lnTo>
                  <a:lnTo>
                    <a:pt x="8737" y="192"/>
                  </a:lnTo>
                  <a:lnTo>
                    <a:pt x="8749" y="184"/>
                  </a:lnTo>
                  <a:lnTo>
                    <a:pt x="8762" y="182"/>
                  </a:lnTo>
                  <a:lnTo>
                    <a:pt x="8775" y="185"/>
                  </a:lnTo>
                  <a:lnTo>
                    <a:pt x="8788" y="169"/>
                  </a:lnTo>
                  <a:lnTo>
                    <a:pt x="8801" y="153"/>
                  </a:lnTo>
                  <a:lnTo>
                    <a:pt x="8814" y="155"/>
                  </a:lnTo>
                  <a:lnTo>
                    <a:pt x="8826" y="163"/>
                  </a:lnTo>
                  <a:lnTo>
                    <a:pt x="8839" y="167"/>
                  </a:lnTo>
                  <a:lnTo>
                    <a:pt x="8852" y="170"/>
                  </a:lnTo>
                  <a:lnTo>
                    <a:pt x="8865" y="187"/>
                  </a:lnTo>
                  <a:lnTo>
                    <a:pt x="8878" y="194"/>
                  </a:lnTo>
                  <a:lnTo>
                    <a:pt x="8891" y="209"/>
                  </a:lnTo>
                  <a:lnTo>
                    <a:pt x="8903" y="256"/>
                  </a:lnTo>
                  <a:lnTo>
                    <a:pt x="8916" y="267"/>
                  </a:lnTo>
                  <a:lnTo>
                    <a:pt x="8929" y="260"/>
                  </a:lnTo>
                  <a:lnTo>
                    <a:pt x="8942" y="257"/>
                  </a:lnTo>
                  <a:lnTo>
                    <a:pt x="8955" y="248"/>
                  </a:lnTo>
                  <a:lnTo>
                    <a:pt x="8968" y="263"/>
                  </a:lnTo>
                  <a:lnTo>
                    <a:pt x="8980" y="276"/>
                  </a:lnTo>
                  <a:lnTo>
                    <a:pt x="8993" y="272"/>
                  </a:lnTo>
                  <a:lnTo>
                    <a:pt x="9006" y="296"/>
                  </a:lnTo>
                  <a:lnTo>
                    <a:pt x="9019" y="314"/>
                  </a:lnTo>
                  <a:lnTo>
                    <a:pt x="9032" y="302"/>
                  </a:lnTo>
                  <a:lnTo>
                    <a:pt x="9045" y="327"/>
                  </a:lnTo>
                  <a:lnTo>
                    <a:pt x="9057" y="315"/>
                  </a:lnTo>
                  <a:lnTo>
                    <a:pt x="9070" y="303"/>
                  </a:lnTo>
                  <a:lnTo>
                    <a:pt x="9083" y="298"/>
                  </a:lnTo>
                  <a:lnTo>
                    <a:pt x="9096" y="285"/>
                  </a:lnTo>
                  <a:lnTo>
                    <a:pt x="9109" y="271"/>
                  </a:lnTo>
                  <a:lnTo>
                    <a:pt x="9122" y="262"/>
                  </a:lnTo>
                  <a:lnTo>
                    <a:pt x="9134" y="270"/>
                  </a:lnTo>
                  <a:lnTo>
                    <a:pt x="9147" y="283"/>
                  </a:lnTo>
                  <a:lnTo>
                    <a:pt x="9160" y="269"/>
                  </a:lnTo>
                  <a:lnTo>
                    <a:pt x="9173" y="246"/>
                  </a:lnTo>
                  <a:lnTo>
                    <a:pt x="9186" y="302"/>
                  </a:lnTo>
                  <a:lnTo>
                    <a:pt x="9199" y="271"/>
                  </a:lnTo>
                  <a:lnTo>
                    <a:pt x="9211" y="265"/>
                  </a:lnTo>
                  <a:lnTo>
                    <a:pt x="9224" y="252"/>
                  </a:lnTo>
                  <a:lnTo>
                    <a:pt x="9237" y="299"/>
                  </a:lnTo>
                  <a:lnTo>
                    <a:pt x="9250" y="285"/>
                  </a:lnTo>
                  <a:lnTo>
                    <a:pt x="9263" y="263"/>
                  </a:lnTo>
                  <a:lnTo>
                    <a:pt x="9276" y="233"/>
                  </a:lnTo>
                  <a:lnTo>
                    <a:pt x="9288" y="235"/>
                  </a:lnTo>
                  <a:lnTo>
                    <a:pt x="9301" y="226"/>
                  </a:lnTo>
                  <a:lnTo>
                    <a:pt x="9314" y="228"/>
                  </a:lnTo>
                  <a:lnTo>
                    <a:pt x="9327" y="210"/>
                  </a:lnTo>
                  <a:lnTo>
                    <a:pt x="9340" y="198"/>
                  </a:lnTo>
                  <a:lnTo>
                    <a:pt x="9353" y="202"/>
                  </a:lnTo>
                  <a:lnTo>
                    <a:pt x="9365" y="194"/>
                  </a:lnTo>
                  <a:lnTo>
                    <a:pt x="9378" y="195"/>
                  </a:lnTo>
                  <a:lnTo>
                    <a:pt x="9391" y="207"/>
                  </a:lnTo>
                  <a:lnTo>
                    <a:pt x="9404" y="199"/>
                  </a:lnTo>
                  <a:lnTo>
                    <a:pt x="9417" y="191"/>
                  </a:lnTo>
                  <a:lnTo>
                    <a:pt x="9430" y="176"/>
                  </a:lnTo>
                  <a:lnTo>
                    <a:pt x="9442" y="174"/>
                  </a:lnTo>
                  <a:lnTo>
                    <a:pt x="9455" y="149"/>
                  </a:lnTo>
                  <a:lnTo>
                    <a:pt x="9468" y="197"/>
                  </a:lnTo>
                  <a:lnTo>
                    <a:pt x="9481" y="197"/>
                  </a:lnTo>
                  <a:lnTo>
                    <a:pt x="9494" y="181"/>
                  </a:lnTo>
                  <a:lnTo>
                    <a:pt x="9506" y="157"/>
                  </a:lnTo>
                  <a:lnTo>
                    <a:pt x="9519" y="143"/>
                  </a:lnTo>
                  <a:lnTo>
                    <a:pt x="9532" y="134"/>
                  </a:lnTo>
                  <a:lnTo>
                    <a:pt x="9545" y="125"/>
                  </a:lnTo>
                  <a:lnTo>
                    <a:pt x="9558" y="170"/>
                  </a:lnTo>
                  <a:lnTo>
                    <a:pt x="9571" y="165"/>
                  </a:lnTo>
                  <a:lnTo>
                    <a:pt x="9583" y="164"/>
                  </a:lnTo>
                  <a:lnTo>
                    <a:pt x="9596" y="153"/>
                  </a:lnTo>
                  <a:lnTo>
                    <a:pt x="9609" y="139"/>
                  </a:lnTo>
                  <a:lnTo>
                    <a:pt x="9622" y="130"/>
                  </a:lnTo>
                  <a:lnTo>
                    <a:pt x="9635" y="131"/>
                  </a:lnTo>
                  <a:lnTo>
                    <a:pt x="9648" y="136"/>
                  </a:lnTo>
                  <a:lnTo>
                    <a:pt x="9660" y="138"/>
                  </a:lnTo>
                  <a:lnTo>
                    <a:pt x="9673" y="127"/>
                  </a:lnTo>
                  <a:lnTo>
                    <a:pt x="9686" y="159"/>
                  </a:lnTo>
                  <a:lnTo>
                    <a:pt x="9699" y="154"/>
                  </a:lnTo>
                  <a:lnTo>
                    <a:pt x="9712" y="122"/>
                  </a:lnTo>
                  <a:lnTo>
                    <a:pt x="9725" y="113"/>
                  </a:lnTo>
                  <a:lnTo>
                    <a:pt x="9737" y="114"/>
                  </a:lnTo>
                  <a:lnTo>
                    <a:pt x="9750" y="129"/>
                  </a:lnTo>
                  <a:lnTo>
                    <a:pt x="9763" y="140"/>
                  </a:lnTo>
                  <a:lnTo>
                    <a:pt x="9776" y="118"/>
                  </a:lnTo>
                  <a:lnTo>
                    <a:pt x="9789" y="116"/>
                  </a:lnTo>
                  <a:lnTo>
                    <a:pt x="9802" y="107"/>
                  </a:lnTo>
                  <a:lnTo>
                    <a:pt x="9814" y="121"/>
                  </a:lnTo>
                  <a:lnTo>
                    <a:pt x="9827" y="117"/>
                  </a:lnTo>
                  <a:lnTo>
                    <a:pt x="9840" y="144"/>
                  </a:lnTo>
                  <a:lnTo>
                    <a:pt x="9853" y="182"/>
                  </a:lnTo>
                  <a:lnTo>
                    <a:pt x="9866" y="195"/>
                  </a:lnTo>
                  <a:lnTo>
                    <a:pt x="9879" y="181"/>
                  </a:lnTo>
                  <a:lnTo>
                    <a:pt x="9891" y="181"/>
                  </a:lnTo>
                  <a:lnTo>
                    <a:pt x="9904" y="180"/>
                  </a:lnTo>
                  <a:lnTo>
                    <a:pt x="9917" y="167"/>
                  </a:lnTo>
                  <a:lnTo>
                    <a:pt x="9930" y="181"/>
                  </a:lnTo>
                  <a:lnTo>
                    <a:pt x="9943" y="175"/>
                  </a:lnTo>
                  <a:lnTo>
                    <a:pt x="9956" y="183"/>
                  </a:lnTo>
                  <a:lnTo>
                    <a:pt x="9968" y="175"/>
                  </a:lnTo>
                  <a:lnTo>
                    <a:pt x="9981" y="171"/>
                  </a:lnTo>
                  <a:lnTo>
                    <a:pt x="9994" y="171"/>
                  </a:lnTo>
                  <a:lnTo>
                    <a:pt x="10007" y="165"/>
                  </a:lnTo>
                  <a:lnTo>
                    <a:pt x="10020" y="170"/>
                  </a:lnTo>
                  <a:lnTo>
                    <a:pt x="10033" y="169"/>
                  </a:lnTo>
                  <a:lnTo>
                    <a:pt x="10045" y="163"/>
                  </a:lnTo>
                  <a:lnTo>
                    <a:pt x="10058" y="163"/>
                  </a:lnTo>
                  <a:lnTo>
                    <a:pt x="10071" y="155"/>
                  </a:lnTo>
                  <a:lnTo>
                    <a:pt x="10084" y="164"/>
                  </a:lnTo>
                  <a:lnTo>
                    <a:pt x="10097" y="150"/>
                  </a:lnTo>
                  <a:lnTo>
                    <a:pt x="10100" y="151"/>
                  </a:lnTo>
                </a:path>
              </a:pathLst>
            </a:cu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40" name="Rectangle 235"/>
            <p:cNvSpPr>
              <a:spLocks noChangeArrowheads="1"/>
            </p:cNvSpPr>
            <p:nvPr/>
          </p:nvSpPr>
          <p:spPr bwMode="auto">
            <a:xfrm>
              <a:off x="2210771" y="3080737"/>
              <a:ext cx="400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dirty="0" smtClean="0">
                  <a:ln>
                    <a:noFill/>
                  </a:ln>
                  <a:effectLst/>
                </a:rPr>
                <a:t>MsTPS1</a:t>
              </a:r>
              <a:endParaRPr kumimoji="0" lang="en-US" altLang="en-US" sz="800" b="1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1844980" y="3165086"/>
              <a:ext cx="3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Rectangle 232"/>
            <p:cNvSpPr>
              <a:spLocks noChangeArrowheads="1"/>
            </p:cNvSpPr>
            <p:nvPr/>
          </p:nvSpPr>
          <p:spPr bwMode="auto">
            <a:xfrm rot="16200000">
              <a:off x="-86152" y="3803722"/>
              <a:ext cx="96821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800" b="1" dirty="0" smtClean="0"/>
                <a:t>Relative</a:t>
              </a: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effectLst/>
                </a:rPr>
                <a:t> </a:t>
              </a:r>
              <a:r>
                <a:rPr lang="en-US" altLang="en-US" sz="800" b="1" dirty="0"/>
                <a:t>a</a:t>
              </a: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effectLst/>
                </a:rPr>
                <a:t>bundance</a:t>
              </a:r>
            </a:p>
          </p:txBody>
        </p:sp>
      </p:grpSp>
      <p:sp>
        <p:nvSpPr>
          <p:cNvPr id="322" name="TextBox 321"/>
          <p:cNvSpPr txBox="1"/>
          <p:nvPr/>
        </p:nvSpPr>
        <p:spPr>
          <a:xfrm>
            <a:off x="310689" y="5617138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400" b="1" dirty="0" smtClean="0"/>
              <a:t>Additional </a:t>
            </a:r>
            <a:r>
              <a:rPr lang="en-SG" sz="1400" b="1" smtClean="0"/>
              <a:t>File </a:t>
            </a:r>
            <a:r>
              <a:rPr lang="en-SG" sz="1400" b="1" smtClean="0"/>
              <a:t>8</a:t>
            </a:r>
            <a:endParaRPr lang="en-SG" sz="1400" dirty="0"/>
          </a:p>
        </p:txBody>
      </p:sp>
    </p:spTree>
    <p:extLst>
      <p:ext uri="{BB962C8B-B14F-4D97-AF65-F5344CB8AC3E}">
        <p14:creationId xmlns:p14="http://schemas.microsoft.com/office/powerpoint/2010/main" val="2329542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1</Words>
  <Application>Microsoft Office PowerPoint</Application>
  <PresentationFormat>On-screen Show (4:3)</PresentationFormat>
  <Paragraphs>6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ojam Rajani</dc:creator>
  <cp:lastModifiedBy>Sarojam Rajani</cp:lastModifiedBy>
  <cp:revision>9</cp:revision>
  <dcterms:created xsi:type="dcterms:W3CDTF">2014-02-05T09:43:27Z</dcterms:created>
  <dcterms:modified xsi:type="dcterms:W3CDTF">2014-05-26T08:50:54Z</dcterms:modified>
</cp:coreProperties>
</file>